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theme/themeOverride2.xml" ContentType="application/vnd.openxmlformats-officedocument.themeOverride+xml"/>
  <Override PartName="/ppt/charts/chart3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4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24" r:id="rId2"/>
    <p:sldId id="314" r:id="rId3"/>
    <p:sldId id="497" r:id="rId4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75" d="100"/>
          <a:sy n="75" d="100"/>
        </p:scale>
        <p:origin x="324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kakepyon\Desktop\DG\DGpla1-4.xlsx" TargetMode="External"/><Relationship Id="rId1" Type="http://schemas.openxmlformats.org/officeDocument/2006/relationships/themeOverride" Target="../theme/themeOverride1.xm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kakepyon\Desktop\paper%20pla\ceramide&#12288;&#32080;&#26524;.xlsx" TargetMode="External"/><Relationship Id="rId1" Type="http://schemas.openxmlformats.org/officeDocument/2006/relationships/themeOverride" Target="../theme/themeOverrid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Book1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Book1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3.5627516378218226E-2"/>
          <c:y val="1.3273563306583655E-2"/>
          <c:w val="0.94592513385148436"/>
          <c:h val="0.5782393851912645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 w="19050"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pla!$AA$2:$AA$43</c:f>
                <c:numCache>
                  <c:formatCode>General</c:formatCode>
                  <c:ptCount val="42"/>
                  <c:pt idx="0">
                    <c:v>0</c:v>
                  </c:pt>
                  <c:pt idx="1">
                    <c:v>0.21654228352586827</c:v>
                  </c:pt>
                  <c:pt idx="2">
                    <c:v>0</c:v>
                  </c:pt>
                  <c:pt idx="3">
                    <c:v>0.52722289607529282</c:v>
                  </c:pt>
                  <c:pt idx="4">
                    <c:v>2.2990532069357421</c:v>
                  </c:pt>
                  <c:pt idx="5">
                    <c:v>1.3046885758474127</c:v>
                  </c:pt>
                  <c:pt idx="6">
                    <c:v>10.897825417857444</c:v>
                  </c:pt>
                  <c:pt idx="7">
                    <c:v>1.2419122275279717</c:v>
                  </c:pt>
                  <c:pt idx="8">
                    <c:v>3.8823320614074008E-2</c:v>
                  </c:pt>
                  <c:pt idx="9">
                    <c:v>0.42616545809639211</c:v>
                  </c:pt>
                  <c:pt idx="10">
                    <c:v>9.2997639995980694E-2</c:v>
                  </c:pt>
                  <c:pt idx="11">
                    <c:v>1.0370198738741356</c:v>
                  </c:pt>
                  <c:pt idx="12">
                    <c:v>1.668471006423474</c:v>
                  </c:pt>
                  <c:pt idx="13">
                    <c:v>0.74649840920699484</c:v>
                  </c:pt>
                  <c:pt idx="14">
                    <c:v>0.26520447247701823</c:v>
                  </c:pt>
                  <c:pt idx="15">
                    <c:v>1.0663100537222041</c:v>
                  </c:pt>
                  <c:pt idx="16">
                    <c:v>0.9954440851532057</c:v>
                  </c:pt>
                  <c:pt idx="17">
                    <c:v>2.8974797291522236</c:v>
                  </c:pt>
                  <c:pt idx="18">
                    <c:v>2.2102616740220644</c:v>
                  </c:pt>
                  <c:pt idx="19">
                    <c:v>2.8778126898079197</c:v>
                  </c:pt>
                  <c:pt idx="20">
                    <c:v>0.58318550493441146</c:v>
                  </c:pt>
                  <c:pt idx="21">
                    <c:v>1.9439733672444524</c:v>
                  </c:pt>
                  <c:pt idx="22">
                    <c:v>0.30643786457660022</c:v>
                  </c:pt>
                  <c:pt idx="23">
                    <c:v>0.55898465548296861</c:v>
                  </c:pt>
                  <c:pt idx="24">
                    <c:v>2.9702485979482121</c:v>
                  </c:pt>
                  <c:pt idx="25">
                    <c:v>3.1506767948417695</c:v>
                  </c:pt>
                  <c:pt idx="26">
                    <c:v>1.7415349242376457</c:v>
                  </c:pt>
                  <c:pt idx="27">
                    <c:v>8.8485653946632006E-2</c:v>
                  </c:pt>
                  <c:pt idx="28">
                    <c:v>0.10370576966152606</c:v>
                  </c:pt>
                  <c:pt idx="29">
                    <c:v>3.2683431035836596</c:v>
                  </c:pt>
                  <c:pt idx="30">
                    <c:v>4.7211808610523045</c:v>
                  </c:pt>
                  <c:pt idx="31">
                    <c:v>0.13951004492042354</c:v>
                  </c:pt>
                  <c:pt idx="32">
                    <c:v>0.31479314414448234</c:v>
                  </c:pt>
                  <c:pt idx="33">
                    <c:v>0.24183664449706979</c:v>
                  </c:pt>
                  <c:pt idx="34">
                    <c:v>0.11808797050374188</c:v>
                  </c:pt>
                  <c:pt idx="35">
                    <c:v>0.19584043696034026</c:v>
                  </c:pt>
                  <c:pt idx="36">
                    <c:v>0.44942193932768676</c:v>
                  </c:pt>
                  <c:pt idx="37">
                    <c:v>0.57685871553846357</c:v>
                  </c:pt>
                  <c:pt idx="38">
                    <c:v>0.583291693603463</c:v>
                  </c:pt>
                  <c:pt idx="39">
                    <c:v>0.47999435210222885</c:v>
                  </c:pt>
                  <c:pt idx="40">
                    <c:v>0.12249004825259491</c:v>
                  </c:pt>
                  <c:pt idx="41">
                    <c:v>6.108604696344986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19050">
                <a:solidFill>
                  <a:schemeClr val="tx1"/>
                </a:solidFill>
              </a:ln>
            </c:spPr>
          </c:errBars>
          <c:cat>
            <c:strRef>
              <c:f>pla!$V$2:$V$43</c:f>
              <c:strCache>
                <c:ptCount val="42"/>
                <c:pt idx="0">
                  <c:v>28:1-DG</c:v>
                </c:pt>
                <c:pt idx="1">
                  <c:v>28:0-DG ( 14:0-14:0 )</c:v>
                </c:pt>
                <c:pt idx="2">
                  <c:v>30:2-DG  ( 14:1-16:1+12:0-18:2 )</c:v>
                </c:pt>
                <c:pt idx="3">
                  <c:v>30:1-DG ( 14:0-16:1+12:0-18:1+16:0-14:1 )</c:v>
                </c:pt>
                <c:pt idx="4">
                  <c:v>30:0-DG (14:0-16:0 )</c:v>
                </c:pt>
                <c:pt idx="5">
                  <c:v>32:2-DG  ( 16:1-16:1+14:0-18:2+16:0-16:2 )</c:v>
                </c:pt>
                <c:pt idx="6">
                  <c:v>32:1-DG  ( 16:0-16:1+14:0-18:1 )</c:v>
                </c:pt>
                <c:pt idx="7">
                  <c:v>32:0-DG  ( 16:0-16:0 )</c:v>
                </c:pt>
                <c:pt idx="8">
                  <c:v>34:4-DG</c:v>
                </c:pt>
                <c:pt idx="9">
                  <c:v>34:3-DG (18:2-16:1)</c:v>
                </c:pt>
                <c:pt idx="10">
                  <c:v>34:3-DG (18:3-16:0)</c:v>
                </c:pt>
                <c:pt idx="11">
                  <c:v>34:2-DG ( 18:1-16:1+18:2-16:0 )</c:v>
                </c:pt>
                <c:pt idx="12">
                  <c:v>34:1-DG (18:1-16:0)</c:v>
                </c:pt>
                <c:pt idx="13">
                  <c:v>34:0-DG (18:0-16:0)</c:v>
                </c:pt>
                <c:pt idx="14">
                  <c:v>36:6-DG (22:6-14:0 + 20:5-16:1)</c:v>
                </c:pt>
                <c:pt idx="15">
                  <c:v>36:5-DG (18:3-18:2)</c:v>
                </c:pt>
                <c:pt idx="16">
                  <c:v>36:4-DG (18:2-18:2 + 18:1-18:3)</c:v>
                </c:pt>
                <c:pt idx="17">
                  <c:v>36:4-DG ( 20:4-16:0 )</c:v>
                </c:pt>
                <c:pt idx="18">
                  <c:v>36:3-DG (18:1-18:2) </c:v>
                </c:pt>
                <c:pt idx="19">
                  <c:v>36:2-DG ( 18:1-18:1)</c:v>
                </c:pt>
                <c:pt idx="20">
                  <c:v>36:2-DG ( 18:2-18:0+20:2-16:0)</c:v>
                </c:pt>
                <c:pt idx="21">
                  <c:v>36:1-DG (18:1-18:0 + 20:1-16:0)</c:v>
                </c:pt>
                <c:pt idx="22">
                  <c:v>36:0-DG (18:0-18:0 )</c:v>
                </c:pt>
                <c:pt idx="23">
                  <c:v>38:7-DG (22:6-16:1)</c:v>
                </c:pt>
                <c:pt idx="24">
                  <c:v>38:6-DG (18:2-20:4)</c:v>
                </c:pt>
                <c:pt idx="25">
                  <c:v>38:6-DG (22:6-16:0)</c:v>
                </c:pt>
                <c:pt idx="26">
                  <c:v>38:5-DG (18:1-20:4)</c:v>
                </c:pt>
                <c:pt idx="27">
                  <c:v>38:5-DG (22:5-16:0)</c:v>
                </c:pt>
                <c:pt idx="28">
                  <c:v>38:4-DG (18:1-20:3 / 18:2-20:2)</c:v>
                </c:pt>
                <c:pt idx="29">
                  <c:v>38:4-DG (22:4-16:0)</c:v>
                </c:pt>
                <c:pt idx="30">
                  <c:v>38:4-DG (20:4-18:0)</c:v>
                </c:pt>
                <c:pt idx="31">
                  <c:v>38:3-DG (18:2-20:1 / 18:1-20:2)</c:v>
                </c:pt>
                <c:pt idx="32">
                  <c:v>38:3-DG (20:3-18:0)</c:v>
                </c:pt>
                <c:pt idx="33">
                  <c:v>38:2-DG (18:1-20:1)</c:v>
                </c:pt>
                <c:pt idx="34">
                  <c:v>38:2-DG (20:2-18:0)</c:v>
                </c:pt>
                <c:pt idx="35">
                  <c:v>38:1-DG (20:1-18:0/18:1-20:0)</c:v>
                </c:pt>
                <c:pt idx="36">
                  <c:v>40:8-DG (22:6-18:2)</c:v>
                </c:pt>
                <c:pt idx="37">
                  <c:v>40:7-DG (22:6-18:1)</c:v>
                </c:pt>
                <c:pt idx="38">
                  <c:v>40:6-DG (22:5-18:1)</c:v>
                </c:pt>
                <c:pt idx="39">
                  <c:v>40:6-DG (22:6-18:0)</c:v>
                </c:pt>
                <c:pt idx="40">
                  <c:v>40:5-DG (22:5-18:0)</c:v>
                </c:pt>
                <c:pt idx="41">
                  <c:v>40:4-DG (22:4-18:0)</c:v>
                </c:pt>
              </c:strCache>
            </c:strRef>
          </c:cat>
          <c:val>
            <c:numRef>
              <c:f>pla!$W$2:$W$43</c:f>
              <c:numCache>
                <c:formatCode>General</c:formatCode>
                <c:ptCount val="42"/>
                <c:pt idx="0">
                  <c:v>0</c:v>
                </c:pt>
                <c:pt idx="1">
                  <c:v>0.23484515753142476</c:v>
                </c:pt>
                <c:pt idx="2">
                  <c:v>0</c:v>
                </c:pt>
                <c:pt idx="3">
                  <c:v>1.1545827762470005</c:v>
                </c:pt>
                <c:pt idx="4">
                  <c:v>5.7488052519646953</c:v>
                </c:pt>
                <c:pt idx="5">
                  <c:v>3.3234346332948119</c:v>
                </c:pt>
                <c:pt idx="6">
                  <c:v>11.163753788593416</c:v>
                </c:pt>
                <c:pt idx="7">
                  <c:v>30.617825983664453</c:v>
                </c:pt>
                <c:pt idx="8">
                  <c:v>1.2941106871358004E-2</c:v>
                </c:pt>
                <c:pt idx="9">
                  <c:v>1.6771592807037174</c:v>
                </c:pt>
                <c:pt idx="10">
                  <c:v>0.67154861850022041</c:v>
                </c:pt>
                <c:pt idx="11">
                  <c:v>17.618397380773697</c:v>
                </c:pt>
                <c:pt idx="12">
                  <c:v>39.560228692121171</c:v>
                </c:pt>
                <c:pt idx="13">
                  <c:v>5.6016228485731103</c:v>
                </c:pt>
                <c:pt idx="14">
                  <c:v>0.37766931805431109</c:v>
                </c:pt>
                <c:pt idx="15">
                  <c:v>0.61393231758475997</c:v>
                </c:pt>
                <c:pt idx="16">
                  <c:v>2.7283236105917452</c:v>
                </c:pt>
                <c:pt idx="17">
                  <c:v>2.9457870770502521</c:v>
                </c:pt>
                <c:pt idx="18">
                  <c:v>8.3765260276145348</c:v>
                </c:pt>
                <c:pt idx="19">
                  <c:v>6.2486293802997439</c:v>
                </c:pt>
                <c:pt idx="20">
                  <c:v>3.109998252136299</c:v>
                </c:pt>
                <c:pt idx="21">
                  <c:v>3.3720280859370595</c:v>
                </c:pt>
                <c:pt idx="22">
                  <c:v>0.97048156418203302</c:v>
                </c:pt>
                <c:pt idx="23">
                  <c:v>0.70782478298211149</c:v>
                </c:pt>
                <c:pt idx="24">
                  <c:v>1.281973956144288</c:v>
                </c:pt>
                <c:pt idx="25">
                  <c:v>7.5490250550254299</c:v>
                </c:pt>
                <c:pt idx="26">
                  <c:v>3.1165035750052494</c:v>
                </c:pt>
                <c:pt idx="27">
                  <c:v>0.33425342071552711</c:v>
                </c:pt>
                <c:pt idx="28">
                  <c:v>0.7131355165242802</c:v>
                </c:pt>
                <c:pt idx="29">
                  <c:v>1.9003270515964887</c:v>
                </c:pt>
                <c:pt idx="30">
                  <c:v>8.1688880520742728</c:v>
                </c:pt>
                <c:pt idx="31">
                  <c:v>0.6945361630240634</c:v>
                </c:pt>
                <c:pt idx="32">
                  <c:v>1.0314792895976308</c:v>
                </c:pt>
                <c:pt idx="33">
                  <c:v>0.62837901856340239</c:v>
                </c:pt>
                <c:pt idx="34">
                  <c:v>0.20967835055465209</c:v>
                </c:pt>
                <c:pt idx="35">
                  <c:v>0.30621555596211264</c:v>
                </c:pt>
                <c:pt idx="36">
                  <c:v>1.011102991793946</c:v>
                </c:pt>
                <c:pt idx="37">
                  <c:v>2.932214428493725</c:v>
                </c:pt>
                <c:pt idx="38">
                  <c:v>0.60169709189099485</c:v>
                </c:pt>
                <c:pt idx="39">
                  <c:v>2.8387920709152099</c:v>
                </c:pt>
                <c:pt idx="40">
                  <c:v>0.7097605274864538</c:v>
                </c:pt>
                <c:pt idx="41">
                  <c:v>0.1987863145093701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A8A-4E3B-B720-2C9236C20A8F}"/>
            </c:ext>
          </c:extLst>
        </c:ser>
        <c:ser>
          <c:idx val="1"/>
          <c:order val="1"/>
          <c:spPr>
            <a:solidFill>
              <a:schemeClr val="tx1"/>
            </a:solidFill>
            <a:ln w="19050"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pla!$AB$2:$AB$43</c:f>
                <c:numCache>
                  <c:formatCode>General</c:formatCode>
                  <c:ptCount val="42"/>
                  <c:pt idx="0">
                    <c:v>0</c:v>
                  </c:pt>
                  <c:pt idx="1">
                    <c:v>0.1052351849006654</c:v>
                  </c:pt>
                  <c:pt idx="2">
                    <c:v>0</c:v>
                  </c:pt>
                  <c:pt idx="3">
                    <c:v>0.31743087218031879</c:v>
                  </c:pt>
                  <c:pt idx="4">
                    <c:v>1.2069991029642366</c:v>
                  </c:pt>
                  <c:pt idx="5">
                    <c:v>2.5465055842584281</c:v>
                  </c:pt>
                  <c:pt idx="6">
                    <c:v>1.5151798974605299</c:v>
                  </c:pt>
                  <c:pt idx="7">
                    <c:v>5.9094459779394048</c:v>
                  </c:pt>
                  <c:pt idx="8">
                    <c:v>9.1991341991341999E-2</c:v>
                  </c:pt>
                  <c:pt idx="9">
                    <c:v>1.2994891297149476</c:v>
                  </c:pt>
                  <c:pt idx="10">
                    <c:v>0.26183059407686005</c:v>
                  </c:pt>
                  <c:pt idx="11">
                    <c:v>9.2543327133498501</c:v>
                  </c:pt>
                  <c:pt idx="12">
                    <c:v>15.308996579365985</c:v>
                  </c:pt>
                  <c:pt idx="13">
                    <c:v>2.0878280137291312</c:v>
                  </c:pt>
                  <c:pt idx="14">
                    <c:v>0.34958205362896849</c:v>
                  </c:pt>
                  <c:pt idx="15">
                    <c:v>0.52309204202077175</c:v>
                  </c:pt>
                  <c:pt idx="16">
                    <c:v>2.7098496977270443</c:v>
                  </c:pt>
                  <c:pt idx="17">
                    <c:v>2.3272593554605874</c:v>
                  </c:pt>
                  <c:pt idx="18">
                    <c:v>6.3218539267056766</c:v>
                  </c:pt>
                  <c:pt idx="19">
                    <c:v>5.9958520146844405</c:v>
                  </c:pt>
                  <c:pt idx="20">
                    <c:v>1.2942215229708289</c:v>
                  </c:pt>
                  <c:pt idx="21">
                    <c:v>2.5412093201774386</c:v>
                  </c:pt>
                  <c:pt idx="22">
                    <c:v>0.28344872032315022</c:v>
                  </c:pt>
                  <c:pt idx="23">
                    <c:v>0.8557317518060078</c:v>
                  </c:pt>
                  <c:pt idx="24">
                    <c:v>1.2773070612152619</c:v>
                  </c:pt>
                  <c:pt idx="25">
                    <c:v>4.0247040927611559</c:v>
                  </c:pt>
                  <c:pt idx="26">
                    <c:v>2.470810311220307</c:v>
                  </c:pt>
                  <c:pt idx="27">
                    <c:v>0.22294187027124623</c:v>
                  </c:pt>
                  <c:pt idx="28">
                    <c:v>0.39951724883279943</c:v>
                  </c:pt>
                  <c:pt idx="29">
                    <c:v>2.8287223708019194</c:v>
                  </c:pt>
                  <c:pt idx="30">
                    <c:v>8.339122469018097</c:v>
                  </c:pt>
                  <c:pt idx="31">
                    <c:v>0.2830831599028823</c:v>
                  </c:pt>
                  <c:pt idx="32">
                    <c:v>0.90754727150604231</c:v>
                  </c:pt>
                  <c:pt idx="33">
                    <c:v>0.43257050040441142</c:v>
                  </c:pt>
                  <c:pt idx="34">
                    <c:v>0.1417136326827923</c:v>
                  </c:pt>
                  <c:pt idx="35">
                    <c:v>0.16059891092675579</c:v>
                  </c:pt>
                  <c:pt idx="36">
                    <c:v>1.1881564795697617</c:v>
                  </c:pt>
                  <c:pt idx="37">
                    <c:v>1.8510572315087674</c:v>
                  </c:pt>
                  <c:pt idx="38">
                    <c:v>0.99404956329681493</c:v>
                  </c:pt>
                  <c:pt idx="39">
                    <c:v>1.8738958967530042</c:v>
                  </c:pt>
                  <c:pt idx="40">
                    <c:v>0.58545528416487369</c:v>
                  </c:pt>
                  <c:pt idx="41">
                    <c:v>0.1883543184649579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19050">
                <a:solidFill>
                  <a:schemeClr val="tx1"/>
                </a:solidFill>
              </a:ln>
            </c:spPr>
          </c:errBars>
          <c:cat>
            <c:strRef>
              <c:f>pla!$V$2:$V$43</c:f>
              <c:strCache>
                <c:ptCount val="42"/>
                <c:pt idx="0">
                  <c:v>28:1-DG</c:v>
                </c:pt>
                <c:pt idx="1">
                  <c:v>28:0-DG ( 14:0-14:0 )</c:v>
                </c:pt>
                <c:pt idx="2">
                  <c:v>30:2-DG  ( 14:1-16:1+12:0-18:2 )</c:v>
                </c:pt>
                <c:pt idx="3">
                  <c:v>30:1-DG ( 14:0-16:1+12:0-18:1+16:0-14:1 )</c:v>
                </c:pt>
                <c:pt idx="4">
                  <c:v>30:0-DG (14:0-16:0 )</c:v>
                </c:pt>
                <c:pt idx="5">
                  <c:v>32:2-DG  ( 16:1-16:1+14:0-18:2+16:0-16:2 )</c:v>
                </c:pt>
                <c:pt idx="6">
                  <c:v>32:1-DG  ( 16:0-16:1+14:0-18:1 )</c:v>
                </c:pt>
                <c:pt idx="7">
                  <c:v>32:0-DG  ( 16:0-16:0 )</c:v>
                </c:pt>
                <c:pt idx="8">
                  <c:v>34:4-DG</c:v>
                </c:pt>
                <c:pt idx="9">
                  <c:v>34:3-DG (18:2-16:1)</c:v>
                </c:pt>
                <c:pt idx="10">
                  <c:v>34:3-DG (18:3-16:0)</c:v>
                </c:pt>
                <c:pt idx="11">
                  <c:v>34:2-DG ( 18:1-16:1+18:2-16:0 )</c:v>
                </c:pt>
                <c:pt idx="12">
                  <c:v>34:1-DG (18:1-16:0)</c:v>
                </c:pt>
                <c:pt idx="13">
                  <c:v>34:0-DG (18:0-16:0)</c:v>
                </c:pt>
                <c:pt idx="14">
                  <c:v>36:6-DG (22:6-14:0 + 20:5-16:1)</c:v>
                </c:pt>
                <c:pt idx="15">
                  <c:v>36:5-DG (18:3-18:2)</c:v>
                </c:pt>
                <c:pt idx="16">
                  <c:v>36:4-DG (18:2-18:2 + 18:1-18:3)</c:v>
                </c:pt>
                <c:pt idx="17">
                  <c:v>36:4-DG ( 20:4-16:0 )</c:v>
                </c:pt>
                <c:pt idx="18">
                  <c:v>36:3-DG (18:1-18:2) </c:v>
                </c:pt>
                <c:pt idx="19">
                  <c:v>36:2-DG ( 18:1-18:1)</c:v>
                </c:pt>
                <c:pt idx="20">
                  <c:v>36:2-DG ( 18:2-18:0+20:2-16:0)</c:v>
                </c:pt>
                <c:pt idx="21">
                  <c:v>36:1-DG (18:1-18:0 + 20:1-16:0)</c:v>
                </c:pt>
                <c:pt idx="22">
                  <c:v>36:0-DG (18:0-18:0 )</c:v>
                </c:pt>
                <c:pt idx="23">
                  <c:v>38:7-DG (22:6-16:1)</c:v>
                </c:pt>
                <c:pt idx="24">
                  <c:v>38:6-DG (18:2-20:4)</c:v>
                </c:pt>
                <c:pt idx="25">
                  <c:v>38:6-DG (22:6-16:0)</c:v>
                </c:pt>
                <c:pt idx="26">
                  <c:v>38:5-DG (18:1-20:4)</c:v>
                </c:pt>
                <c:pt idx="27">
                  <c:v>38:5-DG (22:5-16:0)</c:v>
                </c:pt>
                <c:pt idx="28">
                  <c:v>38:4-DG (18:1-20:3 / 18:2-20:2)</c:v>
                </c:pt>
                <c:pt idx="29">
                  <c:v>38:4-DG (22:4-16:0)</c:v>
                </c:pt>
                <c:pt idx="30">
                  <c:v>38:4-DG (20:4-18:0)</c:v>
                </c:pt>
                <c:pt idx="31">
                  <c:v>38:3-DG (18:2-20:1 / 18:1-20:2)</c:v>
                </c:pt>
                <c:pt idx="32">
                  <c:v>38:3-DG (20:3-18:0)</c:v>
                </c:pt>
                <c:pt idx="33">
                  <c:v>38:2-DG (18:1-20:1)</c:v>
                </c:pt>
                <c:pt idx="34">
                  <c:v>38:2-DG (20:2-18:0)</c:v>
                </c:pt>
                <c:pt idx="35">
                  <c:v>38:1-DG (20:1-18:0/18:1-20:0)</c:v>
                </c:pt>
                <c:pt idx="36">
                  <c:v>40:8-DG (22:6-18:2)</c:v>
                </c:pt>
                <c:pt idx="37">
                  <c:v>40:7-DG (22:6-18:1)</c:v>
                </c:pt>
                <c:pt idx="38">
                  <c:v>40:6-DG (22:5-18:1)</c:v>
                </c:pt>
                <c:pt idx="39">
                  <c:v>40:6-DG (22:6-18:0)</c:v>
                </c:pt>
                <c:pt idx="40">
                  <c:v>40:5-DG (22:5-18:0)</c:v>
                </c:pt>
                <c:pt idx="41">
                  <c:v>40:4-DG (22:4-18:0)</c:v>
                </c:pt>
              </c:strCache>
            </c:strRef>
          </c:cat>
          <c:val>
            <c:numRef>
              <c:f>pla!$X$2:$X$43</c:f>
              <c:numCache>
                <c:formatCode>General</c:formatCode>
                <c:ptCount val="42"/>
                <c:pt idx="0">
                  <c:v>0</c:v>
                </c:pt>
                <c:pt idx="1">
                  <c:v>0.20699297989642662</c:v>
                </c:pt>
                <c:pt idx="2">
                  <c:v>0</c:v>
                </c:pt>
                <c:pt idx="3">
                  <c:v>0.79167823072486265</c:v>
                </c:pt>
                <c:pt idx="4">
                  <c:v>3.5337821738296644</c:v>
                </c:pt>
                <c:pt idx="5">
                  <c:v>3.9922767687850524</c:v>
                </c:pt>
                <c:pt idx="6">
                  <c:v>7.8364281349248097</c:v>
                </c:pt>
                <c:pt idx="7">
                  <c:v>31.214469512361003</c:v>
                </c:pt>
                <c:pt idx="8">
                  <c:v>3.0663780663780664E-2</c:v>
                </c:pt>
                <c:pt idx="9">
                  <c:v>2.3966429545991161</c:v>
                </c:pt>
                <c:pt idx="10">
                  <c:v>0.64689653242764045</c:v>
                </c:pt>
                <c:pt idx="11">
                  <c:v>22.131481417429967</c:v>
                </c:pt>
                <c:pt idx="12">
                  <c:v>48.752384846029287</c:v>
                </c:pt>
                <c:pt idx="13">
                  <c:v>5.5416203444421717</c:v>
                </c:pt>
                <c:pt idx="14">
                  <c:v>0.36240334495051157</c:v>
                </c:pt>
                <c:pt idx="15">
                  <c:v>0.98015362110242354</c:v>
                </c:pt>
                <c:pt idx="16">
                  <c:v>3.941500889958518</c:v>
                </c:pt>
                <c:pt idx="17">
                  <c:v>2.5644490416744063</c:v>
                </c:pt>
                <c:pt idx="18">
                  <c:v>12.969953571529134</c:v>
                </c:pt>
                <c:pt idx="19">
                  <c:v>9.8201299010583227</c:v>
                </c:pt>
                <c:pt idx="20">
                  <c:v>3.4178344430663219</c:v>
                </c:pt>
                <c:pt idx="21">
                  <c:v>3.6272074260420561</c:v>
                </c:pt>
                <c:pt idx="22">
                  <c:v>0.37880314952002497</c:v>
                </c:pt>
                <c:pt idx="23">
                  <c:v>0.91134879721143403</c:v>
                </c:pt>
                <c:pt idx="24">
                  <c:v>0.7514113098199291</c:v>
                </c:pt>
                <c:pt idx="25">
                  <c:v>6.8204923984550527</c:v>
                </c:pt>
                <c:pt idx="26">
                  <c:v>3.5824005723706427</c:v>
                </c:pt>
                <c:pt idx="27">
                  <c:v>0.33021369375885712</c:v>
                </c:pt>
                <c:pt idx="28">
                  <c:v>0.63006583781271097</c:v>
                </c:pt>
                <c:pt idx="29">
                  <c:v>1.9840203079724685</c:v>
                </c:pt>
                <c:pt idx="30">
                  <c:v>9.9589710188632825</c:v>
                </c:pt>
                <c:pt idx="31">
                  <c:v>0.8400125596649356</c:v>
                </c:pt>
                <c:pt idx="32">
                  <c:v>1.2958454649749291</c:v>
                </c:pt>
                <c:pt idx="33">
                  <c:v>0.60290519688572697</c:v>
                </c:pt>
                <c:pt idx="34">
                  <c:v>0.1803671738807974</c:v>
                </c:pt>
                <c:pt idx="35">
                  <c:v>0.26417522200620797</c:v>
                </c:pt>
                <c:pt idx="36">
                  <c:v>1.3515751619514211</c:v>
                </c:pt>
                <c:pt idx="37">
                  <c:v>3.6032465881039442</c:v>
                </c:pt>
                <c:pt idx="38">
                  <c:v>0.94301658249937115</c:v>
                </c:pt>
                <c:pt idx="39">
                  <c:v>3.5094083819558564</c:v>
                </c:pt>
                <c:pt idx="40">
                  <c:v>0.93314145639471913</c:v>
                </c:pt>
                <c:pt idx="41">
                  <c:v>0.2163719234561125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FA8A-4E3B-B720-2C9236C20A8F}"/>
            </c:ext>
          </c:extLst>
        </c:ser>
        <c:ser>
          <c:idx val="2"/>
          <c:order val="2"/>
          <c:spPr>
            <a:solidFill>
              <a:schemeClr val="tx1">
                <a:lumMod val="65000"/>
                <a:lumOff val="35000"/>
              </a:schemeClr>
            </a:solidFill>
            <a:ln w="19050"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pla!$AC$2:$AC$43</c:f>
                <c:numCache>
                  <c:formatCode>General</c:formatCode>
                  <c:ptCount val="42"/>
                  <c:pt idx="0">
                    <c:v>0</c:v>
                  </c:pt>
                  <c:pt idx="1">
                    <c:v>0.15842566111630926</c:v>
                  </c:pt>
                  <c:pt idx="2">
                    <c:v>8.9509488005728582E-2</c:v>
                  </c:pt>
                  <c:pt idx="3">
                    <c:v>0.39759901914541718</c:v>
                  </c:pt>
                  <c:pt idx="4">
                    <c:v>1.1394055125601872</c:v>
                  </c:pt>
                  <c:pt idx="5">
                    <c:v>1.6377286878666468</c:v>
                  </c:pt>
                  <c:pt idx="6">
                    <c:v>1.358184880584957</c:v>
                  </c:pt>
                  <c:pt idx="7">
                    <c:v>7.4992285556198217</c:v>
                  </c:pt>
                  <c:pt idx="8">
                    <c:v>8.3781607696489471E-2</c:v>
                  </c:pt>
                  <c:pt idx="9">
                    <c:v>0.98461047387000455</c:v>
                  </c:pt>
                  <c:pt idx="10">
                    <c:v>0.16939384147305334</c:v>
                  </c:pt>
                  <c:pt idx="11">
                    <c:v>3.9729207584859303</c:v>
                  </c:pt>
                  <c:pt idx="12">
                    <c:v>6.396111074570257</c:v>
                  </c:pt>
                  <c:pt idx="13">
                    <c:v>1.4404645546805512</c:v>
                  </c:pt>
                  <c:pt idx="14">
                    <c:v>0.27305290988726238</c:v>
                  </c:pt>
                  <c:pt idx="15">
                    <c:v>1.156765918133867</c:v>
                  </c:pt>
                  <c:pt idx="16">
                    <c:v>1.1737229108656702</c:v>
                  </c:pt>
                  <c:pt idx="17">
                    <c:v>5.1075009027914531</c:v>
                  </c:pt>
                  <c:pt idx="18">
                    <c:v>2.9013233948740345</c:v>
                  </c:pt>
                  <c:pt idx="19">
                    <c:v>3.7942695581392032</c:v>
                  </c:pt>
                  <c:pt idx="20">
                    <c:v>0.68647907120007134</c:v>
                  </c:pt>
                  <c:pt idx="21">
                    <c:v>2.3540602675249427</c:v>
                  </c:pt>
                  <c:pt idx="22">
                    <c:v>0.1288017201585025</c:v>
                  </c:pt>
                  <c:pt idx="23">
                    <c:v>0.42375200755636072</c:v>
                  </c:pt>
                  <c:pt idx="24">
                    <c:v>2.5100407733136998</c:v>
                  </c:pt>
                  <c:pt idx="25">
                    <c:v>1.9650571821080214</c:v>
                  </c:pt>
                  <c:pt idx="26">
                    <c:v>1.7113098147757622</c:v>
                  </c:pt>
                  <c:pt idx="27">
                    <c:v>0.23196773988059305</c:v>
                  </c:pt>
                  <c:pt idx="28">
                    <c:v>0.57880417686045915</c:v>
                  </c:pt>
                  <c:pt idx="29">
                    <c:v>4.0694977870936953</c:v>
                  </c:pt>
                  <c:pt idx="30">
                    <c:v>6.2578267601578226</c:v>
                  </c:pt>
                  <c:pt idx="31">
                    <c:v>0.23993619227145294</c:v>
                  </c:pt>
                  <c:pt idx="32">
                    <c:v>0.27292481814585795</c:v>
                  </c:pt>
                  <c:pt idx="33">
                    <c:v>8.9443285402944286E-2</c:v>
                  </c:pt>
                  <c:pt idx="34">
                    <c:v>7.6988103699363999E-2</c:v>
                  </c:pt>
                  <c:pt idx="35">
                    <c:v>0.11461995612045248</c:v>
                  </c:pt>
                  <c:pt idx="36">
                    <c:v>0.42789227171071392</c:v>
                  </c:pt>
                  <c:pt idx="37">
                    <c:v>0.70908188195294264</c:v>
                  </c:pt>
                  <c:pt idx="38">
                    <c:v>0.55092331094162239</c:v>
                  </c:pt>
                  <c:pt idx="39">
                    <c:v>1.7134202298943813</c:v>
                  </c:pt>
                  <c:pt idx="40">
                    <c:v>0.21380571982469429</c:v>
                  </c:pt>
                  <c:pt idx="41">
                    <c:v>7.7215532527315292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19050">
                <a:solidFill>
                  <a:schemeClr val="tx1"/>
                </a:solidFill>
              </a:ln>
            </c:spPr>
          </c:errBars>
          <c:cat>
            <c:strRef>
              <c:f>pla!$V$2:$V$43</c:f>
              <c:strCache>
                <c:ptCount val="42"/>
                <c:pt idx="0">
                  <c:v>28:1-DG</c:v>
                </c:pt>
                <c:pt idx="1">
                  <c:v>28:0-DG ( 14:0-14:0 )</c:v>
                </c:pt>
                <c:pt idx="2">
                  <c:v>30:2-DG  ( 14:1-16:1+12:0-18:2 )</c:v>
                </c:pt>
                <c:pt idx="3">
                  <c:v>30:1-DG ( 14:0-16:1+12:0-18:1+16:0-14:1 )</c:v>
                </c:pt>
                <c:pt idx="4">
                  <c:v>30:0-DG (14:0-16:0 )</c:v>
                </c:pt>
                <c:pt idx="5">
                  <c:v>32:2-DG  ( 16:1-16:1+14:0-18:2+16:0-16:2 )</c:v>
                </c:pt>
                <c:pt idx="6">
                  <c:v>32:1-DG  ( 16:0-16:1+14:0-18:1 )</c:v>
                </c:pt>
                <c:pt idx="7">
                  <c:v>32:0-DG  ( 16:0-16:0 )</c:v>
                </c:pt>
                <c:pt idx="8">
                  <c:v>34:4-DG</c:v>
                </c:pt>
                <c:pt idx="9">
                  <c:v>34:3-DG (18:2-16:1)</c:v>
                </c:pt>
                <c:pt idx="10">
                  <c:v>34:3-DG (18:3-16:0)</c:v>
                </c:pt>
                <c:pt idx="11">
                  <c:v>34:2-DG ( 18:1-16:1+18:2-16:0 )</c:v>
                </c:pt>
                <c:pt idx="12">
                  <c:v>34:1-DG (18:1-16:0)</c:v>
                </c:pt>
                <c:pt idx="13">
                  <c:v>34:0-DG (18:0-16:0)</c:v>
                </c:pt>
                <c:pt idx="14">
                  <c:v>36:6-DG (22:6-14:0 + 20:5-16:1)</c:v>
                </c:pt>
                <c:pt idx="15">
                  <c:v>36:5-DG (18:3-18:2)</c:v>
                </c:pt>
                <c:pt idx="16">
                  <c:v>36:4-DG (18:2-18:2 + 18:1-18:3)</c:v>
                </c:pt>
                <c:pt idx="17">
                  <c:v>36:4-DG ( 20:4-16:0 )</c:v>
                </c:pt>
                <c:pt idx="18">
                  <c:v>36:3-DG (18:1-18:2) </c:v>
                </c:pt>
                <c:pt idx="19">
                  <c:v>36:2-DG ( 18:1-18:1)</c:v>
                </c:pt>
                <c:pt idx="20">
                  <c:v>36:2-DG ( 18:2-18:0+20:2-16:0)</c:v>
                </c:pt>
                <c:pt idx="21">
                  <c:v>36:1-DG (18:1-18:0 + 20:1-16:0)</c:v>
                </c:pt>
                <c:pt idx="22">
                  <c:v>36:0-DG (18:0-18:0 )</c:v>
                </c:pt>
                <c:pt idx="23">
                  <c:v>38:7-DG (22:6-16:1)</c:v>
                </c:pt>
                <c:pt idx="24">
                  <c:v>38:6-DG (18:2-20:4)</c:v>
                </c:pt>
                <c:pt idx="25">
                  <c:v>38:6-DG (22:6-16:0)</c:v>
                </c:pt>
                <c:pt idx="26">
                  <c:v>38:5-DG (18:1-20:4)</c:v>
                </c:pt>
                <c:pt idx="27">
                  <c:v>38:5-DG (22:5-16:0)</c:v>
                </c:pt>
                <c:pt idx="28">
                  <c:v>38:4-DG (18:1-20:3 / 18:2-20:2)</c:v>
                </c:pt>
                <c:pt idx="29">
                  <c:v>38:4-DG (22:4-16:0)</c:v>
                </c:pt>
                <c:pt idx="30">
                  <c:v>38:4-DG (20:4-18:0)</c:v>
                </c:pt>
                <c:pt idx="31">
                  <c:v>38:3-DG (18:2-20:1 / 18:1-20:2)</c:v>
                </c:pt>
                <c:pt idx="32">
                  <c:v>38:3-DG (20:3-18:0)</c:v>
                </c:pt>
                <c:pt idx="33">
                  <c:v>38:2-DG (18:1-20:1)</c:v>
                </c:pt>
                <c:pt idx="34">
                  <c:v>38:2-DG (20:2-18:0)</c:v>
                </c:pt>
                <c:pt idx="35">
                  <c:v>38:1-DG (20:1-18:0/18:1-20:0)</c:v>
                </c:pt>
                <c:pt idx="36">
                  <c:v>40:8-DG (22:6-18:2)</c:v>
                </c:pt>
                <c:pt idx="37">
                  <c:v>40:7-DG (22:6-18:1)</c:v>
                </c:pt>
                <c:pt idx="38">
                  <c:v>40:6-DG (22:5-18:1)</c:v>
                </c:pt>
                <c:pt idx="39">
                  <c:v>40:6-DG (22:6-18:0)</c:v>
                </c:pt>
                <c:pt idx="40">
                  <c:v>40:5-DG (22:5-18:0)</c:v>
                </c:pt>
                <c:pt idx="41">
                  <c:v>40:4-DG (22:4-18:0)</c:v>
                </c:pt>
              </c:strCache>
            </c:strRef>
          </c:cat>
          <c:val>
            <c:numRef>
              <c:f>pla!$Y$2:$Y$43</c:f>
              <c:numCache>
                <c:formatCode>General</c:formatCode>
                <c:ptCount val="42"/>
                <c:pt idx="0">
                  <c:v>0</c:v>
                </c:pt>
                <c:pt idx="1">
                  <c:v>0.25857223559044584</c:v>
                </c:pt>
                <c:pt idx="2">
                  <c:v>2.9836496001909529E-2</c:v>
                </c:pt>
                <c:pt idx="3">
                  <c:v>1.389756224800432</c:v>
                </c:pt>
                <c:pt idx="4">
                  <c:v>5.5288806247435662</c:v>
                </c:pt>
                <c:pt idx="5">
                  <c:v>4.5347229171055918</c:v>
                </c:pt>
                <c:pt idx="6">
                  <c:v>7.5995830583661261</c:v>
                </c:pt>
                <c:pt idx="7">
                  <c:v>34.253053358618324</c:v>
                </c:pt>
                <c:pt idx="8">
                  <c:v>4.8330999792755069E-2</c:v>
                </c:pt>
                <c:pt idx="9">
                  <c:v>2.4068131635263934</c:v>
                </c:pt>
                <c:pt idx="10">
                  <c:v>0.88921936767998122</c:v>
                </c:pt>
                <c:pt idx="11">
                  <c:v>20.791949555074233</c:v>
                </c:pt>
                <c:pt idx="12">
                  <c:v>44.351460911961354</c:v>
                </c:pt>
                <c:pt idx="13">
                  <c:v>8.2545910779306215</c:v>
                </c:pt>
                <c:pt idx="14">
                  <c:v>0.43587907344642118</c:v>
                </c:pt>
                <c:pt idx="15">
                  <c:v>1.0249337842453976</c:v>
                </c:pt>
                <c:pt idx="16">
                  <c:v>3.4591056475758322</c:v>
                </c:pt>
                <c:pt idx="17">
                  <c:v>4.5482850684486706</c:v>
                </c:pt>
                <c:pt idx="18">
                  <c:v>12.710889541568502</c:v>
                </c:pt>
                <c:pt idx="19">
                  <c:v>10.341083466947886</c:v>
                </c:pt>
                <c:pt idx="20">
                  <c:v>5.3549738191605609</c:v>
                </c:pt>
                <c:pt idx="21">
                  <c:v>4.3927613888473127</c:v>
                </c:pt>
                <c:pt idx="22">
                  <c:v>0.60337496653053746</c:v>
                </c:pt>
                <c:pt idx="23">
                  <c:v>0.52556953281758323</c:v>
                </c:pt>
                <c:pt idx="24">
                  <c:v>1.2200824196983751</c:v>
                </c:pt>
                <c:pt idx="25">
                  <c:v>6.6955098859325561</c:v>
                </c:pt>
                <c:pt idx="26">
                  <c:v>3.5404599043145586</c:v>
                </c:pt>
                <c:pt idx="27">
                  <c:v>0.76254699760057298</c:v>
                </c:pt>
                <c:pt idx="28">
                  <c:v>1.2997451723878604</c:v>
                </c:pt>
                <c:pt idx="29">
                  <c:v>4.3314402273686738</c:v>
                </c:pt>
                <c:pt idx="30">
                  <c:v>9.9266301750634778</c:v>
                </c:pt>
                <c:pt idx="31">
                  <c:v>1.1797498772925261</c:v>
                </c:pt>
                <c:pt idx="32">
                  <c:v>1.0149786541543215</c:v>
                </c:pt>
                <c:pt idx="33">
                  <c:v>0.59475616114122365</c:v>
                </c:pt>
                <c:pt idx="34">
                  <c:v>0.3576719237492485</c:v>
                </c:pt>
                <c:pt idx="35">
                  <c:v>0.26493329627935508</c:v>
                </c:pt>
                <c:pt idx="36">
                  <c:v>0.63493887535585614</c:v>
                </c:pt>
                <c:pt idx="37">
                  <c:v>2.5646049016358976</c:v>
                </c:pt>
                <c:pt idx="38">
                  <c:v>0.83891179939179072</c:v>
                </c:pt>
                <c:pt idx="39">
                  <c:v>3.4638027352777234</c:v>
                </c:pt>
                <c:pt idx="40">
                  <c:v>0.8308518598270106</c:v>
                </c:pt>
                <c:pt idx="41">
                  <c:v>0.6499356636398622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FA8A-4E3B-B720-2C9236C20A8F}"/>
            </c:ext>
          </c:extLst>
        </c:ser>
        <c:ser>
          <c:idx val="3"/>
          <c:order val="3"/>
          <c:spPr>
            <a:pattFill prst="dkDnDiag">
              <a:fgClr>
                <a:schemeClr val="tx1"/>
              </a:fgClr>
              <a:bgClr>
                <a:schemeClr val="bg1"/>
              </a:bgClr>
            </a:pattFill>
            <a:ln w="19050"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pla!$AD$2:$AD$43</c:f>
                <c:numCache>
                  <c:formatCode>General</c:formatCode>
                  <c:ptCount val="42"/>
                  <c:pt idx="0">
                    <c:v>0</c:v>
                  </c:pt>
                  <c:pt idx="1">
                    <c:v>0.12409842715564003</c:v>
                  </c:pt>
                  <c:pt idx="2">
                    <c:v>0</c:v>
                  </c:pt>
                  <c:pt idx="3">
                    <c:v>0.60421110107380505</c:v>
                  </c:pt>
                  <c:pt idx="4">
                    <c:v>1.5524944604626116</c:v>
                  </c:pt>
                  <c:pt idx="5">
                    <c:v>2.7296103603632691</c:v>
                  </c:pt>
                  <c:pt idx="6">
                    <c:v>2.3774356860786954</c:v>
                  </c:pt>
                  <c:pt idx="7">
                    <c:v>7.5500215413163794</c:v>
                  </c:pt>
                  <c:pt idx="8">
                    <c:v>8.5426521946323331E-2</c:v>
                  </c:pt>
                  <c:pt idx="9">
                    <c:v>1.0977220076974259</c:v>
                  </c:pt>
                  <c:pt idx="10">
                    <c:v>0.22035967113749358</c:v>
                  </c:pt>
                  <c:pt idx="11">
                    <c:v>7.8393753246635933</c:v>
                  </c:pt>
                  <c:pt idx="12">
                    <c:v>12.623296500020087</c:v>
                  </c:pt>
                  <c:pt idx="13">
                    <c:v>1.5458145141653807</c:v>
                  </c:pt>
                  <c:pt idx="14">
                    <c:v>0.28241355469869439</c:v>
                  </c:pt>
                  <c:pt idx="15">
                    <c:v>1.9947371161851604</c:v>
                  </c:pt>
                  <c:pt idx="16">
                    <c:v>1.8908627368989044</c:v>
                  </c:pt>
                  <c:pt idx="17">
                    <c:v>9.3235691958560469</c:v>
                  </c:pt>
                  <c:pt idx="18">
                    <c:v>4.72368984452992</c:v>
                  </c:pt>
                  <c:pt idx="19">
                    <c:v>7.8242023819769564</c:v>
                  </c:pt>
                  <c:pt idx="20">
                    <c:v>1.2132153343842396</c:v>
                  </c:pt>
                  <c:pt idx="21">
                    <c:v>2.5732551096213521</c:v>
                  </c:pt>
                  <c:pt idx="22">
                    <c:v>0.15773932732752952</c:v>
                  </c:pt>
                  <c:pt idx="23">
                    <c:v>0.37310480068729424</c:v>
                  </c:pt>
                  <c:pt idx="24">
                    <c:v>2.0100691193069085</c:v>
                  </c:pt>
                  <c:pt idx="25">
                    <c:v>1.5998408584041341</c:v>
                  </c:pt>
                  <c:pt idx="26">
                    <c:v>1.2724330283303114</c:v>
                  </c:pt>
                  <c:pt idx="27">
                    <c:v>0.31616361344378408</c:v>
                  </c:pt>
                  <c:pt idx="28">
                    <c:v>0.60760991939374331</c:v>
                  </c:pt>
                  <c:pt idx="29">
                    <c:v>4.0335763360475845</c:v>
                  </c:pt>
                  <c:pt idx="30">
                    <c:v>5.1184827299368374</c:v>
                  </c:pt>
                  <c:pt idx="31">
                    <c:v>0.37735293235965517</c:v>
                  </c:pt>
                  <c:pt idx="32">
                    <c:v>0.26862103585482561</c:v>
                  </c:pt>
                  <c:pt idx="33">
                    <c:v>0.20480249445149634</c:v>
                  </c:pt>
                  <c:pt idx="34">
                    <c:v>0.17115308623702563</c:v>
                  </c:pt>
                  <c:pt idx="35">
                    <c:v>0.11796507236106868</c:v>
                  </c:pt>
                  <c:pt idx="36">
                    <c:v>0.39827173775676372</c:v>
                  </c:pt>
                  <c:pt idx="37">
                    <c:v>0.53395434097711536</c:v>
                  </c:pt>
                  <c:pt idx="38">
                    <c:v>0.54599036671064038</c:v>
                  </c:pt>
                  <c:pt idx="39">
                    <c:v>0.65574653767263447</c:v>
                  </c:pt>
                  <c:pt idx="40">
                    <c:v>0.15883271069286178</c:v>
                  </c:pt>
                  <c:pt idx="41">
                    <c:v>0.1143326669784193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19050">
                <a:solidFill>
                  <a:schemeClr val="tx1"/>
                </a:solidFill>
              </a:ln>
            </c:spPr>
          </c:errBars>
          <c:cat>
            <c:strRef>
              <c:f>pla!$V$2:$V$43</c:f>
              <c:strCache>
                <c:ptCount val="42"/>
                <c:pt idx="0">
                  <c:v>28:1-DG</c:v>
                </c:pt>
                <c:pt idx="1">
                  <c:v>28:0-DG ( 14:0-14:0 )</c:v>
                </c:pt>
                <c:pt idx="2">
                  <c:v>30:2-DG  ( 14:1-16:1+12:0-18:2 )</c:v>
                </c:pt>
                <c:pt idx="3">
                  <c:v>30:1-DG ( 14:0-16:1+12:0-18:1+16:0-14:1 )</c:v>
                </c:pt>
                <c:pt idx="4">
                  <c:v>30:0-DG (14:0-16:0 )</c:v>
                </c:pt>
                <c:pt idx="5">
                  <c:v>32:2-DG  ( 16:1-16:1+14:0-18:2+16:0-16:2 )</c:v>
                </c:pt>
                <c:pt idx="6">
                  <c:v>32:1-DG  ( 16:0-16:1+14:0-18:1 )</c:v>
                </c:pt>
                <c:pt idx="7">
                  <c:v>32:0-DG  ( 16:0-16:0 )</c:v>
                </c:pt>
                <c:pt idx="8">
                  <c:v>34:4-DG</c:v>
                </c:pt>
                <c:pt idx="9">
                  <c:v>34:3-DG (18:2-16:1)</c:v>
                </c:pt>
                <c:pt idx="10">
                  <c:v>34:3-DG (18:3-16:0)</c:v>
                </c:pt>
                <c:pt idx="11">
                  <c:v>34:2-DG ( 18:1-16:1+18:2-16:0 )</c:v>
                </c:pt>
                <c:pt idx="12">
                  <c:v>34:1-DG (18:1-16:0)</c:v>
                </c:pt>
                <c:pt idx="13">
                  <c:v>34:0-DG (18:0-16:0)</c:v>
                </c:pt>
                <c:pt idx="14">
                  <c:v>36:6-DG (22:6-14:0 + 20:5-16:1)</c:v>
                </c:pt>
                <c:pt idx="15">
                  <c:v>36:5-DG (18:3-18:2)</c:v>
                </c:pt>
                <c:pt idx="16">
                  <c:v>36:4-DG (18:2-18:2 + 18:1-18:3)</c:v>
                </c:pt>
                <c:pt idx="17">
                  <c:v>36:4-DG ( 20:4-16:0 )</c:v>
                </c:pt>
                <c:pt idx="18">
                  <c:v>36:3-DG (18:1-18:2) </c:v>
                </c:pt>
                <c:pt idx="19">
                  <c:v>36:2-DG ( 18:1-18:1)</c:v>
                </c:pt>
                <c:pt idx="20">
                  <c:v>36:2-DG ( 18:2-18:0+20:2-16:0)</c:v>
                </c:pt>
                <c:pt idx="21">
                  <c:v>36:1-DG (18:1-18:0 + 20:1-16:0)</c:v>
                </c:pt>
                <c:pt idx="22">
                  <c:v>36:0-DG (18:0-18:0 )</c:v>
                </c:pt>
                <c:pt idx="23">
                  <c:v>38:7-DG (22:6-16:1)</c:v>
                </c:pt>
                <c:pt idx="24">
                  <c:v>38:6-DG (18:2-20:4)</c:v>
                </c:pt>
                <c:pt idx="25">
                  <c:v>38:6-DG (22:6-16:0)</c:v>
                </c:pt>
                <c:pt idx="26">
                  <c:v>38:5-DG (18:1-20:4)</c:v>
                </c:pt>
                <c:pt idx="27">
                  <c:v>38:5-DG (22:5-16:0)</c:v>
                </c:pt>
                <c:pt idx="28">
                  <c:v>38:4-DG (18:1-20:3 / 18:2-20:2)</c:v>
                </c:pt>
                <c:pt idx="29">
                  <c:v>38:4-DG (22:4-16:0)</c:v>
                </c:pt>
                <c:pt idx="30">
                  <c:v>38:4-DG (20:4-18:0)</c:v>
                </c:pt>
                <c:pt idx="31">
                  <c:v>38:3-DG (18:2-20:1 / 18:1-20:2)</c:v>
                </c:pt>
                <c:pt idx="32">
                  <c:v>38:3-DG (20:3-18:0)</c:v>
                </c:pt>
                <c:pt idx="33">
                  <c:v>38:2-DG (18:1-20:1)</c:v>
                </c:pt>
                <c:pt idx="34">
                  <c:v>38:2-DG (20:2-18:0)</c:v>
                </c:pt>
                <c:pt idx="35">
                  <c:v>38:1-DG (20:1-18:0/18:1-20:0)</c:v>
                </c:pt>
                <c:pt idx="36">
                  <c:v>40:8-DG (22:6-18:2)</c:v>
                </c:pt>
                <c:pt idx="37">
                  <c:v>40:7-DG (22:6-18:1)</c:v>
                </c:pt>
                <c:pt idx="38">
                  <c:v>40:6-DG (22:5-18:1)</c:v>
                </c:pt>
                <c:pt idx="39">
                  <c:v>40:6-DG (22:6-18:0)</c:v>
                </c:pt>
                <c:pt idx="40">
                  <c:v>40:5-DG (22:5-18:0)</c:v>
                </c:pt>
                <c:pt idx="41">
                  <c:v>40:4-DG (22:4-18:0)</c:v>
                </c:pt>
              </c:strCache>
            </c:strRef>
          </c:cat>
          <c:val>
            <c:numRef>
              <c:f>pla!$Z$2:$Z$43</c:f>
              <c:numCache>
                <c:formatCode>General</c:formatCode>
                <c:ptCount val="42"/>
                <c:pt idx="0">
                  <c:v>0</c:v>
                </c:pt>
                <c:pt idx="1">
                  <c:v>0.15433665769807983</c:v>
                </c:pt>
                <c:pt idx="2">
                  <c:v>0</c:v>
                </c:pt>
                <c:pt idx="3">
                  <c:v>1.2879092849317895</c:v>
                </c:pt>
                <c:pt idx="4">
                  <c:v>3.7744164368611255</c:v>
                </c:pt>
                <c:pt idx="5">
                  <c:v>5.7597823004757238</c:v>
                </c:pt>
                <c:pt idx="6">
                  <c:v>8.2120577399247878</c:v>
                </c:pt>
                <c:pt idx="7">
                  <c:v>32.178497067300427</c:v>
                </c:pt>
                <c:pt idx="8">
                  <c:v>4.9313157277294462E-2</c:v>
                </c:pt>
                <c:pt idx="9">
                  <c:v>3.1467087569045531</c:v>
                </c:pt>
                <c:pt idx="10">
                  <c:v>0.69351959622585024</c:v>
                </c:pt>
                <c:pt idx="11">
                  <c:v>27.768949385351021</c:v>
                </c:pt>
                <c:pt idx="12">
                  <c:v>60.959780931839504</c:v>
                </c:pt>
                <c:pt idx="13">
                  <c:v>8.0772629702510557</c:v>
                </c:pt>
                <c:pt idx="14">
                  <c:v>0.28649824476486818</c:v>
                </c:pt>
                <c:pt idx="15">
                  <c:v>1.6461683037890524</c:v>
                </c:pt>
                <c:pt idx="16">
                  <c:v>4.1959467199674982</c:v>
                </c:pt>
                <c:pt idx="17">
                  <c:v>4.8220493036712915</c:v>
                </c:pt>
                <c:pt idx="18">
                  <c:v>18.726577332182185</c:v>
                </c:pt>
                <c:pt idx="19">
                  <c:v>15.869586473424006</c:v>
                </c:pt>
                <c:pt idx="20">
                  <c:v>5.1938670437665877</c:v>
                </c:pt>
                <c:pt idx="21">
                  <c:v>4.7932347346895856</c:v>
                </c:pt>
                <c:pt idx="22">
                  <c:v>0.61791813061735945</c:v>
                </c:pt>
                <c:pt idx="23">
                  <c:v>0.58994970564216964</c:v>
                </c:pt>
                <c:pt idx="24">
                  <c:v>0.96671191902892151</c:v>
                </c:pt>
                <c:pt idx="25">
                  <c:v>4.3244239987112385</c:v>
                </c:pt>
                <c:pt idx="26">
                  <c:v>2.4391624984318852</c:v>
                </c:pt>
                <c:pt idx="27">
                  <c:v>0.42175827892368323</c:v>
                </c:pt>
                <c:pt idx="28">
                  <c:v>1.2089566495862556</c:v>
                </c:pt>
                <c:pt idx="29">
                  <c:v>3.4686894260344459</c:v>
                </c:pt>
                <c:pt idx="30">
                  <c:v>8.2785875295617579</c:v>
                </c:pt>
                <c:pt idx="31">
                  <c:v>1.0543323703133773</c:v>
                </c:pt>
                <c:pt idx="32">
                  <c:v>0.82099444196041838</c:v>
                </c:pt>
                <c:pt idx="33">
                  <c:v>0.60979437173003204</c:v>
                </c:pt>
                <c:pt idx="34">
                  <c:v>0.28328159838213191</c:v>
                </c:pt>
                <c:pt idx="35">
                  <c:v>0.2324807963455969</c:v>
                </c:pt>
                <c:pt idx="36">
                  <c:v>0.57905391171131626</c:v>
                </c:pt>
                <c:pt idx="37">
                  <c:v>2.3635787702847968</c:v>
                </c:pt>
                <c:pt idx="38">
                  <c:v>0.75489326615530195</c:v>
                </c:pt>
                <c:pt idx="39">
                  <c:v>2.8996581062037232</c:v>
                </c:pt>
                <c:pt idx="40">
                  <c:v>0.7501099393134415</c:v>
                </c:pt>
                <c:pt idx="41">
                  <c:v>0.5108339209433698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FA8A-4E3B-B720-2C9236C20A8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90341760"/>
        <c:axId val="390343296"/>
      </c:barChart>
      <c:catAx>
        <c:axId val="39034176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 w="19050">
            <a:solidFill>
              <a:schemeClr val="tx1"/>
            </a:solidFill>
          </a:ln>
        </c:spPr>
        <c:txPr>
          <a:bodyPr/>
          <a:lstStyle/>
          <a:p>
            <a:pPr>
              <a:defRPr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ja-JP"/>
          </a:p>
        </c:txPr>
        <c:crossAx val="390343296"/>
        <c:crosses val="autoZero"/>
        <c:auto val="1"/>
        <c:lblAlgn val="ctr"/>
        <c:lblOffset val="100"/>
        <c:noMultiLvlLbl val="0"/>
      </c:catAx>
      <c:valAx>
        <c:axId val="390343296"/>
        <c:scaling>
          <c:orientation val="minMax"/>
        </c:scaling>
        <c:delete val="0"/>
        <c:axPos val="l"/>
        <c:majorGridlines>
          <c:spPr>
            <a:ln>
              <a:noFill/>
            </a:ln>
          </c:spPr>
        </c:majorGridlines>
        <c:numFmt formatCode="General" sourceLinked="1"/>
        <c:majorTickMark val="out"/>
        <c:minorTickMark val="none"/>
        <c:tickLblPos val="nextTo"/>
        <c:spPr>
          <a:ln w="19050">
            <a:solidFill>
              <a:schemeClr val="tx1"/>
            </a:solidFill>
          </a:ln>
        </c:spPr>
        <c:txPr>
          <a:bodyPr/>
          <a:lstStyle/>
          <a:p>
            <a:pPr>
              <a:defRPr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ja-JP"/>
          </a:p>
        </c:txPr>
        <c:crossAx val="390341760"/>
        <c:crosses val="autoZero"/>
        <c:crossBetween val="between"/>
      </c:valAx>
    </c:plotArea>
    <c:plotVisOnly val="1"/>
    <c:dispBlanksAs val="gap"/>
    <c:showDLblsOverMax val="0"/>
  </c:chart>
  <c:externalData r:id="rId2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3!$R$50</c:f>
              <c:strCache>
                <c:ptCount val="1"/>
              </c:strCache>
            </c:strRef>
          </c:tx>
          <c:spPr>
            <a:solidFill>
              <a:schemeClr val="bg1"/>
            </a:solidFill>
            <a:ln w="19050"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Sheet3!$R$62:$R$70</c:f>
                <c:numCache>
                  <c:formatCode>General</c:formatCode>
                  <c:ptCount val="9"/>
                  <c:pt idx="0">
                    <c:v>1.5560375194824527</c:v>
                  </c:pt>
                  <c:pt idx="1">
                    <c:v>20.663226717688286</c:v>
                  </c:pt>
                  <c:pt idx="2">
                    <c:v>1.6880453825566164</c:v>
                  </c:pt>
                  <c:pt idx="3">
                    <c:v>0.78058873849076238</c:v>
                  </c:pt>
                  <c:pt idx="4">
                    <c:v>0.69409747619280371</c:v>
                  </c:pt>
                  <c:pt idx="5">
                    <c:v>0.13745704467353953</c:v>
                  </c:pt>
                  <c:pt idx="6">
                    <c:v>2.3644659087605828</c:v>
                  </c:pt>
                  <c:pt idx="7">
                    <c:v>7.5387818803962992</c:v>
                  </c:pt>
                  <c:pt idx="8">
                    <c:v>4.156796290618419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19050">
                <a:solidFill>
                  <a:schemeClr val="tx1"/>
                </a:solidFill>
              </a:ln>
            </c:spPr>
          </c:errBars>
          <c:cat>
            <c:strRef>
              <c:f>Sheet3!$Q$51:$Q$59</c:f>
              <c:strCache>
                <c:ptCount val="9"/>
                <c:pt idx="0">
                  <c:v>C16:0-d18:1</c:v>
                </c:pt>
                <c:pt idx="1">
                  <c:v>C18:0-d18:1</c:v>
                </c:pt>
                <c:pt idx="2">
                  <c:v>C19:0-d18:1</c:v>
                </c:pt>
                <c:pt idx="3">
                  <c:v>C20:5-d18:1</c:v>
                </c:pt>
                <c:pt idx="4">
                  <c:v>C20:0-d18:1</c:v>
                </c:pt>
                <c:pt idx="5">
                  <c:v>C22:0-d18:2</c:v>
                </c:pt>
                <c:pt idx="6">
                  <c:v>C22:0-d18:1</c:v>
                </c:pt>
                <c:pt idx="7">
                  <c:v>C24:1-d18:1</c:v>
                </c:pt>
                <c:pt idx="8">
                  <c:v>C24:0-d18:1</c:v>
                </c:pt>
              </c:strCache>
            </c:strRef>
          </c:cat>
          <c:val>
            <c:numRef>
              <c:f>Sheet3!$R$51:$R$59</c:f>
              <c:numCache>
                <c:formatCode>General</c:formatCode>
                <c:ptCount val="9"/>
                <c:pt idx="0">
                  <c:v>3.9181249329393304</c:v>
                </c:pt>
                <c:pt idx="1">
                  <c:v>42.311419975976378</c:v>
                </c:pt>
                <c:pt idx="2">
                  <c:v>4.0959249486661173</c:v>
                </c:pt>
                <c:pt idx="3">
                  <c:v>2.3332739589405045</c:v>
                </c:pt>
                <c:pt idx="4">
                  <c:v>1.5880124627695571</c:v>
                </c:pt>
                <c:pt idx="5">
                  <c:v>0</c:v>
                </c:pt>
                <c:pt idx="6">
                  <c:v>4.9095451673189281</c:v>
                </c:pt>
                <c:pt idx="7">
                  <c:v>15.68128118012493</c:v>
                </c:pt>
                <c:pt idx="8">
                  <c:v>7.956368335225853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8EE-4DC4-86B2-F8AC84FF7B1E}"/>
            </c:ext>
          </c:extLst>
        </c:ser>
        <c:ser>
          <c:idx val="1"/>
          <c:order val="1"/>
          <c:tx>
            <c:strRef>
              <c:f>Sheet3!$S$50</c:f>
              <c:strCache>
                <c:ptCount val="1"/>
              </c:strCache>
            </c:strRef>
          </c:tx>
          <c:spPr>
            <a:solidFill>
              <a:schemeClr val="tx1"/>
            </a:solidFill>
            <a:ln w="19050"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Sheet3!$S$62:$S$70</c:f>
                <c:numCache>
                  <c:formatCode>General</c:formatCode>
                  <c:ptCount val="9"/>
                  <c:pt idx="0">
                    <c:v>0.91749085931984786</c:v>
                  </c:pt>
                  <c:pt idx="1">
                    <c:v>12.103154259142359</c:v>
                  </c:pt>
                  <c:pt idx="2">
                    <c:v>0.70376435881421184</c:v>
                  </c:pt>
                  <c:pt idx="3">
                    <c:v>0.63488036772732137</c:v>
                  </c:pt>
                  <c:pt idx="4">
                    <c:v>0.43345985177340096</c:v>
                  </c:pt>
                  <c:pt idx="5">
                    <c:v>0.12880317616025821</c:v>
                  </c:pt>
                  <c:pt idx="6">
                    <c:v>1.2191781735070852</c:v>
                  </c:pt>
                  <c:pt idx="7">
                    <c:v>3.184682471544062</c:v>
                  </c:pt>
                  <c:pt idx="8">
                    <c:v>1.597761013573984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19050">
                <a:solidFill>
                  <a:schemeClr val="tx1"/>
                </a:solidFill>
              </a:ln>
            </c:spPr>
          </c:errBars>
          <c:cat>
            <c:strRef>
              <c:f>Sheet3!$Q$51:$Q$59</c:f>
              <c:strCache>
                <c:ptCount val="9"/>
                <c:pt idx="0">
                  <c:v>C16:0-d18:1</c:v>
                </c:pt>
                <c:pt idx="1">
                  <c:v>C18:0-d18:1</c:v>
                </c:pt>
                <c:pt idx="2">
                  <c:v>C19:0-d18:1</c:v>
                </c:pt>
                <c:pt idx="3">
                  <c:v>C20:5-d18:1</c:v>
                </c:pt>
                <c:pt idx="4">
                  <c:v>C20:0-d18:1</c:v>
                </c:pt>
                <c:pt idx="5">
                  <c:v>C22:0-d18:2</c:v>
                </c:pt>
                <c:pt idx="6">
                  <c:v>C22:0-d18:1</c:v>
                </c:pt>
                <c:pt idx="7">
                  <c:v>C24:1-d18:1</c:v>
                </c:pt>
                <c:pt idx="8">
                  <c:v>C24:0-d18:1</c:v>
                </c:pt>
              </c:strCache>
            </c:strRef>
          </c:cat>
          <c:val>
            <c:numRef>
              <c:f>Sheet3!$S$51:$S$59</c:f>
              <c:numCache>
                <c:formatCode>General</c:formatCode>
                <c:ptCount val="9"/>
                <c:pt idx="0">
                  <c:v>3.7211833767392859</c:v>
                </c:pt>
                <c:pt idx="1">
                  <c:v>54.733761424238693</c:v>
                </c:pt>
                <c:pt idx="2">
                  <c:v>4.3154633558213256</c:v>
                </c:pt>
                <c:pt idx="3">
                  <c:v>2.4718638235725559</c:v>
                </c:pt>
                <c:pt idx="4">
                  <c:v>1.4164178643336502</c:v>
                </c:pt>
                <c:pt idx="5">
                  <c:v>0.82207175134806698</c:v>
                </c:pt>
                <c:pt idx="6">
                  <c:v>5.1583258236799345</c:v>
                </c:pt>
                <c:pt idx="7">
                  <c:v>14.556660121200292</c:v>
                </c:pt>
                <c:pt idx="8">
                  <c:v>8.047662015391313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A8EE-4DC4-86B2-F8AC84FF7B1E}"/>
            </c:ext>
          </c:extLst>
        </c:ser>
        <c:ser>
          <c:idx val="2"/>
          <c:order val="2"/>
          <c:tx>
            <c:strRef>
              <c:f>Sheet3!$T$50</c:f>
              <c:strCache>
                <c:ptCount val="1"/>
              </c:strCache>
            </c:strRef>
          </c:tx>
          <c:spPr>
            <a:solidFill>
              <a:schemeClr val="tx1">
                <a:lumMod val="65000"/>
                <a:lumOff val="35000"/>
              </a:schemeClr>
            </a:solidFill>
            <a:ln w="19050"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Sheet3!$T$62:$T$70</c:f>
                <c:numCache>
                  <c:formatCode>General</c:formatCode>
                  <c:ptCount val="9"/>
                  <c:pt idx="0">
                    <c:v>1.3662671603497771</c:v>
                  </c:pt>
                  <c:pt idx="1">
                    <c:v>15.513277478144669</c:v>
                  </c:pt>
                  <c:pt idx="2">
                    <c:v>0.54460962447528827</c:v>
                  </c:pt>
                  <c:pt idx="3">
                    <c:v>1.2019874114886033</c:v>
                  </c:pt>
                  <c:pt idx="4">
                    <c:v>0.446769574228078</c:v>
                  </c:pt>
                  <c:pt idx="5">
                    <c:v>0.13682940261820459</c:v>
                  </c:pt>
                  <c:pt idx="6">
                    <c:v>1.9757779487910754</c:v>
                  </c:pt>
                  <c:pt idx="7">
                    <c:v>3.9900355348089378</c:v>
                  </c:pt>
                  <c:pt idx="8">
                    <c:v>2.042639086649327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19050">
                <a:solidFill>
                  <a:schemeClr val="tx1"/>
                </a:solidFill>
              </a:ln>
            </c:spPr>
          </c:errBars>
          <c:cat>
            <c:strRef>
              <c:f>Sheet3!$Q$51:$Q$59</c:f>
              <c:strCache>
                <c:ptCount val="9"/>
                <c:pt idx="0">
                  <c:v>C16:0-d18:1</c:v>
                </c:pt>
                <c:pt idx="1">
                  <c:v>C18:0-d18:1</c:v>
                </c:pt>
                <c:pt idx="2">
                  <c:v>C19:0-d18:1</c:v>
                </c:pt>
                <c:pt idx="3">
                  <c:v>C20:5-d18:1</c:v>
                </c:pt>
                <c:pt idx="4">
                  <c:v>C20:0-d18:1</c:v>
                </c:pt>
                <c:pt idx="5">
                  <c:v>C22:0-d18:2</c:v>
                </c:pt>
                <c:pt idx="6">
                  <c:v>C22:0-d18:1</c:v>
                </c:pt>
                <c:pt idx="7">
                  <c:v>C24:1-d18:1</c:v>
                </c:pt>
                <c:pt idx="8">
                  <c:v>C24:0-d18:1</c:v>
                </c:pt>
              </c:strCache>
            </c:strRef>
          </c:cat>
          <c:val>
            <c:numRef>
              <c:f>Sheet3!$T$51:$T$59</c:f>
              <c:numCache>
                <c:formatCode>General</c:formatCode>
                <c:ptCount val="9"/>
                <c:pt idx="0">
                  <c:v>4.4329904343007822</c:v>
                </c:pt>
                <c:pt idx="1">
                  <c:v>54.310999572029566</c:v>
                </c:pt>
                <c:pt idx="2">
                  <c:v>2.263153743772417</c:v>
                </c:pt>
                <c:pt idx="3">
                  <c:v>3.4841024225508113</c:v>
                </c:pt>
                <c:pt idx="4">
                  <c:v>1.6218484423175972</c:v>
                </c:pt>
                <c:pt idx="5">
                  <c:v>1.2585555604257133</c:v>
                </c:pt>
                <c:pt idx="6">
                  <c:v>6.6864765514191955</c:v>
                </c:pt>
                <c:pt idx="7">
                  <c:v>12.820674512578318</c:v>
                </c:pt>
                <c:pt idx="8">
                  <c:v>6.768158494263972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A8EE-4DC4-86B2-F8AC84FF7B1E}"/>
            </c:ext>
          </c:extLst>
        </c:ser>
        <c:ser>
          <c:idx val="3"/>
          <c:order val="3"/>
          <c:tx>
            <c:strRef>
              <c:f>Sheet3!$U$50</c:f>
              <c:strCache>
                <c:ptCount val="1"/>
              </c:strCache>
            </c:strRef>
          </c:tx>
          <c:spPr>
            <a:pattFill prst="dkDnDiag">
              <a:fgClr>
                <a:schemeClr val="tx1"/>
              </a:fgClr>
              <a:bgClr>
                <a:schemeClr val="bg1"/>
              </a:bgClr>
            </a:pattFill>
            <a:ln w="19050"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Sheet3!$U$62:$U$70</c:f>
                <c:numCache>
                  <c:formatCode>General</c:formatCode>
                  <c:ptCount val="9"/>
                  <c:pt idx="0">
                    <c:v>1.9551616717171052</c:v>
                  </c:pt>
                  <c:pt idx="1">
                    <c:v>19.65396827420134</c:v>
                  </c:pt>
                  <c:pt idx="2">
                    <c:v>0.95946635799394953</c:v>
                  </c:pt>
                  <c:pt idx="3">
                    <c:v>0.86948461717704972</c:v>
                  </c:pt>
                  <c:pt idx="4">
                    <c:v>0.53672579343888271</c:v>
                  </c:pt>
                  <c:pt idx="5">
                    <c:v>0.21850170176216505</c:v>
                  </c:pt>
                  <c:pt idx="6">
                    <c:v>2.3527725860856079</c:v>
                  </c:pt>
                  <c:pt idx="7">
                    <c:v>5.2323095246265492</c:v>
                  </c:pt>
                  <c:pt idx="8">
                    <c:v>3.171003757188592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19050">
                <a:solidFill>
                  <a:schemeClr val="tx1"/>
                </a:solidFill>
              </a:ln>
            </c:spPr>
          </c:errBars>
          <c:cat>
            <c:strRef>
              <c:f>Sheet3!$Q$51:$Q$59</c:f>
              <c:strCache>
                <c:ptCount val="9"/>
                <c:pt idx="0">
                  <c:v>C16:0-d18:1</c:v>
                </c:pt>
                <c:pt idx="1">
                  <c:v>C18:0-d18:1</c:v>
                </c:pt>
                <c:pt idx="2">
                  <c:v>C19:0-d18:1</c:v>
                </c:pt>
                <c:pt idx="3">
                  <c:v>C20:5-d18:1</c:v>
                </c:pt>
                <c:pt idx="4">
                  <c:v>C20:0-d18:1</c:v>
                </c:pt>
                <c:pt idx="5">
                  <c:v>C22:0-d18:2</c:v>
                </c:pt>
                <c:pt idx="6">
                  <c:v>C22:0-d18:1</c:v>
                </c:pt>
                <c:pt idx="7">
                  <c:v>C24:1-d18:1</c:v>
                </c:pt>
                <c:pt idx="8">
                  <c:v>C24:0-d18:1</c:v>
                </c:pt>
              </c:strCache>
            </c:strRef>
          </c:cat>
          <c:val>
            <c:numRef>
              <c:f>Sheet3!$U$51:$U$59</c:f>
              <c:numCache>
                <c:formatCode>General</c:formatCode>
                <c:ptCount val="9"/>
                <c:pt idx="0">
                  <c:v>5.1628503289206753</c:v>
                </c:pt>
                <c:pt idx="1">
                  <c:v>59.771186826097406</c:v>
                </c:pt>
                <c:pt idx="2">
                  <c:v>2.4190621696835777</c:v>
                </c:pt>
                <c:pt idx="3">
                  <c:v>3.3394933191012228</c:v>
                </c:pt>
                <c:pt idx="4">
                  <c:v>1.6753187727318244</c:v>
                </c:pt>
                <c:pt idx="5">
                  <c:v>1.374994504889717</c:v>
                </c:pt>
                <c:pt idx="6">
                  <c:v>6.7821172532324514</c:v>
                </c:pt>
                <c:pt idx="7">
                  <c:v>12.429559580133391</c:v>
                </c:pt>
                <c:pt idx="8">
                  <c:v>6.982822113305314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A8EE-4DC4-86B2-F8AC84FF7B1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91379968"/>
        <c:axId val="391385856"/>
      </c:barChart>
      <c:catAx>
        <c:axId val="39137996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</c:spPr>
        <c:txPr>
          <a:bodyPr/>
          <a:lstStyle/>
          <a:p>
            <a:pPr>
              <a:defRPr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ja-JP"/>
          </a:p>
        </c:txPr>
        <c:crossAx val="391385856"/>
        <c:crosses val="autoZero"/>
        <c:auto val="1"/>
        <c:lblAlgn val="ctr"/>
        <c:lblOffset val="100"/>
        <c:noMultiLvlLbl val="0"/>
      </c:catAx>
      <c:valAx>
        <c:axId val="391385856"/>
        <c:scaling>
          <c:orientation val="minMax"/>
        </c:scaling>
        <c:delete val="0"/>
        <c:axPos val="l"/>
        <c:majorGridlines>
          <c:spPr>
            <a:ln>
              <a:noFill/>
            </a:ln>
          </c:spPr>
        </c:majorGridlines>
        <c:numFmt formatCode="General" sourceLinked="1"/>
        <c:majorTickMark val="out"/>
        <c:minorTickMark val="none"/>
        <c:tickLblPos val="nextTo"/>
        <c:spPr>
          <a:ln w="19050">
            <a:solidFill>
              <a:schemeClr val="tx1"/>
            </a:solidFill>
          </a:ln>
        </c:spPr>
        <c:txPr>
          <a:bodyPr/>
          <a:lstStyle/>
          <a:p>
            <a:pPr>
              <a:defRPr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ja-JP"/>
          </a:p>
        </c:txPr>
        <c:crossAx val="391379968"/>
        <c:crosses val="autoZero"/>
        <c:crossBetween val="between"/>
      </c:valAx>
    </c:plotArea>
    <c:plotVisOnly val="1"/>
    <c:dispBlanksAs val="gap"/>
    <c:showDLblsOverMax val="0"/>
  </c:chart>
  <c:externalData r:id="rId2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</c:strCache>
            </c:strRef>
          </c:tx>
          <c:spPr>
            <a:solidFill>
              <a:schemeClr val="accent1"/>
            </a:solidFill>
            <a:ln w="19050"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28F9-4089-A4E9-825A4FD4D120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28F9-4089-A4E9-825A4FD4D120}"/>
              </c:ext>
            </c:extLst>
          </c:dPt>
          <c:dPt>
            <c:idx val="2"/>
            <c:invertIfNegative val="0"/>
            <c:bubble3D val="0"/>
            <c:spPr>
              <a:solidFill>
                <a:schemeClr val="bg1">
                  <a:lumMod val="50000"/>
                </a:schemeClr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28F9-4089-A4E9-825A4FD4D120}"/>
              </c:ext>
            </c:extLst>
          </c:dPt>
          <c:dPt>
            <c:idx val="3"/>
            <c:invertIfNegative val="0"/>
            <c:bubble3D val="0"/>
            <c:spPr>
              <a:pattFill prst="wdDnDiag">
                <a:fgClr>
                  <a:schemeClr val="tx1"/>
                </a:fgClr>
                <a:bgClr>
                  <a:schemeClr val="bg1"/>
                </a:bgClr>
              </a:patt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28F9-4089-A4E9-825A4FD4D120}"/>
              </c:ext>
            </c:extLst>
          </c:dPt>
          <c:errBars>
            <c:errBarType val="plus"/>
            <c:errValType val="cust"/>
            <c:noEndCap val="0"/>
            <c:plus>
              <c:numRef>
                <c:f>Sheet1!$C$2:$C$5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.3</c:v>
                  </c:pt>
                  <c:pt idx="2">
                    <c:v>0.35</c:v>
                  </c:pt>
                  <c:pt idx="3">
                    <c:v>0.2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Sheet1!$A$2:$A$5</c:f>
              <c:numCache>
                <c:formatCode>General</c:formatCode>
                <c:ptCount val="4"/>
              </c:numCache>
            </c:numRef>
          </c:cat>
          <c:val>
            <c:numRef>
              <c:f>Sheet1!$B$2:$B$5</c:f>
              <c:numCache>
                <c:formatCode>General</c:formatCode>
                <c:ptCount val="4"/>
                <c:pt idx="0">
                  <c:v>1</c:v>
                </c:pt>
                <c:pt idx="1">
                  <c:v>1.03</c:v>
                </c:pt>
                <c:pt idx="2">
                  <c:v>0.85</c:v>
                </c:pt>
                <c:pt idx="3">
                  <c:v>1.1399999999999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28F9-4089-A4E9-825A4FD4D12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711897968"/>
        <c:axId val="711898384"/>
      </c:barChart>
      <c:catAx>
        <c:axId val="71189796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711898384"/>
        <c:crosses val="autoZero"/>
        <c:auto val="1"/>
        <c:lblAlgn val="ctr"/>
        <c:lblOffset val="100"/>
        <c:noMultiLvlLbl val="0"/>
      </c:catAx>
      <c:valAx>
        <c:axId val="711898384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71189796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G$3</c:f>
              <c:strCache>
                <c:ptCount val="1"/>
              </c:strCache>
            </c:strRef>
          </c:tx>
          <c:spPr>
            <a:solidFill>
              <a:schemeClr val="accent1"/>
            </a:solidFill>
            <a:ln w="19050">
              <a:solidFill>
                <a:schemeClr val="tx1">
                  <a:lumMod val="65000"/>
                  <a:lumOff val="35000"/>
                </a:schemeClr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 w="19050">
                <a:solidFill>
                  <a:schemeClr val="tx1">
                    <a:lumMod val="65000"/>
                    <a:lumOff val="35000"/>
                  </a:schemeClr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B1D8-4C5B-BCC5-C9891E60628E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 w="19050">
                <a:solidFill>
                  <a:schemeClr val="tx1">
                    <a:lumMod val="65000"/>
                    <a:lumOff val="35000"/>
                  </a:schemeClr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B1D8-4C5B-BCC5-C9891E60628E}"/>
              </c:ext>
            </c:extLst>
          </c:dPt>
          <c:dPt>
            <c:idx val="2"/>
            <c:invertIfNegative val="0"/>
            <c:bubble3D val="0"/>
            <c:spPr>
              <a:solidFill>
                <a:schemeClr val="bg1">
                  <a:lumMod val="50000"/>
                </a:schemeClr>
              </a:solidFill>
              <a:ln w="19050">
                <a:solidFill>
                  <a:schemeClr val="tx1">
                    <a:lumMod val="65000"/>
                    <a:lumOff val="35000"/>
                  </a:schemeClr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B1D8-4C5B-BCC5-C9891E60628E}"/>
              </c:ext>
            </c:extLst>
          </c:dPt>
          <c:dPt>
            <c:idx val="3"/>
            <c:invertIfNegative val="0"/>
            <c:bubble3D val="0"/>
            <c:spPr>
              <a:pattFill prst="wdDnDiag">
                <a:fgClr>
                  <a:schemeClr val="tx1"/>
                </a:fgClr>
                <a:bgClr>
                  <a:schemeClr val="bg1"/>
                </a:bgClr>
              </a:pattFill>
              <a:ln w="19050">
                <a:solidFill>
                  <a:schemeClr val="tx1">
                    <a:lumMod val="65000"/>
                    <a:lumOff val="35000"/>
                  </a:schemeClr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B1D8-4C5B-BCC5-C9891E60628E}"/>
              </c:ext>
            </c:extLst>
          </c:dPt>
          <c:errBars>
            <c:errBarType val="plus"/>
            <c:errValType val="cust"/>
            <c:noEndCap val="0"/>
            <c:plus>
              <c:numRef>
                <c:f>Sheet1!$H$4:$H$7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.3</c:v>
                  </c:pt>
                  <c:pt idx="2">
                    <c:v>0.4</c:v>
                  </c:pt>
                  <c:pt idx="3">
                    <c:v>0.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9050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heet1!$F$4:$F$7</c:f>
              <c:numCache>
                <c:formatCode>General</c:formatCode>
                <c:ptCount val="4"/>
              </c:numCache>
            </c:numRef>
          </c:cat>
          <c:val>
            <c:numRef>
              <c:f>Sheet1!$G$4:$G$7</c:f>
              <c:numCache>
                <c:formatCode>General</c:formatCode>
                <c:ptCount val="4"/>
                <c:pt idx="0">
                  <c:v>1</c:v>
                </c:pt>
                <c:pt idx="1">
                  <c:v>1.1000000000000001</c:v>
                </c:pt>
                <c:pt idx="2">
                  <c:v>1.2</c:v>
                </c:pt>
                <c:pt idx="3">
                  <c:v>1.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B1D8-4C5B-BCC5-C9891E60628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20092928"/>
        <c:axId val="320093256"/>
      </c:barChart>
      <c:catAx>
        <c:axId val="32009292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320093256"/>
        <c:crosses val="autoZero"/>
        <c:auto val="1"/>
        <c:lblAlgn val="ctr"/>
        <c:lblOffset val="100"/>
        <c:noMultiLvlLbl val="0"/>
      </c:catAx>
      <c:valAx>
        <c:axId val="320093256"/>
        <c:scaling>
          <c:orientation val="minMax"/>
          <c:min val="0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>
                <a:lumMod val="65000"/>
                <a:lumOff val="35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32009292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0DA9E13-F21F-20FF-5EA2-C59AEC1367E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80E92A6C-D8C7-3859-FAAD-365A0CABEA2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67B5829-01B4-22E6-CA6B-9888F9B0A7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561558-99D9-46D7-A73A-D3087779D7B9}" type="datetimeFigureOut">
              <a:rPr kumimoji="1" lang="ja-JP" altLang="en-US" smtClean="0"/>
              <a:t>2023/3/3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70E221C-72F2-564F-C266-3738463A0E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DC42D02-FF11-C879-1DC1-021193E041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7A5EBB-CF50-479C-9C1B-9F52C3A78F9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237277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E83DD38-744D-FE06-D9AD-8CE6B41B465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C766C12F-441B-0EFC-5736-3B12C617F6A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15FF01F-982D-4E4D-7A4B-ADFA83A50D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561558-99D9-46D7-A73A-D3087779D7B9}" type="datetimeFigureOut">
              <a:rPr kumimoji="1" lang="ja-JP" altLang="en-US" smtClean="0"/>
              <a:t>2023/3/3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E60B7FF-4FC8-2B9A-2A9E-B7C582D5F8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947C6E5-5EA9-F8EE-8524-0C76565E76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7A5EBB-CF50-479C-9C1B-9F52C3A78F9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807089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185FCDFC-6A43-5916-C098-B2D7AABFB89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E663EC98-F1C3-923B-7B69-9141F66DFC4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F281DF0-D6A3-40B4-CC94-97DD0330A4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561558-99D9-46D7-A73A-D3087779D7B9}" type="datetimeFigureOut">
              <a:rPr kumimoji="1" lang="ja-JP" altLang="en-US" smtClean="0"/>
              <a:t>2023/3/3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B0014FA-2980-AD1B-E090-7C43BD5753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6EC065A-2EB8-A941-D8AC-793F276BC8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7A5EBB-CF50-479C-9C1B-9F52C3A78F9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15739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BE0A54B-9325-BF11-2332-4B7F7DAF3BF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A9B3DCE8-80AE-827E-1C02-D1F4F40B324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94361AF-5B4B-6151-FCF4-5D45FC9C6A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561558-99D9-46D7-A73A-D3087779D7B9}" type="datetimeFigureOut">
              <a:rPr kumimoji="1" lang="ja-JP" altLang="en-US" smtClean="0"/>
              <a:t>2023/3/3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678773E-6DC0-38E9-91CC-1F1CFE257A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5770303-9853-8D2B-2A3F-B28C313B83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7A5EBB-CF50-479C-9C1B-9F52C3A78F9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784615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F514AE5-6448-7BE6-DA66-8319858E44F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6BF3570C-A159-9631-CA3E-733C686C87C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8B2803A-66C7-28C1-50EE-70F85067B1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561558-99D9-46D7-A73A-D3087779D7B9}" type="datetimeFigureOut">
              <a:rPr kumimoji="1" lang="ja-JP" altLang="en-US" smtClean="0"/>
              <a:t>2023/3/3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480D1AF-9C5E-4FF2-2848-56C0E590DD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682196D-039E-D75B-96EF-B667FB4F04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7A5EBB-CF50-479C-9C1B-9F52C3A78F9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26394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9729F95-26DF-D020-9128-3E189D7069F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B69ECE53-D981-FE36-EF31-5EFC559B201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4E0C4C95-0D77-8EB5-617A-2B19AF1C320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77C3F190-F9C7-10DE-8607-AA7CCE5A0C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561558-99D9-46D7-A73A-D3087779D7B9}" type="datetimeFigureOut">
              <a:rPr kumimoji="1" lang="ja-JP" altLang="en-US" smtClean="0"/>
              <a:t>2023/3/3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F9B750D8-5327-A7AC-A37E-0F62415295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D41DA883-33A8-523E-2A16-EFBA183001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7A5EBB-CF50-479C-9C1B-9F52C3A78F9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08709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4B5203B-2DA6-05BA-69A5-41CDFC085E1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2BA81C16-DC53-C792-230B-C8AA8CF7444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6DAED146-9E49-39BA-ED8E-099D08B06CD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08485202-2A5C-92D3-7373-7F31E5AAD83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C90BD844-F331-1BA5-6CA3-D008B363DAC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08F27B7B-A0E9-EFFC-F419-FEAF8C198C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561558-99D9-46D7-A73A-D3087779D7B9}" type="datetimeFigureOut">
              <a:rPr kumimoji="1" lang="ja-JP" altLang="en-US" smtClean="0"/>
              <a:t>2023/3/31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C17D4E3E-D730-1784-3562-14E1F384DC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2F207061-3FC3-8508-DD9D-67B92AD1D7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7A5EBB-CF50-479C-9C1B-9F52C3A78F9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843092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BBC0F2C-4327-4F8C-4F8B-DA046EA2F0A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82643A8C-8A60-0091-6D36-517CF88E4F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561558-99D9-46D7-A73A-D3087779D7B9}" type="datetimeFigureOut">
              <a:rPr kumimoji="1" lang="ja-JP" altLang="en-US" smtClean="0"/>
              <a:t>2023/3/31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B9AD27C9-EC6A-C32C-CD1C-4CD3E6B71E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7FE61FA3-0DCE-9711-8F48-57659A1504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7A5EBB-CF50-479C-9C1B-9F52C3A78F9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544195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3AF22506-3006-1BE3-B33C-9D5A3A2BB3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561558-99D9-46D7-A73A-D3087779D7B9}" type="datetimeFigureOut">
              <a:rPr kumimoji="1" lang="ja-JP" altLang="en-US" smtClean="0"/>
              <a:t>2023/3/31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19F79AAE-88F6-FBF2-7D4C-3AF996BB45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2C1A7002-F7F6-A605-3A97-B58EC9D2F9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7A5EBB-CF50-479C-9C1B-9F52C3A78F9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124661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F03A538-74C2-EFD6-1E70-41CB3FD63A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B43F0D9C-43D0-202D-B7A9-472824A9DCE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4C4A2DBE-4B57-3BA6-9CD6-3EE204068DA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06D7EBFA-DA55-B055-FAB9-C5A009E15F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561558-99D9-46D7-A73A-D3087779D7B9}" type="datetimeFigureOut">
              <a:rPr kumimoji="1" lang="ja-JP" altLang="en-US" smtClean="0"/>
              <a:t>2023/3/3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B7AB1634-574C-1EC9-B6ED-955EE300BF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6E0DA11E-17D5-1096-D384-59BD946019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7A5EBB-CF50-479C-9C1B-9F52C3A78F9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184350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08C1547-A9A7-50E6-E865-3EC789AFB0A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3F48A3F8-1B4C-526E-468C-515A2A86184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39B7C922-CB99-FC2D-88EA-6A734D0BAEC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2AB65F0A-A598-18A8-9FC6-EB034FCA97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561558-99D9-46D7-A73A-D3087779D7B9}" type="datetimeFigureOut">
              <a:rPr kumimoji="1" lang="ja-JP" altLang="en-US" smtClean="0"/>
              <a:t>2023/3/3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C2354EB1-A689-CB3D-8192-F88EE81802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C53EB17E-5EA8-AF47-9482-F9EDD26265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7A5EBB-CF50-479C-9C1B-9F52C3A78F9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219306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14F48C8C-E2C3-AFA8-8B04-2EA0A1AA646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ADD48C55-098B-2639-FC83-3860EBA5215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EDC8990-F3A3-B44E-8E57-7C35A0D12A4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561558-99D9-46D7-A73A-D3087779D7B9}" type="datetimeFigureOut">
              <a:rPr kumimoji="1" lang="ja-JP" altLang="en-US" smtClean="0"/>
              <a:t>2023/3/3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83B6381-D3C9-FB43-FB55-9E17C9D78A5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B4D0AE0-8157-851B-89B1-1F4A143242C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7A5EBB-CF50-479C-9C1B-9F52C3A78F9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36099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6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6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3.xml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6.xml"/><Relationship Id="rId4" Type="http://schemas.openxmlformats.org/officeDocument/2006/relationships/chart" Target="../charts/chart4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グラフ 2">
            <a:extLst>
              <a:ext uri="{FF2B5EF4-FFF2-40B4-BE49-F238E27FC236}">
                <a16:creationId xmlns:a16="http://schemas.microsoft.com/office/drawing/2014/main" id="{7AA20CEC-0F0B-4F22-9EC2-833D1E44E4F4}"/>
              </a:ext>
            </a:extLst>
          </p:cNvPr>
          <p:cNvGraphicFramePr>
            <a:graphicFrameLocks/>
          </p:cNvGraphicFramePr>
          <p:nvPr/>
        </p:nvGraphicFramePr>
        <p:xfrm>
          <a:off x="1703512" y="692696"/>
          <a:ext cx="8712968" cy="583882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49155" name="テキスト ボックス 3">
            <a:extLst>
              <a:ext uri="{FF2B5EF4-FFF2-40B4-BE49-F238E27FC236}">
                <a16:creationId xmlns:a16="http://schemas.microsoft.com/office/drawing/2014/main" id="{B422B8A5-148C-4249-BB9D-831540EF960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735639" y="2852739"/>
            <a:ext cx="274637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lr>
                <a:srgbClr val="0BD0D9"/>
              </a:buClr>
              <a:buSzPct val="95000"/>
              <a:buFont typeface="Wingdings 2" panose="05020102010507070707" pitchFamily="18" charset="2"/>
              <a:buChar char=""/>
              <a:defRPr kumimoji="1" sz="2600">
                <a:solidFill>
                  <a:schemeClr val="tx1"/>
                </a:solidFill>
                <a:latin typeface="Constantia" panose="02030602050306030303" pitchFamily="18" charset="0"/>
                <a:ea typeface="HGP明朝E" panose="02020900000000000000" pitchFamily="18" charset="-128"/>
              </a:defRPr>
            </a:lvl1pPr>
            <a:lvl2pPr marL="742950" indent="-285750" eaLnBrk="0" hangingPunct="0">
              <a:spcBef>
                <a:spcPct val="20000"/>
              </a:spcBef>
              <a:buClr>
                <a:schemeClr val="accent1"/>
              </a:buClr>
              <a:buSzPct val="85000"/>
              <a:buFont typeface="Wingdings 2" panose="05020102010507070707" pitchFamily="18" charset="2"/>
              <a:buChar char=""/>
              <a:defRPr kumimoji="1" sz="2400">
                <a:solidFill>
                  <a:schemeClr val="tx1"/>
                </a:solidFill>
                <a:latin typeface="Constantia" panose="02030602050306030303" pitchFamily="18" charset="0"/>
                <a:ea typeface="HGP明朝E" panose="02020900000000000000" pitchFamily="18" charset="-128"/>
              </a:defRPr>
            </a:lvl2pPr>
            <a:lvl3pPr marL="1143000" indent="-228600" eaLnBrk="0" hangingPunct="0">
              <a:spcBef>
                <a:spcPct val="20000"/>
              </a:spcBef>
              <a:buClr>
                <a:schemeClr val="accent2"/>
              </a:buClr>
              <a:buSzPct val="70000"/>
              <a:buFont typeface="Wingdings 2" panose="05020102010507070707" pitchFamily="18" charset="2"/>
              <a:buChar char=""/>
              <a:defRPr kumimoji="1" sz="2100">
                <a:solidFill>
                  <a:schemeClr val="tx1"/>
                </a:solidFill>
                <a:latin typeface="Constantia" panose="02030602050306030303" pitchFamily="18" charset="0"/>
                <a:ea typeface="HGP明朝E" panose="02020900000000000000" pitchFamily="18" charset="-128"/>
              </a:defRPr>
            </a:lvl3pPr>
            <a:lvl4pPr marL="1600200" indent="-228600" eaLnBrk="0" hangingPunct="0">
              <a:spcBef>
                <a:spcPct val="20000"/>
              </a:spcBef>
              <a:buClr>
                <a:srgbClr val="0BD0D9"/>
              </a:buClr>
              <a:buSzPct val="65000"/>
              <a:buFont typeface="Wingdings 2" panose="05020102010507070707" pitchFamily="18" charset="2"/>
              <a:buChar char=""/>
              <a:defRPr kumimoji="1" sz="2000">
                <a:solidFill>
                  <a:schemeClr val="tx1"/>
                </a:solidFill>
                <a:latin typeface="Constantia" panose="02030602050306030303" pitchFamily="18" charset="0"/>
                <a:ea typeface="HGP明朝E" panose="02020900000000000000" pitchFamily="18" charset="-128"/>
              </a:defRPr>
            </a:lvl4pPr>
            <a:lvl5pPr marL="2057400" indent="-228600" eaLnBrk="0" hangingPunct="0">
              <a:spcBef>
                <a:spcPct val="20000"/>
              </a:spcBef>
              <a:buClr>
                <a:srgbClr val="10CF9B"/>
              </a:buClr>
              <a:buSzPct val="65000"/>
              <a:buFont typeface="Wingdings 2" panose="05020102010507070707" pitchFamily="18" charset="2"/>
              <a:buChar char=""/>
              <a:defRPr kumimoji="1" sz="2000">
                <a:solidFill>
                  <a:schemeClr val="tx1"/>
                </a:solidFill>
                <a:latin typeface="Constantia" panose="02030602050306030303" pitchFamily="18" charset="0"/>
                <a:ea typeface="HGP明朝E" panose="02020900000000000000" pitchFamily="18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10CF9B"/>
              </a:buClr>
              <a:buSzPct val="65000"/>
              <a:buFont typeface="Wingdings 2" panose="05020102010507070707" pitchFamily="18" charset="2"/>
              <a:buChar char=""/>
              <a:defRPr kumimoji="1" sz="2000">
                <a:solidFill>
                  <a:schemeClr val="tx1"/>
                </a:solidFill>
                <a:latin typeface="Constantia" panose="02030602050306030303" pitchFamily="18" charset="0"/>
                <a:ea typeface="HGP明朝E" panose="02020900000000000000" pitchFamily="18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10CF9B"/>
              </a:buClr>
              <a:buSzPct val="65000"/>
              <a:buFont typeface="Wingdings 2" panose="05020102010507070707" pitchFamily="18" charset="2"/>
              <a:buChar char=""/>
              <a:defRPr kumimoji="1" sz="2000">
                <a:solidFill>
                  <a:schemeClr val="tx1"/>
                </a:solidFill>
                <a:latin typeface="Constantia" panose="02030602050306030303" pitchFamily="18" charset="0"/>
                <a:ea typeface="HGP明朝E" panose="02020900000000000000" pitchFamily="18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10CF9B"/>
              </a:buClr>
              <a:buSzPct val="65000"/>
              <a:buFont typeface="Wingdings 2" panose="05020102010507070707" pitchFamily="18" charset="2"/>
              <a:buChar char=""/>
              <a:defRPr kumimoji="1" sz="2000">
                <a:solidFill>
                  <a:schemeClr val="tx1"/>
                </a:solidFill>
                <a:latin typeface="Constantia" panose="02030602050306030303" pitchFamily="18" charset="0"/>
                <a:ea typeface="HGP明朝E" panose="02020900000000000000" pitchFamily="18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10CF9B"/>
              </a:buClr>
              <a:buSzPct val="65000"/>
              <a:buFont typeface="Wingdings 2" panose="05020102010507070707" pitchFamily="18" charset="2"/>
              <a:buChar char=""/>
              <a:defRPr kumimoji="1" sz="2000">
                <a:solidFill>
                  <a:schemeClr val="tx1"/>
                </a:solidFill>
                <a:latin typeface="Constantia" panose="02030602050306030303" pitchFamily="18" charset="0"/>
                <a:ea typeface="HGP明朝E" panose="02020900000000000000" pitchFamily="18" charset="-128"/>
              </a:defRPr>
            </a:lvl9pPr>
          </a:lstStyle>
          <a:p>
            <a:pPr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US" altLang="ja-JP" sz="1800"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*</a:t>
            </a:r>
            <a:endParaRPr lang="ja-JP" altLang="en-US" sz="1800"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49156" name="テキスト ボックス 4">
            <a:extLst>
              <a:ext uri="{FF2B5EF4-FFF2-40B4-BE49-F238E27FC236}">
                <a16:creationId xmlns:a16="http://schemas.microsoft.com/office/drawing/2014/main" id="{DA47EF68-1D15-47F8-A160-0CF34768E12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559425" y="2714625"/>
            <a:ext cx="273050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lr>
                <a:srgbClr val="0BD0D9"/>
              </a:buClr>
              <a:buSzPct val="95000"/>
              <a:buFont typeface="Wingdings 2" panose="05020102010507070707" pitchFamily="18" charset="2"/>
              <a:buChar char=""/>
              <a:defRPr kumimoji="1" sz="2600">
                <a:solidFill>
                  <a:schemeClr val="tx1"/>
                </a:solidFill>
                <a:latin typeface="Constantia" panose="02030602050306030303" pitchFamily="18" charset="0"/>
                <a:ea typeface="HGP明朝E" panose="02020900000000000000" pitchFamily="18" charset="-128"/>
              </a:defRPr>
            </a:lvl1pPr>
            <a:lvl2pPr marL="742950" indent="-285750" eaLnBrk="0" hangingPunct="0">
              <a:spcBef>
                <a:spcPct val="20000"/>
              </a:spcBef>
              <a:buClr>
                <a:schemeClr val="accent1"/>
              </a:buClr>
              <a:buSzPct val="85000"/>
              <a:buFont typeface="Wingdings 2" panose="05020102010507070707" pitchFamily="18" charset="2"/>
              <a:buChar char=""/>
              <a:defRPr kumimoji="1" sz="2400">
                <a:solidFill>
                  <a:schemeClr val="tx1"/>
                </a:solidFill>
                <a:latin typeface="Constantia" panose="02030602050306030303" pitchFamily="18" charset="0"/>
                <a:ea typeface="HGP明朝E" panose="02020900000000000000" pitchFamily="18" charset="-128"/>
              </a:defRPr>
            </a:lvl2pPr>
            <a:lvl3pPr marL="1143000" indent="-228600" eaLnBrk="0" hangingPunct="0">
              <a:spcBef>
                <a:spcPct val="20000"/>
              </a:spcBef>
              <a:buClr>
                <a:schemeClr val="accent2"/>
              </a:buClr>
              <a:buSzPct val="70000"/>
              <a:buFont typeface="Wingdings 2" panose="05020102010507070707" pitchFamily="18" charset="2"/>
              <a:buChar char=""/>
              <a:defRPr kumimoji="1" sz="2100">
                <a:solidFill>
                  <a:schemeClr val="tx1"/>
                </a:solidFill>
                <a:latin typeface="Constantia" panose="02030602050306030303" pitchFamily="18" charset="0"/>
                <a:ea typeface="HGP明朝E" panose="02020900000000000000" pitchFamily="18" charset="-128"/>
              </a:defRPr>
            </a:lvl3pPr>
            <a:lvl4pPr marL="1600200" indent="-228600" eaLnBrk="0" hangingPunct="0">
              <a:spcBef>
                <a:spcPct val="20000"/>
              </a:spcBef>
              <a:buClr>
                <a:srgbClr val="0BD0D9"/>
              </a:buClr>
              <a:buSzPct val="65000"/>
              <a:buFont typeface="Wingdings 2" panose="05020102010507070707" pitchFamily="18" charset="2"/>
              <a:buChar char=""/>
              <a:defRPr kumimoji="1" sz="2000">
                <a:solidFill>
                  <a:schemeClr val="tx1"/>
                </a:solidFill>
                <a:latin typeface="Constantia" panose="02030602050306030303" pitchFamily="18" charset="0"/>
                <a:ea typeface="HGP明朝E" panose="02020900000000000000" pitchFamily="18" charset="-128"/>
              </a:defRPr>
            </a:lvl4pPr>
            <a:lvl5pPr marL="2057400" indent="-228600" eaLnBrk="0" hangingPunct="0">
              <a:spcBef>
                <a:spcPct val="20000"/>
              </a:spcBef>
              <a:buClr>
                <a:srgbClr val="10CF9B"/>
              </a:buClr>
              <a:buSzPct val="65000"/>
              <a:buFont typeface="Wingdings 2" panose="05020102010507070707" pitchFamily="18" charset="2"/>
              <a:buChar char=""/>
              <a:defRPr kumimoji="1" sz="2000">
                <a:solidFill>
                  <a:schemeClr val="tx1"/>
                </a:solidFill>
                <a:latin typeface="Constantia" panose="02030602050306030303" pitchFamily="18" charset="0"/>
                <a:ea typeface="HGP明朝E" panose="02020900000000000000" pitchFamily="18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10CF9B"/>
              </a:buClr>
              <a:buSzPct val="65000"/>
              <a:buFont typeface="Wingdings 2" panose="05020102010507070707" pitchFamily="18" charset="2"/>
              <a:buChar char=""/>
              <a:defRPr kumimoji="1" sz="2000">
                <a:solidFill>
                  <a:schemeClr val="tx1"/>
                </a:solidFill>
                <a:latin typeface="Constantia" panose="02030602050306030303" pitchFamily="18" charset="0"/>
                <a:ea typeface="HGP明朝E" panose="02020900000000000000" pitchFamily="18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10CF9B"/>
              </a:buClr>
              <a:buSzPct val="65000"/>
              <a:buFont typeface="Wingdings 2" panose="05020102010507070707" pitchFamily="18" charset="2"/>
              <a:buChar char=""/>
              <a:defRPr kumimoji="1" sz="2000">
                <a:solidFill>
                  <a:schemeClr val="tx1"/>
                </a:solidFill>
                <a:latin typeface="Constantia" panose="02030602050306030303" pitchFamily="18" charset="0"/>
                <a:ea typeface="HGP明朝E" panose="02020900000000000000" pitchFamily="18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10CF9B"/>
              </a:buClr>
              <a:buSzPct val="65000"/>
              <a:buFont typeface="Wingdings 2" panose="05020102010507070707" pitchFamily="18" charset="2"/>
              <a:buChar char=""/>
              <a:defRPr kumimoji="1" sz="2000">
                <a:solidFill>
                  <a:schemeClr val="tx1"/>
                </a:solidFill>
                <a:latin typeface="Constantia" panose="02030602050306030303" pitchFamily="18" charset="0"/>
                <a:ea typeface="HGP明朝E" panose="02020900000000000000" pitchFamily="18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10CF9B"/>
              </a:buClr>
              <a:buSzPct val="65000"/>
              <a:buFont typeface="Wingdings 2" panose="05020102010507070707" pitchFamily="18" charset="2"/>
              <a:buChar char=""/>
              <a:defRPr kumimoji="1" sz="2000">
                <a:solidFill>
                  <a:schemeClr val="tx1"/>
                </a:solidFill>
                <a:latin typeface="Constantia" panose="02030602050306030303" pitchFamily="18" charset="0"/>
                <a:ea typeface="HGP明朝E" panose="02020900000000000000" pitchFamily="18" charset="-128"/>
              </a:defRPr>
            </a:lvl9pPr>
          </a:lstStyle>
          <a:p>
            <a:pPr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US" altLang="ja-JP" sz="1800"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*</a:t>
            </a:r>
            <a:endParaRPr lang="ja-JP" altLang="en-US" sz="1800"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49158" name="テキスト ボックス 15">
            <a:extLst>
              <a:ext uri="{FF2B5EF4-FFF2-40B4-BE49-F238E27FC236}">
                <a16:creationId xmlns:a16="http://schemas.microsoft.com/office/drawing/2014/main" id="{A44D401B-C57A-40AE-B56B-881DDF3A2D4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524000" y="188914"/>
            <a:ext cx="9144000" cy="523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lr>
                <a:srgbClr val="0BD0D9"/>
              </a:buClr>
              <a:buSzPct val="95000"/>
              <a:buFont typeface="Wingdings 2" panose="05020102010507070707" pitchFamily="18" charset="2"/>
              <a:buChar char=""/>
              <a:defRPr kumimoji="1" sz="2600">
                <a:solidFill>
                  <a:schemeClr val="tx1"/>
                </a:solidFill>
                <a:latin typeface="Constantia" panose="02030602050306030303" pitchFamily="18" charset="0"/>
                <a:ea typeface="HGP明朝E" panose="02020900000000000000" pitchFamily="18" charset="-128"/>
              </a:defRPr>
            </a:lvl1pPr>
            <a:lvl2pPr marL="742950" indent="-285750" eaLnBrk="0" hangingPunct="0">
              <a:spcBef>
                <a:spcPct val="20000"/>
              </a:spcBef>
              <a:buClr>
                <a:schemeClr val="accent1"/>
              </a:buClr>
              <a:buSzPct val="85000"/>
              <a:buFont typeface="Wingdings 2" panose="05020102010507070707" pitchFamily="18" charset="2"/>
              <a:buChar char=""/>
              <a:defRPr kumimoji="1" sz="2400">
                <a:solidFill>
                  <a:schemeClr val="tx1"/>
                </a:solidFill>
                <a:latin typeface="Constantia" panose="02030602050306030303" pitchFamily="18" charset="0"/>
                <a:ea typeface="HGP明朝E" panose="02020900000000000000" pitchFamily="18" charset="-128"/>
              </a:defRPr>
            </a:lvl2pPr>
            <a:lvl3pPr marL="1143000" indent="-228600" eaLnBrk="0" hangingPunct="0">
              <a:spcBef>
                <a:spcPct val="20000"/>
              </a:spcBef>
              <a:buClr>
                <a:schemeClr val="accent2"/>
              </a:buClr>
              <a:buSzPct val="70000"/>
              <a:buFont typeface="Wingdings 2" panose="05020102010507070707" pitchFamily="18" charset="2"/>
              <a:buChar char=""/>
              <a:defRPr kumimoji="1" sz="2100">
                <a:solidFill>
                  <a:schemeClr val="tx1"/>
                </a:solidFill>
                <a:latin typeface="Constantia" panose="02030602050306030303" pitchFamily="18" charset="0"/>
                <a:ea typeface="HGP明朝E" panose="02020900000000000000" pitchFamily="18" charset="-128"/>
              </a:defRPr>
            </a:lvl3pPr>
            <a:lvl4pPr marL="1600200" indent="-228600" eaLnBrk="0" hangingPunct="0">
              <a:spcBef>
                <a:spcPct val="20000"/>
              </a:spcBef>
              <a:buClr>
                <a:srgbClr val="0BD0D9"/>
              </a:buClr>
              <a:buSzPct val="65000"/>
              <a:buFont typeface="Wingdings 2" panose="05020102010507070707" pitchFamily="18" charset="2"/>
              <a:buChar char=""/>
              <a:defRPr kumimoji="1" sz="2000">
                <a:solidFill>
                  <a:schemeClr val="tx1"/>
                </a:solidFill>
                <a:latin typeface="Constantia" panose="02030602050306030303" pitchFamily="18" charset="0"/>
                <a:ea typeface="HGP明朝E" panose="02020900000000000000" pitchFamily="18" charset="-128"/>
              </a:defRPr>
            </a:lvl4pPr>
            <a:lvl5pPr marL="2057400" indent="-228600" eaLnBrk="0" hangingPunct="0">
              <a:spcBef>
                <a:spcPct val="20000"/>
              </a:spcBef>
              <a:buClr>
                <a:srgbClr val="10CF9B"/>
              </a:buClr>
              <a:buSzPct val="65000"/>
              <a:buFont typeface="Wingdings 2" panose="05020102010507070707" pitchFamily="18" charset="2"/>
              <a:buChar char=""/>
              <a:defRPr kumimoji="1" sz="2000">
                <a:solidFill>
                  <a:schemeClr val="tx1"/>
                </a:solidFill>
                <a:latin typeface="Constantia" panose="02030602050306030303" pitchFamily="18" charset="0"/>
                <a:ea typeface="HGP明朝E" panose="02020900000000000000" pitchFamily="18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10CF9B"/>
              </a:buClr>
              <a:buSzPct val="65000"/>
              <a:buFont typeface="Wingdings 2" panose="05020102010507070707" pitchFamily="18" charset="2"/>
              <a:buChar char=""/>
              <a:defRPr kumimoji="1" sz="2000">
                <a:solidFill>
                  <a:schemeClr val="tx1"/>
                </a:solidFill>
                <a:latin typeface="Constantia" panose="02030602050306030303" pitchFamily="18" charset="0"/>
                <a:ea typeface="HGP明朝E" panose="02020900000000000000" pitchFamily="18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10CF9B"/>
              </a:buClr>
              <a:buSzPct val="65000"/>
              <a:buFont typeface="Wingdings 2" panose="05020102010507070707" pitchFamily="18" charset="2"/>
              <a:buChar char=""/>
              <a:defRPr kumimoji="1" sz="2000">
                <a:solidFill>
                  <a:schemeClr val="tx1"/>
                </a:solidFill>
                <a:latin typeface="Constantia" panose="02030602050306030303" pitchFamily="18" charset="0"/>
                <a:ea typeface="HGP明朝E" panose="02020900000000000000" pitchFamily="18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10CF9B"/>
              </a:buClr>
              <a:buSzPct val="65000"/>
              <a:buFont typeface="Wingdings 2" panose="05020102010507070707" pitchFamily="18" charset="2"/>
              <a:buChar char=""/>
              <a:defRPr kumimoji="1" sz="2000">
                <a:solidFill>
                  <a:schemeClr val="tx1"/>
                </a:solidFill>
                <a:latin typeface="Constantia" panose="02030602050306030303" pitchFamily="18" charset="0"/>
                <a:ea typeface="HGP明朝E" panose="02020900000000000000" pitchFamily="18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10CF9B"/>
              </a:buClr>
              <a:buSzPct val="65000"/>
              <a:buFont typeface="Wingdings 2" panose="05020102010507070707" pitchFamily="18" charset="2"/>
              <a:buChar char=""/>
              <a:defRPr kumimoji="1" sz="2000">
                <a:solidFill>
                  <a:schemeClr val="tx1"/>
                </a:solidFill>
                <a:latin typeface="Constantia" panose="02030602050306030303" pitchFamily="18" charset="0"/>
                <a:ea typeface="HGP明朝E" panose="02020900000000000000" pitchFamily="18" charset="-128"/>
              </a:defRPr>
            </a:lvl9pPr>
          </a:lstStyle>
          <a:p>
            <a:pPr algn="ctr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US" altLang="ja-JP" sz="2800"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Intramyocellular DG</a:t>
            </a:r>
            <a:endParaRPr lang="ja-JP" altLang="en-US" sz="2800"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49159" name="テキスト ボックス 2">
            <a:extLst>
              <a:ext uri="{FF2B5EF4-FFF2-40B4-BE49-F238E27FC236}">
                <a16:creationId xmlns:a16="http://schemas.microsoft.com/office/drawing/2014/main" id="{9855DFA3-6C8B-4FC1-AFF8-D414020915F9}"/>
              </a:ext>
            </a:extLst>
          </p:cNvPr>
          <p:cNvSpPr txBox="1">
            <a:spLocks noChangeArrowheads="1"/>
          </p:cNvSpPr>
          <p:nvPr/>
        </p:nvSpPr>
        <p:spPr bwMode="auto">
          <a:xfrm rot="-5400000">
            <a:off x="1296459" y="2406122"/>
            <a:ext cx="608013" cy="261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lr>
                <a:srgbClr val="0BD0D9"/>
              </a:buClr>
              <a:buSzPct val="95000"/>
              <a:buFont typeface="Wingdings 2" panose="05020102010507070707" pitchFamily="18" charset="2"/>
              <a:buChar char=""/>
              <a:defRPr kumimoji="1" sz="2600">
                <a:solidFill>
                  <a:schemeClr val="tx1"/>
                </a:solidFill>
                <a:latin typeface="Constantia" panose="02030602050306030303" pitchFamily="18" charset="0"/>
                <a:ea typeface="HGP明朝E" panose="02020900000000000000" pitchFamily="18" charset="-128"/>
              </a:defRPr>
            </a:lvl1pPr>
            <a:lvl2pPr marL="742950" indent="-285750" eaLnBrk="0" hangingPunct="0">
              <a:spcBef>
                <a:spcPct val="20000"/>
              </a:spcBef>
              <a:buClr>
                <a:schemeClr val="accent1"/>
              </a:buClr>
              <a:buSzPct val="85000"/>
              <a:buFont typeface="Wingdings 2" panose="05020102010507070707" pitchFamily="18" charset="2"/>
              <a:buChar char=""/>
              <a:defRPr kumimoji="1" sz="2400">
                <a:solidFill>
                  <a:schemeClr val="tx1"/>
                </a:solidFill>
                <a:latin typeface="Constantia" panose="02030602050306030303" pitchFamily="18" charset="0"/>
                <a:ea typeface="HGP明朝E" panose="02020900000000000000" pitchFamily="18" charset="-128"/>
              </a:defRPr>
            </a:lvl2pPr>
            <a:lvl3pPr marL="1143000" indent="-228600" eaLnBrk="0" hangingPunct="0">
              <a:spcBef>
                <a:spcPct val="20000"/>
              </a:spcBef>
              <a:buClr>
                <a:schemeClr val="accent2"/>
              </a:buClr>
              <a:buSzPct val="70000"/>
              <a:buFont typeface="Wingdings 2" panose="05020102010507070707" pitchFamily="18" charset="2"/>
              <a:buChar char=""/>
              <a:defRPr kumimoji="1" sz="2100">
                <a:solidFill>
                  <a:schemeClr val="tx1"/>
                </a:solidFill>
                <a:latin typeface="Constantia" panose="02030602050306030303" pitchFamily="18" charset="0"/>
                <a:ea typeface="HGP明朝E" panose="02020900000000000000" pitchFamily="18" charset="-128"/>
              </a:defRPr>
            </a:lvl3pPr>
            <a:lvl4pPr marL="1600200" indent="-228600" eaLnBrk="0" hangingPunct="0">
              <a:spcBef>
                <a:spcPct val="20000"/>
              </a:spcBef>
              <a:buClr>
                <a:srgbClr val="0BD0D9"/>
              </a:buClr>
              <a:buSzPct val="65000"/>
              <a:buFont typeface="Wingdings 2" panose="05020102010507070707" pitchFamily="18" charset="2"/>
              <a:buChar char=""/>
              <a:defRPr kumimoji="1" sz="2000">
                <a:solidFill>
                  <a:schemeClr val="tx1"/>
                </a:solidFill>
                <a:latin typeface="Constantia" panose="02030602050306030303" pitchFamily="18" charset="0"/>
                <a:ea typeface="HGP明朝E" panose="02020900000000000000" pitchFamily="18" charset="-128"/>
              </a:defRPr>
            </a:lvl4pPr>
            <a:lvl5pPr marL="2057400" indent="-228600" eaLnBrk="0" hangingPunct="0">
              <a:spcBef>
                <a:spcPct val="20000"/>
              </a:spcBef>
              <a:buClr>
                <a:srgbClr val="10CF9B"/>
              </a:buClr>
              <a:buSzPct val="65000"/>
              <a:buFont typeface="Wingdings 2" panose="05020102010507070707" pitchFamily="18" charset="2"/>
              <a:buChar char=""/>
              <a:defRPr kumimoji="1" sz="2000">
                <a:solidFill>
                  <a:schemeClr val="tx1"/>
                </a:solidFill>
                <a:latin typeface="Constantia" panose="02030602050306030303" pitchFamily="18" charset="0"/>
                <a:ea typeface="HGP明朝E" panose="02020900000000000000" pitchFamily="18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10CF9B"/>
              </a:buClr>
              <a:buSzPct val="65000"/>
              <a:buFont typeface="Wingdings 2" panose="05020102010507070707" pitchFamily="18" charset="2"/>
              <a:buChar char=""/>
              <a:defRPr kumimoji="1" sz="2000">
                <a:solidFill>
                  <a:schemeClr val="tx1"/>
                </a:solidFill>
                <a:latin typeface="Constantia" panose="02030602050306030303" pitchFamily="18" charset="0"/>
                <a:ea typeface="HGP明朝E" panose="02020900000000000000" pitchFamily="18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10CF9B"/>
              </a:buClr>
              <a:buSzPct val="65000"/>
              <a:buFont typeface="Wingdings 2" panose="05020102010507070707" pitchFamily="18" charset="2"/>
              <a:buChar char=""/>
              <a:defRPr kumimoji="1" sz="2000">
                <a:solidFill>
                  <a:schemeClr val="tx1"/>
                </a:solidFill>
                <a:latin typeface="Constantia" panose="02030602050306030303" pitchFamily="18" charset="0"/>
                <a:ea typeface="HGP明朝E" panose="02020900000000000000" pitchFamily="18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10CF9B"/>
              </a:buClr>
              <a:buSzPct val="65000"/>
              <a:buFont typeface="Wingdings 2" panose="05020102010507070707" pitchFamily="18" charset="2"/>
              <a:buChar char=""/>
              <a:defRPr kumimoji="1" sz="2000">
                <a:solidFill>
                  <a:schemeClr val="tx1"/>
                </a:solidFill>
                <a:latin typeface="Constantia" panose="02030602050306030303" pitchFamily="18" charset="0"/>
                <a:ea typeface="HGP明朝E" panose="02020900000000000000" pitchFamily="18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10CF9B"/>
              </a:buClr>
              <a:buSzPct val="65000"/>
              <a:buFont typeface="Wingdings 2" panose="05020102010507070707" pitchFamily="18" charset="2"/>
              <a:buChar char=""/>
              <a:defRPr kumimoji="1" sz="2000">
                <a:solidFill>
                  <a:schemeClr val="tx1"/>
                </a:solidFill>
                <a:latin typeface="Constantia" panose="02030602050306030303" pitchFamily="18" charset="0"/>
                <a:ea typeface="HGP明朝E" panose="02020900000000000000" pitchFamily="18" charset="-128"/>
              </a:defRPr>
            </a:lvl9pPr>
          </a:lstStyle>
          <a:p>
            <a:pPr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US" altLang="ja-JP" sz="1100"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pmol/g</a:t>
            </a:r>
            <a:endParaRPr lang="ja-JP" altLang="en-US" sz="1100"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grpSp>
        <p:nvGrpSpPr>
          <p:cNvPr id="49160" name="グループ化 9">
            <a:extLst>
              <a:ext uri="{FF2B5EF4-FFF2-40B4-BE49-F238E27FC236}">
                <a16:creationId xmlns:a16="http://schemas.microsoft.com/office/drawing/2014/main" id="{C0B0B569-C096-4CCA-9BC6-A9DA17991AD4}"/>
              </a:ext>
            </a:extLst>
          </p:cNvPr>
          <p:cNvGrpSpPr>
            <a:grpSpLocks/>
          </p:cNvGrpSpPr>
          <p:nvPr/>
        </p:nvGrpSpPr>
        <p:grpSpPr bwMode="auto">
          <a:xfrm>
            <a:off x="9178925" y="5835650"/>
            <a:ext cx="1360488" cy="954088"/>
            <a:chOff x="7654925" y="5836286"/>
            <a:chExt cx="1360488" cy="954087"/>
          </a:xfrm>
        </p:grpSpPr>
        <p:sp>
          <p:nvSpPr>
            <p:cNvPr id="11" name="正方形/長方形 10">
              <a:extLst>
                <a:ext uri="{FF2B5EF4-FFF2-40B4-BE49-F238E27FC236}">
                  <a16:creationId xmlns:a16="http://schemas.microsoft.com/office/drawing/2014/main" id="{32AF2E3C-B668-4A86-B3C8-DBD7556EA38E}"/>
                </a:ext>
              </a:extLst>
            </p:cNvPr>
            <p:cNvSpPr/>
            <p:nvPr/>
          </p:nvSpPr>
          <p:spPr bwMode="auto">
            <a:xfrm>
              <a:off x="7654925" y="5941061"/>
              <a:ext cx="317500" cy="85725"/>
            </a:xfrm>
            <a:prstGeom prst="rect">
              <a:avLst/>
            </a:prstGeom>
            <a:solidFill>
              <a:schemeClr val="bg1"/>
            </a:solidFill>
            <a:ln w="190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ja-JP" altLang="en-US"/>
            </a:p>
          </p:txBody>
        </p:sp>
        <p:sp>
          <p:nvSpPr>
            <p:cNvPr id="12" name="正方形/長方形 11">
              <a:extLst>
                <a:ext uri="{FF2B5EF4-FFF2-40B4-BE49-F238E27FC236}">
                  <a16:creationId xmlns:a16="http://schemas.microsoft.com/office/drawing/2014/main" id="{7DC65307-890A-40BE-9B5F-E94EF639F951}"/>
                </a:ext>
              </a:extLst>
            </p:cNvPr>
            <p:cNvSpPr/>
            <p:nvPr/>
          </p:nvSpPr>
          <p:spPr bwMode="auto">
            <a:xfrm>
              <a:off x="7661275" y="6380798"/>
              <a:ext cx="317500" cy="85725"/>
            </a:xfrm>
            <a:prstGeom prst="rect">
              <a:avLst/>
            </a:prstGeom>
            <a:solidFill>
              <a:schemeClr val="tx1">
                <a:lumMod val="50000"/>
                <a:lumOff val="50000"/>
              </a:schemeClr>
            </a:solidFill>
            <a:ln w="190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ja-JP" altLang="en-US"/>
            </a:p>
          </p:txBody>
        </p:sp>
        <p:sp>
          <p:nvSpPr>
            <p:cNvPr id="13" name="正方形/長方形 12">
              <a:extLst>
                <a:ext uri="{FF2B5EF4-FFF2-40B4-BE49-F238E27FC236}">
                  <a16:creationId xmlns:a16="http://schemas.microsoft.com/office/drawing/2014/main" id="{38430E1B-5D9A-49DA-9727-DD583AD7C6C1}"/>
                </a:ext>
              </a:extLst>
            </p:cNvPr>
            <p:cNvSpPr/>
            <p:nvPr/>
          </p:nvSpPr>
          <p:spPr bwMode="auto">
            <a:xfrm>
              <a:off x="7661275" y="6171249"/>
              <a:ext cx="317500" cy="85725"/>
            </a:xfrm>
            <a:prstGeom prst="rect">
              <a:avLst/>
            </a:prstGeom>
            <a:solidFill>
              <a:schemeClr val="tx1"/>
            </a:solidFill>
            <a:ln w="190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ja-JP" altLang="en-US"/>
            </a:p>
          </p:txBody>
        </p:sp>
        <p:sp>
          <p:nvSpPr>
            <p:cNvPr id="14" name="正方形/長方形 13">
              <a:extLst>
                <a:ext uri="{FF2B5EF4-FFF2-40B4-BE49-F238E27FC236}">
                  <a16:creationId xmlns:a16="http://schemas.microsoft.com/office/drawing/2014/main" id="{5F563DDB-28E5-422F-B000-E588B2F2E5DA}"/>
                </a:ext>
              </a:extLst>
            </p:cNvPr>
            <p:cNvSpPr/>
            <p:nvPr/>
          </p:nvSpPr>
          <p:spPr bwMode="auto">
            <a:xfrm>
              <a:off x="7661275" y="6618923"/>
              <a:ext cx="317500" cy="85725"/>
            </a:xfrm>
            <a:prstGeom prst="rect">
              <a:avLst/>
            </a:prstGeom>
            <a:pattFill prst="wdDnDiag">
              <a:fgClr>
                <a:schemeClr val="tx1">
                  <a:lumMod val="85000"/>
                  <a:lumOff val="15000"/>
                </a:schemeClr>
              </a:fgClr>
              <a:bgClr>
                <a:schemeClr val="bg1"/>
              </a:bgClr>
            </a:pattFill>
            <a:ln w="190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ja-JP" altLang="en-US"/>
            </a:p>
          </p:txBody>
        </p:sp>
        <p:sp>
          <p:nvSpPr>
            <p:cNvPr id="49165" name="テキスト ボックス 12">
              <a:extLst>
                <a:ext uri="{FF2B5EF4-FFF2-40B4-BE49-F238E27FC236}">
                  <a16:creationId xmlns:a16="http://schemas.microsoft.com/office/drawing/2014/main" id="{D3DBFC28-BE5A-4FF6-9619-9E58A0B3B20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7979471" y="5836286"/>
              <a:ext cx="1035942" cy="9540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Clr>
                  <a:srgbClr val="0BD0D9"/>
                </a:buClr>
                <a:buSzPct val="95000"/>
                <a:buFont typeface="Wingdings 2" panose="05020102010507070707" pitchFamily="18" charset="2"/>
                <a:buChar char=""/>
                <a:defRPr kumimoji="1" sz="2600">
                  <a:solidFill>
                    <a:schemeClr val="tx1"/>
                  </a:solidFill>
                  <a:latin typeface="Constantia" panose="02030602050306030303" pitchFamily="18" charset="0"/>
                  <a:ea typeface="HGP明朝E" panose="02020900000000000000" pitchFamily="18" charset="-128"/>
                </a:defRPr>
              </a:lvl1pPr>
              <a:lvl2pPr marL="742950" indent="-285750" eaLnBrk="0" hangingPunct="0">
                <a:spcBef>
                  <a:spcPct val="20000"/>
                </a:spcBef>
                <a:buClr>
                  <a:schemeClr val="accent1"/>
                </a:buClr>
                <a:buSzPct val="85000"/>
                <a:buFont typeface="Wingdings 2" panose="05020102010507070707" pitchFamily="18" charset="2"/>
                <a:buChar char=""/>
                <a:defRPr kumimoji="1" sz="2400">
                  <a:solidFill>
                    <a:schemeClr val="tx1"/>
                  </a:solidFill>
                  <a:latin typeface="Constantia" panose="02030602050306030303" pitchFamily="18" charset="0"/>
                  <a:ea typeface="HGP明朝E" panose="02020900000000000000" pitchFamily="18" charset="-128"/>
                </a:defRPr>
              </a:lvl2pPr>
              <a:lvl3pPr marL="1143000" indent="-228600" eaLnBrk="0" hangingPunct="0">
                <a:spcBef>
                  <a:spcPct val="20000"/>
                </a:spcBef>
                <a:buClr>
                  <a:schemeClr val="accent2"/>
                </a:buClr>
                <a:buSzPct val="70000"/>
                <a:buFont typeface="Wingdings 2" panose="05020102010507070707" pitchFamily="18" charset="2"/>
                <a:buChar char=""/>
                <a:defRPr kumimoji="1" sz="2100">
                  <a:solidFill>
                    <a:schemeClr val="tx1"/>
                  </a:solidFill>
                  <a:latin typeface="Constantia" panose="02030602050306030303" pitchFamily="18" charset="0"/>
                  <a:ea typeface="HGP明朝E" panose="02020900000000000000" pitchFamily="18" charset="-128"/>
                </a:defRPr>
              </a:lvl3pPr>
              <a:lvl4pPr marL="1600200" indent="-228600" eaLnBrk="0" hangingPunct="0">
                <a:spcBef>
                  <a:spcPct val="20000"/>
                </a:spcBef>
                <a:buClr>
                  <a:srgbClr val="0BD0D9"/>
                </a:buClr>
                <a:buSzPct val="65000"/>
                <a:buFont typeface="Wingdings 2" panose="05020102010507070707" pitchFamily="18" charset="2"/>
                <a:buChar char=""/>
                <a:defRPr kumimoji="1" sz="2000">
                  <a:solidFill>
                    <a:schemeClr val="tx1"/>
                  </a:solidFill>
                  <a:latin typeface="Constantia" panose="02030602050306030303" pitchFamily="18" charset="0"/>
                  <a:ea typeface="HGP明朝E" panose="02020900000000000000" pitchFamily="18" charset="-128"/>
                </a:defRPr>
              </a:lvl4pPr>
              <a:lvl5pPr marL="2057400" indent="-228600" eaLnBrk="0" hangingPunct="0">
                <a:spcBef>
                  <a:spcPct val="20000"/>
                </a:spcBef>
                <a:buClr>
                  <a:srgbClr val="10CF9B"/>
                </a:buClr>
                <a:buSzPct val="65000"/>
                <a:buFont typeface="Wingdings 2" panose="05020102010507070707" pitchFamily="18" charset="2"/>
                <a:buChar char=""/>
                <a:defRPr kumimoji="1" sz="2000">
                  <a:solidFill>
                    <a:schemeClr val="tx1"/>
                  </a:solidFill>
                  <a:latin typeface="Constantia" panose="02030602050306030303" pitchFamily="18" charset="0"/>
                  <a:ea typeface="HGP明朝E" panose="02020900000000000000" pitchFamily="18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lr>
                  <a:srgbClr val="10CF9B"/>
                </a:buClr>
                <a:buSzPct val="65000"/>
                <a:buFont typeface="Wingdings 2" panose="05020102010507070707" pitchFamily="18" charset="2"/>
                <a:buChar char=""/>
                <a:defRPr kumimoji="1" sz="2000">
                  <a:solidFill>
                    <a:schemeClr val="tx1"/>
                  </a:solidFill>
                  <a:latin typeface="Constantia" panose="02030602050306030303" pitchFamily="18" charset="0"/>
                  <a:ea typeface="HGP明朝E" panose="02020900000000000000" pitchFamily="18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lr>
                  <a:srgbClr val="10CF9B"/>
                </a:buClr>
                <a:buSzPct val="65000"/>
                <a:buFont typeface="Wingdings 2" panose="05020102010507070707" pitchFamily="18" charset="2"/>
                <a:buChar char=""/>
                <a:defRPr kumimoji="1" sz="2000">
                  <a:solidFill>
                    <a:schemeClr val="tx1"/>
                  </a:solidFill>
                  <a:latin typeface="Constantia" panose="02030602050306030303" pitchFamily="18" charset="0"/>
                  <a:ea typeface="HGP明朝E" panose="02020900000000000000" pitchFamily="18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lr>
                  <a:srgbClr val="10CF9B"/>
                </a:buClr>
                <a:buSzPct val="65000"/>
                <a:buFont typeface="Wingdings 2" panose="05020102010507070707" pitchFamily="18" charset="2"/>
                <a:buChar char=""/>
                <a:defRPr kumimoji="1" sz="2000">
                  <a:solidFill>
                    <a:schemeClr val="tx1"/>
                  </a:solidFill>
                  <a:latin typeface="Constantia" panose="02030602050306030303" pitchFamily="18" charset="0"/>
                  <a:ea typeface="HGP明朝E" panose="02020900000000000000" pitchFamily="18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lr>
                  <a:srgbClr val="10CF9B"/>
                </a:buClr>
                <a:buSzPct val="65000"/>
                <a:buFont typeface="Wingdings 2" panose="05020102010507070707" pitchFamily="18" charset="2"/>
                <a:buChar char=""/>
                <a:defRPr kumimoji="1" sz="2000">
                  <a:solidFill>
                    <a:schemeClr val="tx1"/>
                  </a:solidFill>
                  <a:latin typeface="Constantia" panose="02030602050306030303" pitchFamily="18" charset="0"/>
                  <a:ea typeface="HGP明朝E" panose="02020900000000000000" pitchFamily="18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ClrTx/>
                <a:buSzTx/>
                <a:buFontTx/>
                <a:buNone/>
              </a:pPr>
              <a:r>
                <a:rPr lang="en-US" altLang="ja-JP" sz="1400">
                  <a:latin typeface="Arial" panose="020B0604020202020204" pitchFamily="34" charset="0"/>
                  <a:ea typeface="ＭＳ Ｐゴシック" panose="020B0600070205080204" pitchFamily="50" charset="-128"/>
                </a:rPr>
                <a:t>NFD HCI-</a:t>
              </a:r>
            </a:p>
            <a:p>
              <a:pPr eaLnBrk="1" hangingPunct="1">
                <a:spcBef>
                  <a:spcPct val="0"/>
                </a:spcBef>
                <a:buClrTx/>
                <a:buSzTx/>
                <a:buFontTx/>
                <a:buNone/>
              </a:pPr>
              <a:r>
                <a:rPr lang="en-US" altLang="ja-JP" sz="1400">
                  <a:latin typeface="Arial" panose="020B0604020202020204" pitchFamily="34" charset="0"/>
                  <a:ea typeface="ＭＳ Ｐゴシック" panose="020B0600070205080204" pitchFamily="50" charset="-128"/>
                </a:rPr>
                <a:t>NFD HCI+</a:t>
              </a:r>
            </a:p>
            <a:p>
              <a:pPr eaLnBrk="1" hangingPunct="1">
                <a:spcBef>
                  <a:spcPct val="0"/>
                </a:spcBef>
                <a:buClrTx/>
                <a:buSzTx/>
                <a:buFontTx/>
                <a:buNone/>
              </a:pPr>
              <a:r>
                <a:rPr lang="en-US" altLang="ja-JP" sz="1400">
                  <a:latin typeface="Arial" panose="020B0604020202020204" pitchFamily="34" charset="0"/>
                  <a:ea typeface="ＭＳ Ｐゴシック" panose="020B0600070205080204" pitchFamily="50" charset="-128"/>
                </a:rPr>
                <a:t>HFD HCI-</a:t>
              </a:r>
            </a:p>
            <a:p>
              <a:pPr eaLnBrk="1" hangingPunct="1">
                <a:spcBef>
                  <a:spcPct val="0"/>
                </a:spcBef>
                <a:buClrTx/>
                <a:buSzTx/>
                <a:buFontTx/>
                <a:buNone/>
              </a:pPr>
              <a:r>
                <a:rPr lang="en-US" altLang="ja-JP" sz="1400">
                  <a:latin typeface="Arial" panose="020B0604020202020204" pitchFamily="34" charset="0"/>
                  <a:ea typeface="ＭＳ Ｐゴシック" panose="020B0600070205080204" pitchFamily="50" charset="-128"/>
                </a:rPr>
                <a:t>HFD HCI+</a:t>
              </a:r>
              <a:endParaRPr lang="ja-JP" altLang="en-US" sz="1400">
                <a:latin typeface="Arial" panose="020B0604020202020204" pitchFamily="34" charset="0"/>
                <a:ea typeface="ＭＳ Ｐゴシック" panose="020B0600070205080204" pitchFamily="50" charset="-128"/>
              </a:endParaRPr>
            </a:p>
          </p:txBody>
        </p:sp>
      </p:grp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18E66336-DEF4-8357-22B7-D4EE37DF9F2F}"/>
              </a:ext>
            </a:extLst>
          </p:cNvPr>
          <p:cNvSpPr txBox="1"/>
          <p:nvPr/>
        </p:nvSpPr>
        <p:spPr>
          <a:xfrm>
            <a:off x="330766" y="125161"/>
            <a:ext cx="194155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400">
                <a:latin typeface="Arial" panose="020B0604020202020204" pitchFamily="34" charset="0"/>
                <a:cs typeface="Arial" panose="020B0604020202020204" pitchFamily="34" charset="0"/>
              </a:rPr>
              <a:t>Supple Fig.1</a:t>
            </a:r>
            <a:endParaRPr lang="ja-JP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3557670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203" name="テキスト ボックス 15">
            <a:extLst>
              <a:ext uri="{FF2B5EF4-FFF2-40B4-BE49-F238E27FC236}">
                <a16:creationId xmlns:a16="http://schemas.microsoft.com/office/drawing/2014/main" id="{C0A6CD22-1C14-439A-8CC8-12B91F0BA4E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735667" y="1374248"/>
            <a:ext cx="9144000" cy="523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lr>
                <a:srgbClr val="0BD0D9"/>
              </a:buClr>
              <a:buSzPct val="95000"/>
              <a:buFont typeface="Wingdings 2" panose="05020102010507070707" pitchFamily="18" charset="2"/>
              <a:buChar char=""/>
              <a:defRPr kumimoji="1" sz="2600">
                <a:solidFill>
                  <a:schemeClr val="tx1"/>
                </a:solidFill>
                <a:latin typeface="Constantia" panose="02030602050306030303" pitchFamily="18" charset="0"/>
                <a:ea typeface="HGP明朝E" panose="02020900000000000000" pitchFamily="18" charset="-128"/>
              </a:defRPr>
            </a:lvl1pPr>
            <a:lvl2pPr marL="742950" indent="-285750" eaLnBrk="0" hangingPunct="0">
              <a:spcBef>
                <a:spcPct val="20000"/>
              </a:spcBef>
              <a:buClr>
                <a:schemeClr val="accent1"/>
              </a:buClr>
              <a:buSzPct val="85000"/>
              <a:buFont typeface="Wingdings 2" panose="05020102010507070707" pitchFamily="18" charset="2"/>
              <a:buChar char=""/>
              <a:defRPr kumimoji="1" sz="2400">
                <a:solidFill>
                  <a:schemeClr val="tx1"/>
                </a:solidFill>
                <a:latin typeface="Constantia" panose="02030602050306030303" pitchFamily="18" charset="0"/>
                <a:ea typeface="HGP明朝E" panose="02020900000000000000" pitchFamily="18" charset="-128"/>
              </a:defRPr>
            </a:lvl2pPr>
            <a:lvl3pPr marL="1143000" indent="-228600" eaLnBrk="0" hangingPunct="0">
              <a:spcBef>
                <a:spcPct val="20000"/>
              </a:spcBef>
              <a:buClr>
                <a:schemeClr val="accent2"/>
              </a:buClr>
              <a:buSzPct val="70000"/>
              <a:buFont typeface="Wingdings 2" panose="05020102010507070707" pitchFamily="18" charset="2"/>
              <a:buChar char=""/>
              <a:defRPr kumimoji="1" sz="2100">
                <a:solidFill>
                  <a:schemeClr val="tx1"/>
                </a:solidFill>
                <a:latin typeface="Constantia" panose="02030602050306030303" pitchFamily="18" charset="0"/>
                <a:ea typeface="HGP明朝E" panose="02020900000000000000" pitchFamily="18" charset="-128"/>
              </a:defRPr>
            </a:lvl3pPr>
            <a:lvl4pPr marL="1600200" indent="-228600" eaLnBrk="0" hangingPunct="0">
              <a:spcBef>
                <a:spcPct val="20000"/>
              </a:spcBef>
              <a:buClr>
                <a:srgbClr val="0BD0D9"/>
              </a:buClr>
              <a:buSzPct val="65000"/>
              <a:buFont typeface="Wingdings 2" panose="05020102010507070707" pitchFamily="18" charset="2"/>
              <a:buChar char=""/>
              <a:defRPr kumimoji="1" sz="2000">
                <a:solidFill>
                  <a:schemeClr val="tx1"/>
                </a:solidFill>
                <a:latin typeface="Constantia" panose="02030602050306030303" pitchFamily="18" charset="0"/>
                <a:ea typeface="HGP明朝E" panose="02020900000000000000" pitchFamily="18" charset="-128"/>
              </a:defRPr>
            </a:lvl4pPr>
            <a:lvl5pPr marL="2057400" indent="-228600" eaLnBrk="0" hangingPunct="0">
              <a:spcBef>
                <a:spcPct val="20000"/>
              </a:spcBef>
              <a:buClr>
                <a:srgbClr val="10CF9B"/>
              </a:buClr>
              <a:buSzPct val="65000"/>
              <a:buFont typeface="Wingdings 2" panose="05020102010507070707" pitchFamily="18" charset="2"/>
              <a:buChar char=""/>
              <a:defRPr kumimoji="1" sz="2000">
                <a:solidFill>
                  <a:schemeClr val="tx1"/>
                </a:solidFill>
                <a:latin typeface="Constantia" panose="02030602050306030303" pitchFamily="18" charset="0"/>
                <a:ea typeface="HGP明朝E" panose="02020900000000000000" pitchFamily="18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10CF9B"/>
              </a:buClr>
              <a:buSzPct val="65000"/>
              <a:buFont typeface="Wingdings 2" panose="05020102010507070707" pitchFamily="18" charset="2"/>
              <a:buChar char=""/>
              <a:defRPr kumimoji="1" sz="2000">
                <a:solidFill>
                  <a:schemeClr val="tx1"/>
                </a:solidFill>
                <a:latin typeface="Constantia" panose="02030602050306030303" pitchFamily="18" charset="0"/>
                <a:ea typeface="HGP明朝E" panose="02020900000000000000" pitchFamily="18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10CF9B"/>
              </a:buClr>
              <a:buSzPct val="65000"/>
              <a:buFont typeface="Wingdings 2" panose="05020102010507070707" pitchFamily="18" charset="2"/>
              <a:buChar char=""/>
              <a:defRPr kumimoji="1" sz="2000">
                <a:solidFill>
                  <a:schemeClr val="tx1"/>
                </a:solidFill>
                <a:latin typeface="Constantia" panose="02030602050306030303" pitchFamily="18" charset="0"/>
                <a:ea typeface="HGP明朝E" panose="02020900000000000000" pitchFamily="18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10CF9B"/>
              </a:buClr>
              <a:buSzPct val="65000"/>
              <a:buFont typeface="Wingdings 2" panose="05020102010507070707" pitchFamily="18" charset="2"/>
              <a:buChar char=""/>
              <a:defRPr kumimoji="1" sz="2000">
                <a:solidFill>
                  <a:schemeClr val="tx1"/>
                </a:solidFill>
                <a:latin typeface="Constantia" panose="02030602050306030303" pitchFamily="18" charset="0"/>
                <a:ea typeface="HGP明朝E" panose="02020900000000000000" pitchFamily="18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10CF9B"/>
              </a:buClr>
              <a:buSzPct val="65000"/>
              <a:buFont typeface="Wingdings 2" panose="05020102010507070707" pitchFamily="18" charset="2"/>
              <a:buChar char=""/>
              <a:defRPr kumimoji="1" sz="2000">
                <a:solidFill>
                  <a:schemeClr val="tx1"/>
                </a:solidFill>
                <a:latin typeface="Constantia" panose="02030602050306030303" pitchFamily="18" charset="0"/>
                <a:ea typeface="HGP明朝E" panose="02020900000000000000" pitchFamily="18" charset="-128"/>
              </a:defRPr>
            </a:lvl9pPr>
          </a:lstStyle>
          <a:p>
            <a:pPr algn="ctr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US" altLang="ja-JP" sz="2800"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Intramyocellular ceramides</a:t>
            </a:r>
            <a:endParaRPr lang="ja-JP" altLang="en-US" sz="2800"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graphicFrame>
        <p:nvGraphicFramePr>
          <p:cNvPr id="6" name="グラフ 5">
            <a:extLst>
              <a:ext uri="{FF2B5EF4-FFF2-40B4-BE49-F238E27FC236}">
                <a16:creationId xmlns:a16="http://schemas.microsoft.com/office/drawing/2014/main" id="{79CCE413-06E9-4725-ABA3-A84EE9C3BDC8}"/>
              </a:ext>
            </a:extLst>
          </p:cNvPr>
          <p:cNvGraphicFramePr>
            <a:graphicFrameLocks/>
          </p:cNvGraphicFramePr>
          <p:nvPr/>
        </p:nvGraphicFramePr>
        <p:xfrm>
          <a:off x="3863753" y="2060848"/>
          <a:ext cx="4615309" cy="292482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1208" name="テキスト ボックス 2">
            <a:extLst>
              <a:ext uri="{FF2B5EF4-FFF2-40B4-BE49-F238E27FC236}">
                <a16:creationId xmlns:a16="http://schemas.microsoft.com/office/drawing/2014/main" id="{E8092C90-CFE0-4A56-A4CD-337A507AF513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3479486" y="3025900"/>
            <a:ext cx="608013" cy="2603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lr>
                <a:srgbClr val="0BD0D9"/>
              </a:buClr>
              <a:buSzPct val="95000"/>
              <a:buFont typeface="Wingdings 2" panose="05020102010507070707" pitchFamily="18" charset="2"/>
              <a:buChar char=""/>
              <a:defRPr kumimoji="1" sz="2600">
                <a:solidFill>
                  <a:schemeClr val="tx1"/>
                </a:solidFill>
                <a:latin typeface="Constantia" panose="02030602050306030303" pitchFamily="18" charset="0"/>
                <a:ea typeface="HGP明朝E" panose="02020900000000000000" pitchFamily="18" charset="-128"/>
              </a:defRPr>
            </a:lvl1pPr>
            <a:lvl2pPr marL="742950" indent="-285750" eaLnBrk="0" hangingPunct="0">
              <a:spcBef>
                <a:spcPct val="20000"/>
              </a:spcBef>
              <a:buClr>
                <a:schemeClr val="accent1"/>
              </a:buClr>
              <a:buSzPct val="85000"/>
              <a:buFont typeface="Wingdings 2" panose="05020102010507070707" pitchFamily="18" charset="2"/>
              <a:buChar char=""/>
              <a:defRPr kumimoji="1" sz="2400">
                <a:solidFill>
                  <a:schemeClr val="tx1"/>
                </a:solidFill>
                <a:latin typeface="Constantia" panose="02030602050306030303" pitchFamily="18" charset="0"/>
                <a:ea typeface="HGP明朝E" panose="02020900000000000000" pitchFamily="18" charset="-128"/>
              </a:defRPr>
            </a:lvl2pPr>
            <a:lvl3pPr marL="1143000" indent="-228600" eaLnBrk="0" hangingPunct="0">
              <a:spcBef>
                <a:spcPct val="20000"/>
              </a:spcBef>
              <a:buClr>
                <a:schemeClr val="accent2"/>
              </a:buClr>
              <a:buSzPct val="70000"/>
              <a:buFont typeface="Wingdings 2" panose="05020102010507070707" pitchFamily="18" charset="2"/>
              <a:buChar char=""/>
              <a:defRPr kumimoji="1" sz="2100">
                <a:solidFill>
                  <a:schemeClr val="tx1"/>
                </a:solidFill>
                <a:latin typeface="Constantia" panose="02030602050306030303" pitchFamily="18" charset="0"/>
                <a:ea typeface="HGP明朝E" panose="02020900000000000000" pitchFamily="18" charset="-128"/>
              </a:defRPr>
            </a:lvl3pPr>
            <a:lvl4pPr marL="1600200" indent="-228600" eaLnBrk="0" hangingPunct="0">
              <a:spcBef>
                <a:spcPct val="20000"/>
              </a:spcBef>
              <a:buClr>
                <a:srgbClr val="0BD0D9"/>
              </a:buClr>
              <a:buSzPct val="65000"/>
              <a:buFont typeface="Wingdings 2" panose="05020102010507070707" pitchFamily="18" charset="2"/>
              <a:buChar char=""/>
              <a:defRPr kumimoji="1" sz="2000">
                <a:solidFill>
                  <a:schemeClr val="tx1"/>
                </a:solidFill>
                <a:latin typeface="Constantia" panose="02030602050306030303" pitchFamily="18" charset="0"/>
                <a:ea typeface="HGP明朝E" panose="02020900000000000000" pitchFamily="18" charset="-128"/>
              </a:defRPr>
            </a:lvl4pPr>
            <a:lvl5pPr marL="2057400" indent="-228600" eaLnBrk="0" hangingPunct="0">
              <a:spcBef>
                <a:spcPct val="20000"/>
              </a:spcBef>
              <a:buClr>
                <a:srgbClr val="10CF9B"/>
              </a:buClr>
              <a:buSzPct val="65000"/>
              <a:buFont typeface="Wingdings 2" panose="05020102010507070707" pitchFamily="18" charset="2"/>
              <a:buChar char=""/>
              <a:defRPr kumimoji="1" sz="2000">
                <a:solidFill>
                  <a:schemeClr val="tx1"/>
                </a:solidFill>
                <a:latin typeface="Constantia" panose="02030602050306030303" pitchFamily="18" charset="0"/>
                <a:ea typeface="HGP明朝E" panose="02020900000000000000" pitchFamily="18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10CF9B"/>
              </a:buClr>
              <a:buSzPct val="65000"/>
              <a:buFont typeface="Wingdings 2" panose="05020102010507070707" pitchFamily="18" charset="2"/>
              <a:buChar char=""/>
              <a:defRPr kumimoji="1" sz="2000">
                <a:solidFill>
                  <a:schemeClr val="tx1"/>
                </a:solidFill>
                <a:latin typeface="Constantia" panose="02030602050306030303" pitchFamily="18" charset="0"/>
                <a:ea typeface="HGP明朝E" panose="02020900000000000000" pitchFamily="18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10CF9B"/>
              </a:buClr>
              <a:buSzPct val="65000"/>
              <a:buFont typeface="Wingdings 2" panose="05020102010507070707" pitchFamily="18" charset="2"/>
              <a:buChar char=""/>
              <a:defRPr kumimoji="1" sz="2000">
                <a:solidFill>
                  <a:schemeClr val="tx1"/>
                </a:solidFill>
                <a:latin typeface="Constantia" panose="02030602050306030303" pitchFamily="18" charset="0"/>
                <a:ea typeface="HGP明朝E" panose="02020900000000000000" pitchFamily="18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10CF9B"/>
              </a:buClr>
              <a:buSzPct val="65000"/>
              <a:buFont typeface="Wingdings 2" panose="05020102010507070707" pitchFamily="18" charset="2"/>
              <a:buChar char=""/>
              <a:defRPr kumimoji="1" sz="2000">
                <a:solidFill>
                  <a:schemeClr val="tx1"/>
                </a:solidFill>
                <a:latin typeface="Constantia" panose="02030602050306030303" pitchFamily="18" charset="0"/>
                <a:ea typeface="HGP明朝E" panose="02020900000000000000" pitchFamily="18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10CF9B"/>
              </a:buClr>
              <a:buSzPct val="65000"/>
              <a:buFont typeface="Wingdings 2" panose="05020102010507070707" pitchFamily="18" charset="2"/>
              <a:buChar char=""/>
              <a:defRPr kumimoji="1" sz="2000">
                <a:solidFill>
                  <a:schemeClr val="tx1"/>
                </a:solidFill>
                <a:latin typeface="Constantia" panose="02030602050306030303" pitchFamily="18" charset="0"/>
                <a:ea typeface="HGP明朝E" panose="02020900000000000000" pitchFamily="18" charset="-128"/>
              </a:defRPr>
            </a:lvl9pPr>
          </a:lstStyle>
          <a:p>
            <a:pPr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US" altLang="ja-JP" sz="1100"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pmol/g</a:t>
            </a:r>
            <a:endParaRPr lang="ja-JP" altLang="en-US" sz="1100"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B553DF8D-1763-368B-38E6-4D30C20CF3F9}"/>
              </a:ext>
            </a:extLst>
          </p:cNvPr>
          <p:cNvSpPr txBox="1"/>
          <p:nvPr/>
        </p:nvSpPr>
        <p:spPr>
          <a:xfrm>
            <a:off x="330766" y="125161"/>
            <a:ext cx="194155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400">
                <a:latin typeface="Arial" panose="020B0604020202020204" pitchFamily="34" charset="0"/>
                <a:cs typeface="Arial" panose="020B0604020202020204" pitchFamily="34" charset="0"/>
              </a:rPr>
              <a:t>Supple Fig.2</a:t>
            </a:r>
            <a:endParaRPr lang="ja-JP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" name="グループ化 9">
            <a:extLst>
              <a:ext uri="{FF2B5EF4-FFF2-40B4-BE49-F238E27FC236}">
                <a16:creationId xmlns:a16="http://schemas.microsoft.com/office/drawing/2014/main" id="{7FE33B76-3203-74DC-AFD7-FDE0F91D4881}"/>
              </a:ext>
            </a:extLst>
          </p:cNvPr>
          <p:cNvGrpSpPr>
            <a:grpSpLocks/>
          </p:cNvGrpSpPr>
          <p:nvPr/>
        </p:nvGrpSpPr>
        <p:grpSpPr bwMode="auto">
          <a:xfrm>
            <a:off x="9178925" y="5835650"/>
            <a:ext cx="1360488" cy="954088"/>
            <a:chOff x="7654925" y="5836286"/>
            <a:chExt cx="1360488" cy="954087"/>
          </a:xfrm>
        </p:grpSpPr>
        <p:sp>
          <p:nvSpPr>
            <p:cNvPr id="4" name="正方形/長方形 3">
              <a:extLst>
                <a:ext uri="{FF2B5EF4-FFF2-40B4-BE49-F238E27FC236}">
                  <a16:creationId xmlns:a16="http://schemas.microsoft.com/office/drawing/2014/main" id="{970BB041-761D-D3D9-CEEE-6A203341FFF3}"/>
                </a:ext>
              </a:extLst>
            </p:cNvPr>
            <p:cNvSpPr/>
            <p:nvPr/>
          </p:nvSpPr>
          <p:spPr bwMode="auto">
            <a:xfrm>
              <a:off x="7654925" y="5941061"/>
              <a:ext cx="317500" cy="85725"/>
            </a:xfrm>
            <a:prstGeom prst="rect">
              <a:avLst/>
            </a:prstGeom>
            <a:solidFill>
              <a:schemeClr val="bg1"/>
            </a:solidFill>
            <a:ln w="190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ja-JP" altLang="en-US"/>
            </a:p>
          </p:txBody>
        </p:sp>
        <p:sp>
          <p:nvSpPr>
            <p:cNvPr id="5" name="正方形/長方形 4">
              <a:extLst>
                <a:ext uri="{FF2B5EF4-FFF2-40B4-BE49-F238E27FC236}">
                  <a16:creationId xmlns:a16="http://schemas.microsoft.com/office/drawing/2014/main" id="{A5D19215-49A3-043D-86E9-4918795220D0}"/>
                </a:ext>
              </a:extLst>
            </p:cNvPr>
            <p:cNvSpPr/>
            <p:nvPr/>
          </p:nvSpPr>
          <p:spPr bwMode="auto">
            <a:xfrm>
              <a:off x="7661275" y="6380798"/>
              <a:ext cx="317500" cy="85725"/>
            </a:xfrm>
            <a:prstGeom prst="rect">
              <a:avLst/>
            </a:prstGeom>
            <a:solidFill>
              <a:schemeClr val="tx1">
                <a:lumMod val="50000"/>
                <a:lumOff val="50000"/>
              </a:schemeClr>
            </a:solidFill>
            <a:ln w="190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ja-JP" altLang="en-US"/>
            </a:p>
          </p:txBody>
        </p:sp>
        <p:sp>
          <p:nvSpPr>
            <p:cNvPr id="7" name="正方形/長方形 6">
              <a:extLst>
                <a:ext uri="{FF2B5EF4-FFF2-40B4-BE49-F238E27FC236}">
                  <a16:creationId xmlns:a16="http://schemas.microsoft.com/office/drawing/2014/main" id="{1496FAD1-1664-8482-78ED-6C8D9DC51BC4}"/>
                </a:ext>
              </a:extLst>
            </p:cNvPr>
            <p:cNvSpPr/>
            <p:nvPr/>
          </p:nvSpPr>
          <p:spPr bwMode="auto">
            <a:xfrm>
              <a:off x="7661275" y="6171249"/>
              <a:ext cx="317500" cy="85725"/>
            </a:xfrm>
            <a:prstGeom prst="rect">
              <a:avLst/>
            </a:prstGeom>
            <a:solidFill>
              <a:schemeClr val="tx1"/>
            </a:solidFill>
            <a:ln w="190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ja-JP" altLang="en-US"/>
            </a:p>
          </p:txBody>
        </p:sp>
        <p:sp>
          <p:nvSpPr>
            <p:cNvPr id="8" name="正方形/長方形 7">
              <a:extLst>
                <a:ext uri="{FF2B5EF4-FFF2-40B4-BE49-F238E27FC236}">
                  <a16:creationId xmlns:a16="http://schemas.microsoft.com/office/drawing/2014/main" id="{1FDEF215-C1C4-EFAF-55C4-C53CF38A4541}"/>
                </a:ext>
              </a:extLst>
            </p:cNvPr>
            <p:cNvSpPr/>
            <p:nvPr/>
          </p:nvSpPr>
          <p:spPr bwMode="auto">
            <a:xfrm>
              <a:off x="7661275" y="6618923"/>
              <a:ext cx="317500" cy="85725"/>
            </a:xfrm>
            <a:prstGeom prst="rect">
              <a:avLst/>
            </a:prstGeom>
            <a:pattFill prst="wdDnDiag">
              <a:fgClr>
                <a:schemeClr val="tx1">
                  <a:lumMod val="85000"/>
                  <a:lumOff val="15000"/>
                </a:schemeClr>
              </a:fgClr>
              <a:bgClr>
                <a:schemeClr val="bg1"/>
              </a:bgClr>
            </a:pattFill>
            <a:ln w="190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ja-JP" altLang="en-US"/>
            </a:p>
          </p:txBody>
        </p:sp>
        <p:sp>
          <p:nvSpPr>
            <p:cNvPr id="9" name="テキスト ボックス 12">
              <a:extLst>
                <a:ext uri="{FF2B5EF4-FFF2-40B4-BE49-F238E27FC236}">
                  <a16:creationId xmlns:a16="http://schemas.microsoft.com/office/drawing/2014/main" id="{2BC9BFB1-357E-8075-32E2-212ABB0D0B4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7979471" y="5836286"/>
              <a:ext cx="1035942" cy="9540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Clr>
                  <a:srgbClr val="0BD0D9"/>
                </a:buClr>
                <a:buSzPct val="95000"/>
                <a:buFont typeface="Wingdings 2" panose="05020102010507070707" pitchFamily="18" charset="2"/>
                <a:buChar char=""/>
                <a:defRPr kumimoji="1" sz="2600">
                  <a:solidFill>
                    <a:schemeClr val="tx1"/>
                  </a:solidFill>
                  <a:latin typeface="Constantia" panose="02030602050306030303" pitchFamily="18" charset="0"/>
                  <a:ea typeface="HGP明朝E" panose="02020900000000000000" pitchFamily="18" charset="-128"/>
                </a:defRPr>
              </a:lvl1pPr>
              <a:lvl2pPr marL="742950" indent="-285750" eaLnBrk="0" hangingPunct="0">
                <a:spcBef>
                  <a:spcPct val="20000"/>
                </a:spcBef>
                <a:buClr>
                  <a:schemeClr val="accent1"/>
                </a:buClr>
                <a:buSzPct val="85000"/>
                <a:buFont typeface="Wingdings 2" panose="05020102010507070707" pitchFamily="18" charset="2"/>
                <a:buChar char=""/>
                <a:defRPr kumimoji="1" sz="2400">
                  <a:solidFill>
                    <a:schemeClr val="tx1"/>
                  </a:solidFill>
                  <a:latin typeface="Constantia" panose="02030602050306030303" pitchFamily="18" charset="0"/>
                  <a:ea typeface="HGP明朝E" panose="02020900000000000000" pitchFamily="18" charset="-128"/>
                </a:defRPr>
              </a:lvl2pPr>
              <a:lvl3pPr marL="1143000" indent="-228600" eaLnBrk="0" hangingPunct="0">
                <a:spcBef>
                  <a:spcPct val="20000"/>
                </a:spcBef>
                <a:buClr>
                  <a:schemeClr val="accent2"/>
                </a:buClr>
                <a:buSzPct val="70000"/>
                <a:buFont typeface="Wingdings 2" panose="05020102010507070707" pitchFamily="18" charset="2"/>
                <a:buChar char=""/>
                <a:defRPr kumimoji="1" sz="2100">
                  <a:solidFill>
                    <a:schemeClr val="tx1"/>
                  </a:solidFill>
                  <a:latin typeface="Constantia" panose="02030602050306030303" pitchFamily="18" charset="0"/>
                  <a:ea typeface="HGP明朝E" panose="02020900000000000000" pitchFamily="18" charset="-128"/>
                </a:defRPr>
              </a:lvl3pPr>
              <a:lvl4pPr marL="1600200" indent="-228600" eaLnBrk="0" hangingPunct="0">
                <a:spcBef>
                  <a:spcPct val="20000"/>
                </a:spcBef>
                <a:buClr>
                  <a:srgbClr val="0BD0D9"/>
                </a:buClr>
                <a:buSzPct val="65000"/>
                <a:buFont typeface="Wingdings 2" panose="05020102010507070707" pitchFamily="18" charset="2"/>
                <a:buChar char=""/>
                <a:defRPr kumimoji="1" sz="2000">
                  <a:solidFill>
                    <a:schemeClr val="tx1"/>
                  </a:solidFill>
                  <a:latin typeface="Constantia" panose="02030602050306030303" pitchFamily="18" charset="0"/>
                  <a:ea typeface="HGP明朝E" panose="02020900000000000000" pitchFamily="18" charset="-128"/>
                </a:defRPr>
              </a:lvl4pPr>
              <a:lvl5pPr marL="2057400" indent="-228600" eaLnBrk="0" hangingPunct="0">
                <a:spcBef>
                  <a:spcPct val="20000"/>
                </a:spcBef>
                <a:buClr>
                  <a:srgbClr val="10CF9B"/>
                </a:buClr>
                <a:buSzPct val="65000"/>
                <a:buFont typeface="Wingdings 2" panose="05020102010507070707" pitchFamily="18" charset="2"/>
                <a:buChar char=""/>
                <a:defRPr kumimoji="1" sz="2000">
                  <a:solidFill>
                    <a:schemeClr val="tx1"/>
                  </a:solidFill>
                  <a:latin typeface="Constantia" panose="02030602050306030303" pitchFamily="18" charset="0"/>
                  <a:ea typeface="HGP明朝E" panose="02020900000000000000" pitchFamily="18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lr>
                  <a:srgbClr val="10CF9B"/>
                </a:buClr>
                <a:buSzPct val="65000"/>
                <a:buFont typeface="Wingdings 2" panose="05020102010507070707" pitchFamily="18" charset="2"/>
                <a:buChar char=""/>
                <a:defRPr kumimoji="1" sz="2000">
                  <a:solidFill>
                    <a:schemeClr val="tx1"/>
                  </a:solidFill>
                  <a:latin typeface="Constantia" panose="02030602050306030303" pitchFamily="18" charset="0"/>
                  <a:ea typeface="HGP明朝E" panose="02020900000000000000" pitchFamily="18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lr>
                  <a:srgbClr val="10CF9B"/>
                </a:buClr>
                <a:buSzPct val="65000"/>
                <a:buFont typeface="Wingdings 2" panose="05020102010507070707" pitchFamily="18" charset="2"/>
                <a:buChar char=""/>
                <a:defRPr kumimoji="1" sz="2000">
                  <a:solidFill>
                    <a:schemeClr val="tx1"/>
                  </a:solidFill>
                  <a:latin typeface="Constantia" panose="02030602050306030303" pitchFamily="18" charset="0"/>
                  <a:ea typeface="HGP明朝E" panose="02020900000000000000" pitchFamily="18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lr>
                  <a:srgbClr val="10CF9B"/>
                </a:buClr>
                <a:buSzPct val="65000"/>
                <a:buFont typeface="Wingdings 2" panose="05020102010507070707" pitchFamily="18" charset="2"/>
                <a:buChar char=""/>
                <a:defRPr kumimoji="1" sz="2000">
                  <a:solidFill>
                    <a:schemeClr val="tx1"/>
                  </a:solidFill>
                  <a:latin typeface="Constantia" panose="02030602050306030303" pitchFamily="18" charset="0"/>
                  <a:ea typeface="HGP明朝E" panose="02020900000000000000" pitchFamily="18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lr>
                  <a:srgbClr val="10CF9B"/>
                </a:buClr>
                <a:buSzPct val="65000"/>
                <a:buFont typeface="Wingdings 2" panose="05020102010507070707" pitchFamily="18" charset="2"/>
                <a:buChar char=""/>
                <a:defRPr kumimoji="1" sz="2000">
                  <a:solidFill>
                    <a:schemeClr val="tx1"/>
                  </a:solidFill>
                  <a:latin typeface="Constantia" panose="02030602050306030303" pitchFamily="18" charset="0"/>
                  <a:ea typeface="HGP明朝E" panose="02020900000000000000" pitchFamily="18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ClrTx/>
                <a:buSzTx/>
                <a:buFontTx/>
                <a:buNone/>
              </a:pPr>
              <a:r>
                <a:rPr lang="en-US" altLang="ja-JP" sz="1400">
                  <a:latin typeface="Arial" panose="020B0604020202020204" pitchFamily="34" charset="0"/>
                  <a:ea typeface="ＭＳ Ｐゴシック" panose="020B0600070205080204" pitchFamily="50" charset="-128"/>
                </a:rPr>
                <a:t>NFD HCI-</a:t>
              </a:r>
            </a:p>
            <a:p>
              <a:pPr eaLnBrk="1" hangingPunct="1">
                <a:spcBef>
                  <a:spcPct val="0"/>
                </a:spcBef>
                <a:buClrTx/>
                <a:buSzTx/>
                <a:buFontTx/>
                <a:buNone/>
              </a:pPr>
              <a:r>
                <a:rPr lang="en-US" altLang="ja-JP" sz="1400">
                  <a:latin typeface="Arial" panose="020B0604020202020204" pitchFamily="34" charset="0"/>
                  <a:ea typeface="ＭＳ Ｐゴシック" panose="020B0600070205080204" pitchFamily="50" charset="-128"/>
                </a:rPr>
                <a:t>NFD HCI+</a:t>
              </a:r>
            </a:p>
            <a:p>
              <a:pPr eaLnBrk="1" hangingPunct="1">
                <a:spcBef>
                  <a:spcPct val="0"/>
                </a:spcBef>
                <a:buClrTx/>
                <a:buSzTx/>
                <a:buFontTx/>
                <a:buNone/>
              </a:pPr>
              <a:r>
                <a:rPr lang="en-US" altLang="ja-JP" sz="1400">
                  <a:latin typeface="Arial" panose="020B0604020202020204" pitchFamily="34" charset="0"/>
                  <a:ea typeface="ＭＳ Ｐゴシック" panose="020B0600070205080204" pitchFamily="50" charset="-128"/>
                </a:rPr>
                <a:t>HFD HCI-</a:t>
              </a:r>
            </a:p>
            <a:p>
              <a:pPr eaLnBrk="1" hangingPunct="1">
                <a:spcBef>
                  <a:spcPct val="0"/>
                </a:spcBef>
                <a:buClrTx/>
                <a:buSzTx/>
                <a:buFontTx/>
                <a:buNone/>
              </a:pPr>
              <a:r>
                <a:rPr lang="en-US" altLang="ja-JP" sz="1400">
                  <a:latin typeface="Arial" panose="020B0604020202020204" pitchFamily="34" charset="0"/>
                  <a:ea typeface="ＭＳ Ｐゴシック" panose="020B0600070205080204" pitchFamily="50" charset="-128"/>
                </a:rPr>
                <a:t>HFD HCI+</a:t>
              </a:r>
              <a:endParaRPr lang="ja-JP" altLang="en-US" sz="1400">
                <a:latin typeface="Arial" panose="020B0604020202020204" pitchFamily="34" charset="0"/>
                <a:ea typeface="ＭＳ Ｐゴシック" panose="020B0600070205080204" pitchFamily="50" charset="-128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95518388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>
            <a:extLst>
              <a:ext uri="{FF2B5EF4-FFF2-40B4-BE49-F238E27FC236}">
                <a16:creationId xmlns:a16="http://schemas.microsoft.com/office/drawing/2014/main" id="{5F35D1F1-86D8-4B65-B6BC-D50F431FB38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638603" y="2136333"/>
            <a:ext cx="1589107" cy="742529"/>
          </a:xfrm>
          <a:prstGeom prst="rect">
            <a:avLst/>
          </a:prstGeom>
        </p:spPr>
      </p:pic>
      <p:graphicFrame>
        <p:nvGraphicFramePr>
          <p:cNvPr id="4" name="グラフ 3">
            <a:extLst>
              <a:ext uri="{FF2B5EF4-FFF2-40B4-BE49-F238E27FC236}">
                <a16:creationId xmlns:a16="http://schemas.microsoft.com/office/drawing/2014/main" id="{82FE053F-2518-C83E-EB1E-172D3A07BD74}"/>
              </a:ext>
            </a:extLst>
          </p:cNvPr>
          <p:cNvGraphicFramePr>
            <a:graphicFrameLocks/>
          </p:cNvGraphicFramePr>
          <p:nvPr/>
        </p:nvGraphicFramePr>
        <p:xfrm>
          <a:off x="4315652" y="2465630"/>
          <a:ext cx="2126035" cy="23831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6" name="テキスト ボックス 12">
            <a:extLst>
              <a:ext uri="{FF2B5EF4-FFF2-40B4-BE49-F238E27FC236}">
                <a16:creationId xmlns:a16="http://schemas.microsoft.com/office/drawing/2014/main" id="{BCFCA087-19DF-13D3-20EC-673286416A49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3021104" y="3609052"/>
            <a:ext cx="2031325" cy="52322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algn="ctr" eaLnBrk="1" hangingPunct="1"/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PTP1B association/IRβ</a:t>
            </a:r>
          </a:p>
          <a:p>
            <a:pPr algn="ctr" eaLnBrk="1" hangingPunct="1"/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Fold over control cast-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19">
            <a:extLst>
              <a:ext uri="{FF2B5EF4-FFF2-40B4-BE49-F238E27FC236}">
                <a16:creationId xmlns:a16="http://schemas.microsoft.com/office/drawing/2014/main" id="{9D57110D-D22D-E429-414A-FD76A407CE7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090155" y="2234798"/>
            <a:ext cx="1540806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IP:IRβ</a:t>
            </a:r>
            <a:r>
              <a:rPr lang="ja-JP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　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WB:PTP1B</a:t>
            </a:r>
          </a:p>
          <a:p>
            <a:pPr eaLnBrk="1" hangingPunct="1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IP:IRβ</a:t>
            </a:r>
            <a:r>
              <a:rPr lang="ja-JP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　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WB:</a:t>
            </a:r>
            <a:r>
              <a:rPr lang="ja-JP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　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IRβ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8" name="グラフ 7">
            <a:extLst>
              <a:ext uri="{FF2B5EF4-FFF2-40B4-BE49-F238E27FC236}">
                <a16:creationId xmlns:a16="http://schemas.microsoft.com/office/drawing/2014/main" id="{944F1F79-C0E6-E575-DBAF-208BA62B8A67}"/>
              </a:ext>
            </a:extLst>
          </p:cNvPr>
          <p:cNvGraphicFramePr>
            <a:graphicFrameLocks/>
          </p:cNvGraphicFramePr>
          <p:nvPr/>
        </p:nvGraphicFramePr>
        <p:xfrm>
          <a:off x="6815668" y="2319868"/>
          <a:ext cx="2175933" cy="252994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D93DC252-5952-2500-2BAA-AD49F16C3376}"/>
              </a:ext>
            </a:extLst>
          </p:cNvPr>
          <p:cNvSpPr txBox="1"/>
          <p:nvPr/>
        </p:nvSpPr>
        <p:spPr>
          <a:xfrm rot="16200000">
            <a:off x="6301908" y="3591602"/>
            <a:ext cx="85151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en-US" altLang="ja-JP" sz="1400">
                <a:latin typeface="Arial" panose="020B0604020202020204" pitchFamily="34" charset="0"/>
                <a:cs typeface="Arial" panose="020B0604020202020204" pitchFamily="34" charset="0"/>
              </a:rPr>
              <a:t>elative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C189BBA7-0A97-0D4E-36D4-A32F7800C9E8}"/>
              </a:ext>
            </a:extLst>
          </p:cNvPr>
          <p:cNvSpPr txBox="1"/>
          <p:nvPr/>
        </p:nvSpPr>
        <p:spPr>
          <a:xfrm>
            <a:off x="330766" y="125161"/>
            <a:ext cx="194155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400">
                <a:latin typeface="Arial" panose="020B0604020202020204" pitchFamily="34" charset="0"/>
                <a:cs typeface="Arial" panose="020B0604020202020204" pitchFamily="34" charset="0"/>
              </a:rPr>
              <a:t>Supple Fig.3</a:t>
            </a:r>
            <a:endParaRPr lang="ja-JP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353AE99B-5ADB-403B-51EB-DAFF7779124B}"/>
              </a:ext>
            </a:extLst>
          </p:cNvPr>
          <p:cNvSpPr txBox="1"/>
          <p:nvPr/>
        </p:nvSpPr>
        <p:spPr>
          <a:xfrm flipH="1">
            <a:off x="3246120" y="1744134"/>
            <a:ext cx="1828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1D40EB7D-F58A-2F73-EBBC-4936CB1A21FD}"/>
              </a:ext>
            </a:extLst>
          </p:cNvPr>
          <p:cNvSpPr txBox="1"/>
          <p:nvPr/>
        </p:nvSpPr>
        <p:spPr>
          <a:xfrm flipH="1">
            <a:off x="6531187" y="1803401"/>
            <a:ext cx="1828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45959BB9-2E70-23D6-D928-2144B684CB93}"/>
              </a:ext>
            </a:extLst>
          </p:cNvPr>
          <p:cNvSpPr txBox="1"/>
          <p:nvPr/>
        </p:nvSpPr>
        <p:spPr>
          <a:xfrm>
            <a:off x="7272867" y="2311401"/>
            <a:ext cx="17443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>
                <a:latin typeface="Arial" panose="020B0604020202020204" pitchFamily="34" charset="0"/>
                <a:cs typeface="Arial" panose="020B0604020202020204" pitchFamily="34" charset="0"/>
              </a:rPr>
              <a:t>PTP1B activity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54">
            <a:extLst>
              <a:ext uri="{FF2B5EF4-FFF2-40B4-BE49-F238E27FC236}">
                <a16:creationId xmlns:a16="http://schemas.microsoft.com/office/drawing/2014/main" id="{C8C98237-7F7D-89C0-E99D-BCDAEC392EC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297979" y="4750173"/>
            <a:ext cx="2232248" cy="430887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Clr>
                <a:srgbClr val="0BD0D9"/>
              </a:buClr>
              <a:buSzPct val="95000"/>
              <a:buFont typeface="Wingdings 2" panose="05020102010507070707" pitchFamily="18" charset="2"/>
              <a:buChar char=""/>
              <a:defRPr kumimoji="1" sz="2600">
                <a:solidFill>
                  <a:schemeClr val="tx1"/>
                </a:solidFill>
                <a:latin typeface="Constantia" panose="02030602050306030303" pitchFamily="18" charset="0"/>
                <a:ea typeface="HGP明朝E" panose="02020900000000000000" pitchFamily="18" charset="-128"/>
              </a:defRPr>
            </a:lvl1pPr>
            <a:lvl2pPr marL="742950" indent="-285750" eaLnBrk="0" hangingPunct="0">
              <a:spcBef>
                <a:spcPct val="20000"/>
              </a:spcBef>
              <a:buClr>
                <a:schemeClr val="accent1"/>
              </a:buClr>
              <a:buSzPct val="85000"/>
              <a:buFont typeface="Wingdings 2" panose="05020102010507070707" pitchFamily="18" charset="2"/>
              <a:buChar char=""/>
              <a:defRPr kumimoji="1" sz="2400">
                <a:solidFill>
                  <a:schemeClr val="tx1"/>
                </a:solidFill>
                <a:latin typeface="Constantia" panose="02030602050306030303" pitchFamily="18" charset="0"/>
                <a:ea typeface="HGP明朝E" panose="02020900000000000000" pitchFamily="18" charset="-128"/>
              </a:defRPr>
            </a:lvl2pPr>
            <a:lvl3pPr marL="1143000" indent="-228600" eaLnBrk="0" hangingPunct="0">
              <a:spcBef>
                <a:spcPct val="20000"/>
              </a:spcBef>
              <a:buClr>
                <a:schemeClr val="accent2"/>
              </a:buClr>
              <a:buSzPct val="70000"/>
              <a:buFont typeface="Wingdings 2" panose="05020102010507070707" pitchFamily="18" charset="2"/>
              <a:buChar char=""/>
              <a:defRPr kumimoji="1" sz="2100">
                <a:solidFill>
                  <a:schemeClr val="tx1"/>
                </a:solidFill>
                <a:latin typeface="Constantia" panose="02030602050306030303" pitchFamily="18" charset="0"/>
                <a:ea typeface="HGP明朝E" panose="02020900000000000000" pitchFamily="18" charset="-128"/>
              </a:defRPr>
            </a:lvl3pPr>
            <a:lvl4pPr marL="1600200" indent="-228600" eaLnBrk="0" hangingPunct="0">
              <a:spcBef>
                <a:spcPct val="20000"/>
              </a:spcBef>
              <a:buClr>
                <a:srgbClr val="0BD0D9"/>
              </a:buClr>
              <a:buSzPct val="65000"/>
              <a:buFont typeface="Wingdings 2" panose="05020102010507070707" pitchFamily="18" charset="2"/>
              <a:buChar char=""/>
              <a:defRPr kumimoji="1" sz="2000">
                <a:solidFill>
                  <a:schemeClr val="tx1"/>
                </a:solidFill>
                <a:latin typeface="Constantia" panose="02030602050306030303" pitchFamily="18" charset="0"/>
                <a:ea typeface="HGP明朝E" panose="02020900000000000000" pitchFamily="18" charset="-128"/>
              </a:defRPr>
            </a:lvl4pPr>
            <a:lvl5pPr marL="2057400" indent="-228600" eaLnBrk="0" hangingPunct="0">
              <a:spcBef>
                <a:spcPct val="20000"/>
              </a:spcBef>
              <a:buClr>
                <a:srgbClr val="10CF9B"/>
              </a:buClr>
              <a:buSzPct val="65000"/>
              <a:buFont typeface="Wingdings 2" panose="05020102010507070707" pitchFamily="18" charset="2"/>
              <a:buChar char=""/>
              <a:defRPr kumimoji="1" sz="2000">
                <a:solidFill>
                  <a:schemeClr val="tx1"/>
                </a:solidFill>
                <a:latin typeface="Constantia" panose="02030602050306030303" pitchFamily="18" charset="0"/>
                <a:ea typeface="HGP明朝E" panose="02020900000000000000" pitchFamily="18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10CF9B"/>
              </a:buClr>
              <a:buSzPct val="65000"/>
              <a:buFont typeface="Wingdings 2" panose="05020102010507070707" pitchFamily="18" charset="2"/>
              <a:buChar char=""/>
              <a:defRPr kumimoji="1" sz="2000">
                <a:solidFill>
                  <a:schemeClr val="tx1"/>
                </a:solidFill>
                <a:latin typeface="Constantia" panose="02030602050306030303" pitchFamily="18" charset="0"/>
                <a:ea typeface="HGP明朝E" panose="02020900000000000000" pitchFamily="18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10CF9B"/>
              </a:buClr>
              <a:buSzPct val="65000"/>
              <a:buFont typeface="Wingdings 2" panose="05020102010507070707" pitchFamily="18" charset="2"/>
              <a:buChar char=""/>
              <a:defRPr kumimoji="1" sz="2000">
                <a:solidFill>
                  <a:schemeClr val="tx1"/>
                </a:solidFill>
                <a:latin typeface="Constantia" panose="02030602050306030303" pitchFamily="18" charset="0"/>
                <a:ea typeface="HGP明朝E" panose="02020900000000000000" pitchFamily="18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10CF9B"/>
              </a:buClr>
              <a:buSzPct val="65000"/>
              <a:buFont typeface="Wingdings 2" panose="05020102010507070707" pitchFamily="18" charset="2"/>
              <a:buChar char=""/>
              <a:defRPr kumimoji="1" sz="2000">
                <a:solidFill>
                  <a:schemeClr val="tx1"/>
                </a:solidFill>
                <a:latin typeface="Constantia" panose="02030602050306030303" pitchFamily="18" charset="0"/>
                <a:ea typeface="HGP明朝E" panose="02020900000000000000" pitchFamily="18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10CF9B"/>
              </a:buClr>
              <a:buSzPct val="65000"/>
              <a:buFont typeface="Wingdings 2" panose="05020102010507070707" pitchFamily="18" charset="2"/>
              <a:buChar char=""/>
              <a:defRPr kumimoji="1" sz="2000">
                <a:solidFill>
                  <a:schemeClr val="tx1"/>
                </a:solidFill>
                <a:latin typeface="Constantia" panose="02030602050306030303" pitchFamily="18" charset="0"/>
                <a:ea typeface="HGP明朝E" panose="02020900000000000000" pitchFamily="18" charset="-128"/>
              </a:defRPr>
            </a:lvl9pPr>
          </a:lstStyle>
          <a:p>
            <a:pPr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US" altLang="ja-JP" sz="1100"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HCI  </a:t>
            </a:r>
            <a:r>
              <a:rPr lang="ja-JP" altLang="en-US" sz="1100"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　</a:t>
            </a:r>
            <a:r>
              <a:rPr lang="en-US" altLang="ja-JP" sz="1100"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 -</a:t>
            </a:r>
            <a:r>
              <a:rPr lang="ja-JP" altLang="en-US" sz="1100"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　　　</a:t>
            </a:r>
            <a:r>
              <a:rPr lang="en-US" altLang="ja-JP" sz="1100"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 </a:t>
            </a:r>
            <a:r>
              <a:rPr lang="ja-JP" altLang="en-US" sz="1100"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＋　　   </a:t>
            </a:r>
            <a:r>
              <a:rPr lang="en-US" altLang="ja-JP" sz="1100"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-</a:t>
            </a:r>
            <a:r>
              <a:rPr lang="ja-JP" altLang="en-US" sz="1100"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　　 </a:t>
            </a:r>
            <a:r>
              <a:rPr lang="en-US" altLang="ja-JP" sz="1100"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   </a:t>
            </a:r>
            <a:r>
              <a:rPr lang="ja-JP" altLang="en-US" sz="1100"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＋</a:t>
            </a:r>
            <a:endParaRPr lang="en-US" altLang="ja-JP" sz="1100"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  <a:p>
            <a:pPr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US" altLang="ja-JP" sz="1100"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              NFD            HFD</a:t>
            </a:r>
            <a:endParaRPr lang="ja-JP" altLang="en-US" sz="1100"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22" name="TextBox 54">
            <a:extLst>
              <a:ext uri="{FF2B5EF4-FFF2-40B4-BE49-F238E27FC236}">
                <a16:creationId xmlns:a16="http://schemas.microsoft.com/office/drawing/2014/main" id="{F3BE8442-0E82-F616-9F91-B7C8E989725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880312" y="4750173"/>
            <a:ext cx="2232248" cy="430887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Clr>
                <a:srgbClr val="0BD0D9"/>
              </a:buClr>
              <a:buSzPct val="95000"/>
              <a:buFont typeface="Wingdings 2" panose="05020102010507070707" pitchFamily="18" charset="2"/>
              <a:buChar char=""/>
              <a:defRPr kumimoji="1" sz="2600">
                <a:solidFill>
                  <a:schemeClr val="tx1"/>
                </a:solidFill>
                <a:latin typeface="Constantia" panose="02030602050306030303" pitchFamily="18" charset="0"/>
                <a:ea typeface="HGP明朝E" panose="02020900000000000000" pitchFamily="18" charset="-128"/>
              </a:defRPr>
            </a:lvl1pPr>
            <a:lvl2pPr marL="742950" indent="-285750" eaLnBrk="0" hangingPunct="0">
              <a:spcBef>
                <a:spcPct val="20000"/>
              </a:spcBef>
              <a:buClr>
                <a:schemeClr val="accent1"/>
              </a:buClr>
              <a:buSzPct val="85000"/>
              <a:buFont typeface="Wingdings 2" panose="05020102010507070707" pitchFamily="18" charset="2"/>
              <a:buChar char=""/>
              <a:defRPr kumimoji="1" sz="2400">
                <a:solidFill>
                  <a:schemeClr val="tx1"/>
                </a:solidFill>
                <a:latin typeface="Constantia" panose="02030602050306030303" pitchFamily="18" charset="0"/>
                <a:ea typeface="HGP明朝E" panose="02020900000000000000" pitchFamily="18" charset="-128"/>
              </a:defRPr>
            </a:lvl2pPr>
            <a:lvl3pPr marL="1143000" indent="-228600" eaLnBrk="0" hangingPunct="0">
              <a:spcBef>
                <a:spcPct val="20000"/>
              </a:spcBef>
              <a:buClr>
                <a:schemeClr val="accent2"/>
              </a:buClr>
              <a:buSzPct val="70000"/>
              <a:buFont typeface="Wingdings 2" panose="05020102010507070707" pitchFamily="18" charset="2"/>
              <a:buChar char=""/>
              <a:defRPr kumimoji="1" sz="2100">
                <a:solidFill>
                  <a:schemeClr val="tx1"/>
                </a:solidFill>
                <a:latin typeface="Constantia" panose="02030602050306030303" pitchFamily="18" charset="0"/>
                <a:ea typeface="HGP明朝E" panose="02020900000000000000" pitchFamily="18" charset="-128"/>
              </a:defRPr>
            </a:lvl3pPr>
            <a:lvl4pPr marL="1600200" indent="-228600" eaLnBrk="0" hangingPunct="0">
              <a:spcBef>
                <a:spcPct val="20000"/>
              </a:spcBef>
              <a:buClr>
                <a:srgbClr val="0BD0D9"/>
              </a:buClr>
              <a:buSzPct val="65000"/>
              <a:buFont typeface="Wingdings 2" panose="05020102010507070707" pitchFamily="18" charset="2"/>
              <a:buChar char=""/>
              <a:defRPr kumimoji="1" sz="2000">
                <a:solidFill>
                  <a:schemeClr val="tx1"/>
                </a:solidFill>
                <a:latin typeface="Constantia" panose="02030602050306030303" pitchFamily="18" charset="0"/>
                <a:ea typeface="HGP明朝E" panose="02020900000000000000" pitchFamily="18" charset="-128"/>
              </a:defRPr>
            </a:lvl4pPr>
            <a:lvl5pPr marL="2057400" indent="-228600" eaLnBrk="0" hangingPunct="0">
              <a:spcBef>
                <a:spcPct val="20000"/>
              </a:spcBef>
              <a:buClr>
                <a:srgbClr val="10CF9B"/>
              </a:buClr>
              <a:buSzPct val="65000"/>
              <a:buFont typeface="Wingdings 2" panose="05020102010507070707" pitchFamily="18" charset="2"/>
              <a:buChar char=""/>
              <a:defRPr kumimoji="1" sz="2000">
                <a:solidFill>
                  <a:schemeClr val="tx1"/>
                </a:solidFill>
                <a:latin typeface="Constantia" panose="02030602050306030303" pitchFamily="18" charset="0"/>
                <a:ea typeface="HGP明朝E" panose="02020900000000000000" pitchFamily="18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10CF9B"/>
              </a:buClr>
              <a:buSzPct val="65000"/>
              <a:buFont typeface="Wingdings 2" panose="05020102010507070707" pitchFamily="18" charset="2"/>
              <a:buChar char=""/>
              <a:defRPr kumimoji="1" sz="2000">
                <a:solidFill>
                  <a:schemeClr val="tx1"/>
                </a:solidFill>
                <a:latin typeface="Constantia" panose="02030602050306030303" pitchFamily="18" charset="0"/>
                <a:ea typeface="HGP明朝E" panose="02020900000000000000" pitchFamily="18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10CF9B"/>
              </a:buClr>
              <a:buSzPct val="65000"/>
              <a:buFont typeface="Wingdings 2" panose="05020102010507070707" pitchFamily="18" charset="2"/>
              <a:buChar char=""/>
              <a:defRPr kumimoji="1" sz="2000">
                <a:solidFill>
                  <a:schemeClr val="tx1"/>
                </a:solidFill>
                <a:latin typeface="Constantia" panose="02030602050306030303" pitchFamily="18" charset="0"/>
                <a:ea typeface="HGP明朝E" panose="02020900000000000000" pitchFamily="18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10CF9B"/>
              </a:buClr>
              <a:buSzPct val="65000"/>
              <a:buFont typeface="Wingdings 2" panose="05020102010507070707" pitchFamily="18" charset="2"/>
              <a:buChar char=""/>
              <a:defRPr kumimoji="1" sz="2000">
                <a:solidFill>
                  <a:schemeClr val="tx1"/>
                </a:solidFill>
                <a:latin typeface="Constantia" panose="02030602050306030303" pitchFamily="18" charset="0"/>
                <a:ea typeface="HGP明朝E" panose="02020900000000000000" pitchFamily="18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10CF9B"/>
              </a:buClr>
              <a:buSzPct val="65000"/>
              <a:buFont typeface="Wingdings 2" panose="05020102010507070707" pitchFamily="18" charset="2"/>
              <a:buChar char=""/>
              <a:defRPr kumimoji="1" sz="2000">
                <a:solidFill>
                  <a:schemeClr val="tx1"/>
                </a:solidFill>
                <a:latin typeface="Constantia" panose="02030602050306030303" pitchFamily="18" charset="0"/>
                <a:ea typeface="HGP明朝E" panose="02020900000000000000" pitchFamily="18" charset="-128"/>
              </a:defRPr>
            </a:lvl9pPr>
          </a:lstStyle>
          <a:p>
            <a:pPr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US" altLang="ja-JP" sz="1100"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HCI  </a:t>
            </a:r>
            <a:r>
              <a:rPr lang="ja-JP" altLang="en-US" sz="1100"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　</a:t>
            </a:r>
            <a:r>
              <a:rPr lang="en-US" altLang="ja-JP" sz="1100"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 -</a:t>
            </a:r>
            <a:r>
              <a:rPr lang="ja-JP" altLang="en-US" sz="1100"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　　　</a:t>
            </a:r>
            <a:r>
              <a:rPr lang="en-US" altLang="ja-JP" sz="1100"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 </a:t>
            </a:r>
            <a:r>
              <a:rPr lang="ja-JP" altLang="en-US" sz="1100"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＋　　   </a:t>
            </a:r>
            <a:r>
              <a:rPr lang="en-US" altLang="ja-JP" sz="1100"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-</a:t>
            </a:r>
            <a:r>
              <a:rPr lang="ja-JP" altLang="en-US" sz="1100"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　　 </a:t>
            </a:r>
            <a:r>
              <a:rPr lang="en-US" altLang="ja-JP" sz="1100"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  </a:t>
            </a:r>
            <a:r>
              <a:rPr lang="ja-JP" altLang="en-US" sz="1100"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＋</a:t>
            </a:r>
            <a:endParaRPr lang="en-US" altLang="ja-JP" sz="1100"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  <a:p>
            <a:pPr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US" altLang="ja-JP" sz="1100"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              NFD            HFD</a:t>
            </a:r>
            <a:endParaRPr lang="ja-JP" altLang="en-US" sz="1100"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77029015"/>
      </p:ext>
    </p:extLst>
  </p:cSld>
  <p:clrMapOvr>
    <a:masterClrMapping/>
  </p:clrMapOvr>
</p:sld>
</file>

<file path=ppt/theme/_rels/themeOverride1.xml.rels><?xml version="1.0" encoding="UTF-8" standalone="yes"?>
<Relationships xmlns="http://schemas.openxmlformats.org/package/2006/relationships"><Relationship Id="rId1" Type="http://schemas.openxmlformats.org/officeDocument/2006/relationships/image" Target="../media/image1.jpeg"/></Relationships>
</file>

<file path=ppt/theme/_rels/themeOverride2.xml.rels><?xml version="1.0" encoding="UTF-8" standalone="yes"?>
<Relationships xmlns="http://schemas.openxmlformats.org/package/2006/relationships"><Relationship Id="rId1" Type="http://schemas.openxmlformats.org/officeDocument/2006/relationships/image" Target="../media/image1.jpeg"/></Relationships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リゾート">
    <a:dk1>
      <a:sysClr val="windowText" lastClr="000000"/>
    </a:dk1>
    <a:lt1>
      <a:sysClr val="window" lastClr="FFFFFF"/>
    </a:lt1>
    <a:dk2>
      <a:srgbClr val="04617B"/>
    </a:dk2>
    <a:lt2>
      <a:srgbClr val="DBF5F9"/>
    </a:lt2>
    <a:accent1>
      <a:srgbClr val="0F6FC6"/>
    </a:accent1>
    <a:accent2>
      <a:srgbClr val="009DD9"/>
    </a:accent2>
    <a:accent3>
      <a:srgbClr val="0BD0D9"/>
    </a:accent3>
    <a:accent4>
      <a:srgbClr val="10CF9B"/>
    </a:accent4>
    <a:accent5>
      <a:srgbClr val="7CCA62"/>
    </a:accent5>
    <a:accent6>
      <a:srgbClr val="A5C249"/>
    </a:accent6>
    <a:hlink>
      <a:srgbClr val="E2D700"/>
    </a:hlink>
    <a:folHlink>
      <a:srgbClr val="85DFD0"/>
    </a:folHlink>
  </a:clrScheme>
  <a:fontScheme name="リゾート">
    <a:majorFont>
      <a:latin typeface="Calibri"/>
      <a:ea typeface=""/>
      <a:cs typeface=""/>
      <a:font script="Jpan" typeface="ＭＳ Ｐゴシック"/>
      <a:font script="Hang" typeface="HY중고딕"/>
      <a:font script="Hans" typeface="隶书"/>
      <a:font script="Hant" typeface="微軟正黑體"/>
      <a:font script="Arab" typeface="Traditional Arabic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ajorFont>
    <a:minorFont>
      <a:latin typeface="Constantia"/>
      <a:ea typeface=""/>
      <a:cs typeface=""/>
      <a:font script="Jpan" typeface="HGP明朝E"/>
      <a:font script="Hang" typeface="HY신명조"/>
      <a:font script="Hans" typeface="宋体"/>
      <a:font script="Hant" typeface="新細明體"/>
      <a:font script="Arab" typeface="Majalla UI"/>
      <a:font script="Hebr" typeface="David"/>
      <a:font script="Thai" typeface="Browalli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inorFont>
  </a:fontScheme>
  <a:fmtScheme name="リゾート">
    <a:fillStyleLst>
      <a:solidFill>
        <a:schemeClr val="phClr"/>
      </a:solidFill>
      <a:gradFill rotWithShape="1">
        <a:gsLst>
          <a:gs pos="0">
            <a:schemeClr val="phClr">
              <a:tint val="70000"/>
              <a:satMod val="130000"/>
            </a:schemeClr>
          </a:gs>
          <a:gs pos="43000">
            <a:schemeClr val="phClr">
              <a:tint val="44000"/>
              <a:satMod val="165000"/>
            </a:schemeClr>
          </a:gs>
          <a:gs pos="93000">
            <a:schemeClr val="phClr">
              <a:tint val="15000"/>
              <a:satMod val="165000"/>
            </a:schemeClr>
          </a:gs>
          <a:gs pos="100000">
            <a:schemeClr val="phClr">
              <a:tint val="5000"/>
              <a:satMod val="250000"/>
            </a:schemeClr>
          </a:gs>
        </a:gsLst>
        <a:path path="circle">
          <a:fillToRect l="50000" t="130000" r="50000" b="-30000"/>
        </a:path>
      </a:gradFill>
      <a:gradFill rotWithShape="1">
        <a:gsLst>
          <a:gs pos="0">
            <a:schemeClr val="phClr">
              <a:tint val="98000"/>
              <a:shade val="25000"/>
              <a:satMod val="250000"/>
            </a:schemeClr>
          </a:gs>
          <a:gs pos="68000">
            <a:schemeClr val="phClr">
              <a:tint val="86000"/>
              <a:satMod val="115000"/>
            </a:schemeClr>
          </a:gs>
          <a:gs pos="100000">
            <a:schemeClr val="phClr">
              <a:tint val="50000"/>
              <a:satMod val="150000"/>
            </a:schemeClr>
          </a:gs>
        </a:gsLst>
        <a:path path="circle">
          <a:fillToRect l="50000" t="130000" r="50000" b="-30000"/>
        </a:path>
      </a:gradFill>
    </a:fillStyleLst>
    <a:lnStyleLst>
      <a:ln w="9525" cap="flat" cmpd="sng" algn="ctr">
        <a:solidFill>
          <a:schemeClr val="phClr">
            <a:shade val="50000"/>
            <a:satMod val="103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57150" dist="38100" dir="5400000" algn="ctr" rotWithShape="0">
            <a:schemeClr val="phClr">
              <a:shade val="9000"/>
              <a:satMod val="105000"/>
              <a:alpha val="48000"/>
            </a:schemeClr>
          </a:outerShdw>
        </a:effectLst>
      </a:effectStyle>
      <a:effectStyle>
        <a:effectLst>
          <a:outerShdw blurRad="57150" dist="38100" dir="5400000" algn="ctr" rotWithShape="0">
            <a:schemeClr val="phClr">
              <a:shade val="9000"/>
              <a:satMod val="105000"/>
              <a:alpha val="48000"/>
            </a:schemeClr>
          </a:outerShdw>
        </a:effectLst>
      </a:effectStyle>
      <a:effectStyle>
        <a:effectLst>
          <a:outerShdw blurRad="57150" dist="38100" dir="5400000" algn="ctr" rotWithShape="0">
            <a:schemeClr val="phClr">
              <a:shade val="9000"/>
              <a:satMod val="105000"/>
              <a:alpha val="48000"/>
            </a:schemeClr>
          </a:outerShdw>
        </a:effectLst>
        <a:scene3d>
          <a:camera prst="orthographicFront" fov="0">
            <a:rot lat="0" lon="0" rev="0"/>
          </a:camera>
          <a:lightRig rig="glow" dir="tl">
            <a:rot lat="0" lon="0" rev="900000"/>
          </a:lightRig>
        </a:scene3d>
        <a:sp3d prstMaterial="powder">
          <a:bevelT w="25400" h="381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80000"/>
              <a:satMod val="400000"/>
            </a:schemeClr>
          </a:gs>
          <a:gs pos="25000">
            <a:schemeClr val="phClr">
              <a:tint val="83000"/>
              <a:satMod val="320000"/>
            </a:schemeClr>
          </a:gs>
          <a:gs pos="100000">
            <a:schemeClr val="phClr">
              <a:shade val="15000"/>
              <a:satMod val="320000"/>
            </a:schemeClr>
          </a:gs>
        </a:gsLst>
        <a:path path="circle">
          <a:fillToRect l="10000" t="110000" r="10000" b="100000"/>
        </a:path>
      </a:gradFill>
      <a:blipFill>
        <a:blip xmlns:r="http://schemas.openxmlformats.org/officeDocument/2006/relationships" r:embed="rId1">
          <a:duotone>
            <a:schemeClr val="phClr">
              <a:shade val="90000"/>
              <a:satMod val="150000"/>
            </a:schemeClr>
            <a:schemeClr val="phClr">
              <a:tint val="88000"/>
              <a:satMod val="150000"/>
            </a:schemeClr>
          </a:duotone>
        </a:blip>
        <a:tile tx="0" ty="0" sx="65000" sy="65000" flip="none" algn="tl"/>
      </a:blipFill>
    </a:bgFillStyleLst>
  </a:fmtScheme>
</a:themeOverride>
</file>

<file path=ppt/theme/themeOverride2.xml><?xml version="1.0" encoding="utf-8"?>
<a:themeOverride xmlns:a="http://schemas.openxmlformats.org/drawingml/2006/main">
  <a:clrScheme name="リゾート">
    <a:dk1>
      <a:sysClr val="windowText" lastClr="000000"/>
    </a:dk1>
    <a:lt1>
      <a:sysClr val="window" lastClr="FFFFFF"/>
    </a:lt1>
    <a:dk2>
      <a:srgbClr val="04617B"/>
    </a:dk2>
    <a:lt2>
      <a:srgbClr val="DBF5F9"/>
    </a:lt2>
    <a:accent1>
      <a:srgbClr val="0F6FC6"/>
    </a:accent1>
    <a:accent2>
      <a:srgbClr val="009DD9"/>
    </a:accent2>
    <a:accent3>
      <a:srgbClr val="0BD0D9"/>
    </a:accent3>
    <a:accent4>
      <a:srgbClr val="10CF9B"/>
    </a:accent4>
    <a:accent5>
      <a:srgbClr val="7CCA62"/>
    </a:accent5>
    <a:accent6>
      <a:srgbClr val="A5C249"/>
    </a:accent6>
    <a:hlink>
      <a:srgbClr val="E2D700"/>
    </a:hlink>
    <a:folHlink>
      <a:srgbClr val="85DFD0"/>
    </a:folHlink>
  </a:clrScheme>
  <a:fontScheme name="リゾート">
    <a:majorFont>
      <a:latin typeface="Calibri"/>
      <a:ea typeface=""/>
      <a:cs typeface=""/>
      <a:font script="Jpan" typeface="ＭＳ Ｐゴシック"/>
      <a:font script="Hang" typeface="HY중고딕"/>
      <a:font script="Hans" typeface="隶书"/>
      <a:font script="Hant" typeface="微軟正黑體"/>
      <a:font script="Arab" typeface="Traditional Arabic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ajorFont>
    <a:minorFont>
      <a:latin typeface="Constantia"/>
      <a:ea typeface=""/>
      <a:cs typeface=""/>
      <a:font script="Jpan" typeface="HGP明朝E"/>
      <a:font script="Hang" typeface="HY신명조"/>
      <a:font script="Hans" typeface="宋体"/>
      <a:font script="Hant" typeface="新細明體"/>
      <a:font script="Arab" typeface="Majalla UI"/>
      <a:font script="Hebr" typeface="David"/>
      <a:font script="Thai" typeface="Browalli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inorFont>
  </a:fontScheme>
  <a:fmtScheme name="リゾート">
    <a:fillStyleLst>
      <a:solidFill>
        <a:schemeClr val="phClr"/>
      </a:solidFill>
      <a:gradFill rotWithShape="1">
        <a:gsLst>
          <a:gs pos="0">
            <a:schemeClr val="phClr">
              <a:tint val="70000"/>
              <a:satMod val="130000"/>
            </a:schemeClr>
          </a:gs>
          <a:gs pos="43000">
            <a:schemeClr val="phClr">
              <a:tint val="44000"/>
              <a:satMod val="165000"/>
            </a:schemeClr>
          </a:gs>
          <a:gs pos="93000">
            <a:schemeClr val="phClr">
              <a:tint val="15000"/>
              <a:satMod val="165000"/>
            </a:schemeClr>
          </a:gs>
          <a:gs pos="100000">
            <a:schemeClr val="phClr">
              <a:tint val="5000"/>
              <a:satMod val="250000"/>
            </a:schemeClr>
          </a:gs>
        </a:gsLst>
        <a:path path="circle">
          <a:fillToRect l="50000" t="130000" r="50000" b="-30000"/>
        </a:path>
      </a:gradFill>
      <a:gradFill rotWithShape="1">
        <a:gsLst>
          <a:gs pos="0">
            <a:schemeClr val="phClr">
              <a:tint val="98000"/>
              <a:shade val="25000"/>
              <a:satMod val="250000"/>
            </a:schemeClr>
          </a:gs>
          <a:gs pos="68000">
            <a:schemeClr val="phClr">
              <a:tint val="86000"/>
              <a:satMod val="115000"/>
            </a:schemeClr>
          </a:gs>
          <a:gs pos="100000">
            <a:schemeClr val="phClr">
              <a:tint val="50000"/>
              <a:satMod val="150000"/>
            </a:schemeClr>
          </a:gs>
        </a:gsLst>
        <a:path path="circle">
          <a:fillToRect l="50000" t="130000" r="50000" b="-30000"/>
        </a:path>
      </a:gradFill>
    </a:fillStyleLst>
    <a:lnStyleLst>
      <a:ln w="9525" cap="flat" cmpd="sng" algn="ctr">
        <a:solidFill>
          <a:schemeClr val="phClr">
            <a:shade val="50000"/>
            <a:satMod val="103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57150" dist="38100" dir="5400000" algn="ctr" rotWithShape="0">
            <a:schemeClr val="phClr">
              <a:shade val="9000"/>
              <a:satMod val="105000"/>
              <a:alpha val="48000"/>
            </a:schemeClr>
          </a:outerShdw>
        </a:effectLst>
      </a:effectStyle>
      <a:effectStyle>
        <a:effectLst>
          <a:outerShdw blurRad="57150" dist="38100" dir="5400000" algn="ctr" rotWithShape="0">
            <a:schemeClr val="phClr">
              <a:shade val="9000"/>
              <a:satMod val="105000"/>
              <a:alpha val="48000"/>
            </a:schemeClr>
          </a:outerShdw>
        </a:effectLst>
      </a:effectStyle>
      <a:effectStyle>
        <a:effectLst>
          <a:outerShdw blurRad="57150" dist="38100" dir="5400000" algn="ctr" rotWithShape="0">
            <a:schemeClr val="phClr">
              <a:shade val="9000"/>
              <a:satMod val="105000"/>
              <a:alpha val="48000"/>
            </a:schemeClr>
          </a:outerShdw>
        </a:effectLst>
        <a:scene3d>
          <a:camera prst="orthographicFront" fov="0">
            <a:rot lat="0" lon="0" rev="0"/>
          </a:camera>
          <a:lightRig rig="glow" dir="tl">
            <a:rot lat="0" lon="0" rev="900000"/>
          </a:lightRig>
        </a:scene3d>
        <a:sp3d prstMaterial="powder">
          <a:bevelT w="25400" h="381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80000"/>
              <a:satMod val="400000"/>
            </a:schemeClr>
          </a:gs>
          <a:gs pos="25000">
            <a:schemeClr val="phClr">
              <a:tint val="83000"/>
              <a:satMod val="320000"/>
            </a:schemeClr>
          </a:gs>
          <a:gs pos="100000">
            <a:schemeClr val="phClr">
              <a:shade val="15000"/>
              <a:satMod val="320000"/>
            </a:schemeClr>
          </a:gs>
        </a:gsLst>
        <a:path path="circle">
          <a:fillToRect l="10000" t="110000" r="10000" b="100000"/>
        </a:path>
      </a:gradFill>
      <a:blipFill>
        <a:blip xmlns:r="http://schemas.openxmlformats.org/officeDocument/2006/relationships" r:embed="rId1">
          <a:duotone>
            <a:schemeClr val="phClr">
              <a:shade val="90000"/>
              <a:satMod val="150000"/>
            </a:schemeClr>
            <a:schemeClr val="phClr">
              <a:tint val="88000"/>
              <a:satMod val="150000"/>
            </a:schemeClr>
          </a:duotone>
        </a:blip>
        <a:tile tx="0" ty="0" sx="65000" sy="65000" flip="none" algn="tl"/>
      </a:blip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85</Words>
  <Application>Microsoft Office PowerPoint</Application>
  <PresentationFormat>ワイド画面</PresentationFormat>
  <Paragraphs>29</Paragraphs>
  <Slides>3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3</vt:i4>
      </vt:variant>
    </vt:vector>
  </HeadingPairs>
  <TitlesOfParts>
    <vt:vector size="7" baseType="lpstr">
      <vt:lpstr>游ゴシック</vt:lpstr>
      <vt:lpstr>游ゴシック Light</vt:lpstr>
      <vt:lpstr>Arial</vt:lpstr>
      <vt:lpstr>Office テーマ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筧 佐織</dc:creator>
  <cp:lastModifiedBy>筧 佐織</cp:lastModifiedBy>
  <cp:revision>1</cp:revision>
  <dcterms:created xsi:type="dcterms:W3CDTF">2023-03-31T09:03:29Z</dcterms:created>
  <dcterms:modified xsi:type="dcterms:W3CDTF">2023-03-31T09:04:01Z</dcterms:modified>
</cp:coreProperties>
</file>